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3"/>
  </p:notesMasterIdLst>
  <p:sldIdLst>
    <p:sldId id="256" r:id="rId2"/>
    <p:sldId id="266" r:id="rId3"/>
    <p:sldId id="257" r:id="rId4"/>
    <p:sldId id="258" r:id="rId5"/>
    <p:sldId id="259" r:id="rId6"/>
    <p:sldId id="261" r:id="rId7"/>
    <p:sldId id="262" r:id="rId8"/>
    <p:sldId id="260" r:id="rId9"/>
    <p:sldId id="263" r:id="rId10"/>
    <p:sldId id="264" r:id="rId11"/>
    <p:sldId id="265" r:id="rId1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391" autoAdjust="0"/>
  </p:normalViewPr>
  <p:slideViewPr>
    <p:cSldViewPr snapToGrid="0" showGuides="1">
      <p:cViewPr>
        <p:scale>
          <a:sx n="91" d="100"/>
          <a:sy n="91" d="100"/>
        </p:scale>
        <p:origin x="2814" y="-3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B98E09-895C-410F-91F1-78C96BAF3451}" type="datetimeFigureOut">
              <a:rPr lang="ko-KR" altLang="en-US" smtClean="0"/>
              <a:t>2023-03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C78591-E474-463E-A36B-579B9B76720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6456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DC78591-E474-463E-A36B-579B9B76720B}" type="slidenum">
              <a:rPr lang="ko-KR" altLang="en-US" smtClean="0"/>
              <a:t>9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95244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01783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73543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48982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55167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5308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173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58514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48431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255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3930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61390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561B2-3A8A-4AD9-AC91-1D4622A2B398}" type="datetimeFigureOut">
              <a:rPr lang="ko-KR" altLang="en-US" smtClean="0"/>
              <a:t>2023-03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C9CEFB-4EE4-4C28-A324-7C19132E365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3002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2.tiff"/><Relationship Id="rId13" Type="http://schemas.openxmlformats.org/officeDocument/2006/relationships/image" Target="../media/image147.tiff"/><Relationship Id="rId3" Type="http://schemas.openxmlformats.org/officeDocument/2006/relationships/image" Target="../media/image137.tiff"/><Relationship Id="rId7" Type="http://schemas.openxmlformats.org/officeDocument/2006/relationships/image" Target="../media/image141.tiff"/><Relationship Id="rId12" Type="http://schemas.openxmlformats.org/officeDocument/2006/relationships/image" Target="../media/image146.tiff"/><Relationship Id="rId2" Type="http://schemas.openxmlformats.org/officeDocument/2006/relationships/image" Target="../media/image136.tiff"/><Relationship Id="rId16" Type="http://schemas.openxmlformats.org/officeDocument/2006/relationships/image" Target="../media/image15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0.tiff"/><Relationship Id="rId11" Type="http://schemas.openxmlformats.org/officeDocument/2006/relationships/image" Target="../media/image145.tiff"/><Relationship Id="rId5" Type="http://schemas.openxmlformats.org/officeDocument/2006/relationships/image" Target="../media/image139.tiff"/><Relationship Id="rId15" Type="http://schemas.openxmlformats.org/officeDocument/2006/relationships/image" Target="../media/image149.tiff"/><Relationship Id="rId10" Type="http://schemas.openxmlformats.org/officeDocument/2006/relationships/image" Target="../media/image144.tiff"/><Relationship Id="rId4" Type="http://schemas.openxmlformats.org/officeDocument/2006/relationships/image" Target="../media/image138.tiff"/><Relationship Id="rId9" Type="http://schemas.openxmlformats.org/officeDocument/2006/relationships/image" Target="../media/image143.tiff"/><Relationship Id="rId14" Type="http://schemas.openxmlformats.org/officeDocument/2006/relationships/image" Target="../media/image148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7.tiff"/><Relationship Id="rId13" Type="http://schemas.openxmlformats.org/officeDocument/2006/relationships/image" Target="../media/image162.tiff"/><Relationship Id="rId3" Type="http://schemas.openxmlformats.org/officeDocument/2006/relationships/image" Target="../media/image152.tiff"/><Relationship Id="rId7" Type="http://schemas.openxmlformats.org/officeDocument/2006/relationships/image" Target="../media/image156.tiff"/><Relationship Id="rId12" Type="http://schemas.openxmlformats.org/officeDocument/2006/relationships/image" Target="../media/image161.tiff"/><Relationship Id="rId2" Type="http://schemas.openxmlformats.org/officeDocument/2006/relationships/image" Target="../media/image151.tiff"/><Relationship Id="rId16" Type="http://schemas.openxmlformats.org/officeDocument/2006/relationships/image" Target="../media/image16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55.tiff"/><Relationship Id="rId11" Type="http://schemas.openxmlformats.org/officeDocument/2006/relationships/image" Target="../media/image160.tiff"/><Relationship Id="rId5" Type="http://schemas.openxmlformats.org/officeDocument/2006/relationships/image" Target="../media/image154.tiff"/><Relationship Id="rId15" Type="http://schemas.openxmlformats.org/officeDocument/2006/relationships/image" Target="../media/image164.tiff"/><Relationship Id="rId10" Type="http://schemas.openxmlformats.org/officeDocument/2006/relationships/image" Target="../media/image159.tiff"/><Relationship Id="rId4" Type="http://schemas.openxmlformats.org/officeDocument/2006/relationships/image" Target="../media/image153.tiff"/><Relationship Id="rId9" Type="http://schemas.openxmlformats.org/officeDocument/2006/relationships/image" Target="../media/image158.tiff"/><Relationship Id="rId14" Type="http://schemas.openxmlformats.org/officeDocument/2006/relationships/image" Target="../media/image16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f"/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10" Type="http://schemas.openxmlformats.org/officeDocument/2006/relationships/image" Target="../media/image15.tiff"/><Relationship Id="rId4" Type="http://schemas.openxmlformats.org/officeDocument/2006/relationships/image" Target="../media/image9.tiff"/><Relationship Id="rId9" Type="http://schemas.openxmlformats.org/officeDocument/2006/relationships/image" Target="../media/image14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tiff"/><Relationship Id="rId13" Type="http://schemas.openxmlformats.org/officeDocument/2006/relationships/image" Target="../media/image27.tiff"/><Relationship Id="rId18" Type="http://schemas.openxmlformats.org/officeDocument/2006/relationships/image" Target="../media/image32.tiff"/><Relationship Id="rId3" Type="http://schemas.openxmlformats.org/officeDocument/2006/relationships/image" Target="../media/image17.tiff"/><Relationship Id="rId21" Type="http://schemas.openxmlformats.org/officeDocument/2006/relationships/image" Target="../media/image35.tiff"/><Relationship Id="rId7" Type="http://schemas.openxmlformats.org/officeDocument/2006/relationships/image" Target="../media/image21.tiff"/><Relationship Id="rId12" Type="http://schemas.openxmlformats.org/officeDocument/2006/relationships/image" Target="../media/image26.tiff"/><Relationship Id="rId17" Type="http://schemas.openxmlformats.org/officeDocument/2006/relationships/image" Target="../media/image31.tiff"/><Relationship Id="rId2" Type="http://schemas.openxmlformats.org/officeDocument/2006/relationships/image" Target="../media/image16.tiff"/><Relationship Id="rId16" Type="http://schemas.openxmlformats.org/officeDocument/2006/relationships/image" Target="../media/image30.tiff"/><Relationship Id="rId20" Type="http://schemas.openxmlformats.org/officeDocument/2006/relationships/image" Target="../media/image3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tiff"/><Relationship Id="rId11" Type="http://schemas.openxmlformats.org/officeDocument/2006/relationships/image" Target="../media/image25.tiff"/><Relationship Id="rId5" Type="http://schemas.openxmlformats.org/officeDocument/2006/relationships/image" Target="../media/image19.tiff"/><Relationship Id="rId15" Type="http://schemas.openxmlformats.org/officeDocument/2006/relationships/image" Target="../media/image29.tiff"/><Relationship Id="rId10" Type="http://schemas.openxmlformats.org/officeDocument/2006/relationships/image" Target="../media/image24.tiff"/><Relationship Id="rId19" Type="http://schemas.openxmlformats.org/officeDocument/2006/relationships/image" Target="../media/image33.tiff"/><Relationship Id="rId4" Type="http://schemas.openxmlformats.org/officeDocument/2006/relationships/image" Target="../media/image18.tiff"/><Relationship Id="rId9" Type="http://schemas.openxmlformats.org/officeDocument/2006/relationships/image" Target="../media/image23.tiff"/><Relationship Id="rId14" Type="http://schemas.openxmlformats.org/officeDocument/2006/relationships/image" Target="../media/image28.tiff"/><Relationship Id="rId22" Type="http://schemas.openxmlformats.org/officeDocument/2006/relationships/image" Target="../media/image36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tiff"/><Relationship Id="rId13" Type="http://schemas.openxmlformats.org/officeDocument/2006/relationships/image" Target="../media/image48.tiff"/><Relationship Id="rId18" Type="http://schemas.openxmlformats.org/officeDocument/2006/relationships/image" Target="../media/image53.tiff"/><Relationship Id="rId3" Type="http://schemas.openxmlformats.org/officeDocument/2006/relationships/image" Target="../media/image38.tiff"/><Relationship Id="rId21" Type="http://schemas.openxmlformats.org/officeDocument/2006/relationships/image" Target="../media/image56.tiff"/><Relationship Id="rId7" Type="http://schemas.openxmlformats.org/officeDocument/2006/relationships/image" Target="../media/image42.tiff"/><Relationship Id="rId12" Type="http://schemas.openxmlformats.org/officeDocument/2006/relationships/image" Target="../media/image47.tiff"/><Relationship Id="rId17" Type="http://schemas.openxmlformats.org/officeDocument/2006/relationships/image" Target="../media/image52.tiff"/><Relationship Id="rId2" Type="http://schemas.openxmlformats.org/officeDocument/2006/relationships/image" Target="../media/image37.tiff"/><Relationship Id="rId16" Type="http://schemas.openxmlformats.org/officeDocument/2006/relationships/image" Target="../media/image51.tiff"/><Relationship Id="rId20" Type="http://schemas.openxmlformats.org/officeDocument/2006/relationships/image" Target="../media/image5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tiff"/><Relationship Id="rId11" Type="http://schemas.openxmlformats.org/officeDocument/2006/relationships/image" Target="../media/image46.tiff"/><Relationship Id="rId5" Type="http://schemas.openxmlformats.org/officeDocument/2006/relationships/image" Target="../media/image40.tiff"/><Relationship Id="rId15" Type="http://schemas.openxmlformats.org/officeDocument/2006/relationships/image" Target="../media/image50.tiff"/><Relationship Id="rId10" Type="http://schemas.openxmlformats.org/officeDocument/2006/relationships/image" Target="../media/image45.tiff"/><Relationship Id="rId19" Type="http://schemas.openxmlformats.org/officeDocument/2006/relationships/image" Target="../media/image54.tiff"/><Relationship Id="rId4" Type="http://schemas.openxmlformats.org/officeDocument/2006/relationships/image" Target="../media/image39.tiff"/><Relationship Id="rId9" Type="http://schemas.openxmlformats.org/officeDocument/2006/relationships/image" Target="../media/image44.tiff"/><Relationship Id="rId14" Type="http://schemas.openxmlformats.org/officeDocument/2006/relationships/image" Target="../media/image49.tiff"/><Relationship Id="rId22" Type="http://schemas.openxmlformats.org/officeDocument/2006/relationships/image" Target="../media/image57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tiff"/><Relationship Id="rId13" Type="http://schemas.openxmlformats.org/officeDocument/2006/relationships/image" Target="../media/image66.tiff"/><Relationship Id="rId18" Type="http://schemas.openxmlformats.org/officeDocument/2006/relationships/image" Target="../media/image71.tiff"/><Relationship Id="rId3" Type="http://schemas.openxmlformats.org/officeDocument/2006/relationships/image" Target="../media/image59.tiff"/><Relationship Id="rId21" Type="http://schemas.openxmlformats.org/officeDocument/2006/relationships/image" Target="../media/image74.tiff"/><Relationship Id="rId7" Type="http://schemas.openxmlformats.org/officeDocument/2006/relationships/image" Target="../media/image63.tiff"/><Relationship Id="rId12" Type="http://schemas.openxmlformats.org/officeDocument/2006/relationships/image" Target="../media/image65.tiff"/><Relationship Id="rId17" Type="http://schemas.openxmlformats.org/officeDocument/2006/relationships/image" Target="../media/image70.tiff"/><Relationship Id="rId2" Type="http://schemas.openxmlformats.org/officeDocument/2006/relationships/image" Target="../media/image58.tiff"/><Relationship Id="rId16" Type="http://schemas.openxmlformats.org/officeDocument/2006/relationships/image" Target="../media/image69.tiff"/><Relationship Id="rId20" Type="http://schemas.openxmlformats.org/officeDocument/2006/relationships/image" Target="../media/image7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2.tiff"/><Relationship Id="rId11" Type="http://schemas.openxmlformats.org/officeDocument/2006/relationships/image" Target="../media/image64.tiff"/><Relationship Id="rId5" Type="http://schemas.openxmlformats.org/officeDocument/2006/relationships/image" Target="../media/image61.tiff"/><Relationship Id="rId15" Type="http://schemas.openxmlformats.org/officeDocument/2006/relationships/image" Target="../media/image68.tiff"/><Relationship Id="rId10" Type="http://schemas.openxmlformats.org/officeDocument/2006/relationships/image" Target="../media/image43.tiff"/><Relationship Id="rId19" Type="http://schemas.openxmlformats.org/officeDocument/2006/relationships/image" Target="../media/image72.tiff"/><Relationship Id="rId4" Type="http://schemas.openxmlformats.org/officeDocument/2006/relationships/image" Target="../media/image60.tiff"/><Relationship Id="rId9" Type="http://schemas.openxmlformats.org/officeDocument/2006/relationships/image" Target="../media/image44.tiff"/><Relationship Id="rId14" Type="http://schemas.openxmlformats.org/officeDocument/2006/relationships/image" Target="../media/image67.tiff"/><Relationship Id="rId22" Type="http://schemas.openxmlformats.org/officeDocument/2006/relationships/image" Target="../media/image75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82.tiff"/><Relationship Id="rId13" Type="http://schemas.openxmlformats.org/officeDocument/2006/relationships/image" Target="../media/image87.tiff"/><Relationship Id="rId3" Type="http://schemas.openxmlformats.org/officeDocument/2006/relationships/image" Target="../media/image77.tiff"/><Relationship Id="rId7" Type="http://schemas.openxmlformats.org/officeDocument/2006/relationships/image" Target="../media/image81.tiff"/><Relationship Id="rId12" Type="http://schemas.openxmlformats.org/officeDocument/2006/relationships/image" Target="../media/image86.tiff"/><Relationship Id="rId2" Type="http://schemas.openxmlformats.org/officeDocument/2006/relationships/image" Target="../media/image76.tiff"/><Relationship Id="rId16" Type="http://schemas.openxmlformats.org/officeDocument/2006/relationships/image" Target="../media/image9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0.tiff"/><Relationship Id="rId11" Type="http://schemas.openxmlformats.org/officeDocument/2006/relationships/image" Target="../media/image85.tiff"/><Relationship Id="rId5" Type="http://schemas.openxmlformats.org/officeDocument/2006/relationships/image" Target="../media/image79.tiff"/><Relationship Id="rId15" Type="http://schemas.openxmlformats.org/officeDocument/2006/relationships/image" Target="../media/image89.tiff"/><Relationship Id="rId10" Type="http://schemas.openxmlformats.org/officeDocument/2006/relationships/image" Target="../media/image84.tiff"/><Relationship Id="rId4" Type="http://schemas.openxmlformats.org/officeDocument/2006/relationships/image" Target="../media/image78.tiff"/><Relationship Id="rId9" Type="http://schemas.openxmlformats.org/officeDocument/2006/relationships/image" Target="../media/image83.tiff"/><Relationship Id="rId14" Type="http://schemas.openxmlformats.org/officeDocument/2006/relationships/image" Target="../media/image88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97.tiff"/><Relationship Id="rId13" Type="http://schemas.openxmlformats.org/officeDocument/2006/relationships/image" Target="../media/image102.tiff"/><Relationship Id="rId3" Type="http://schemas.openxmlformats.org/officeDocument/2006/relationships/image" Target="../media/image92.tiff"/><Relationship Id="rId7" Type="http://schemas.openxmlformats.org/officeDocument/2006/relationships/image" Target="../media/image96.tiff"/><Relationship Id="rId12" Type="http://schemas.openxmlformats.org/officeDocument/2006/relationships/image" Target="../media/image101.tiff"/><Relationship Id="rId2" Type="http://schemas.openxmlformats.org/officeDocument/2006/relationships/image" Target="../media/image91.tiff"/><Relationship Id="rId16" Type="http://schemas.openxmlformats.org/officeDocument/2006/relationships/image" Target="../media/image10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5.tiff"/><Relationship Id="rId11" Type="http://schemas.openxmlformats.org/officeDocument/2006/relationships/image" Target="../media/image100.tiff"/><Relationship Id="rId5" Type="http://schemas.openxmlformats.org/officeDocument/2006/relationships/image" Target="../media/image94.tiff"/><Relationship Id="rId15" Type="http://schemas.openxmlformats.org/officeDocument/2006/relationships/image" Target="../media/image104.tiff"/><Relationship Id="rId10" Type="http://schemas.openxmlformats.org/officeDocument/2006/relationships/image" Target="../media/image99.tiff"/><Relationship Id="rId4" Type="http://schemas.openxmlformats.org/officeDocument/2006/relationships/image" Target="../media/image93.tiff"/><Relationship Id="rId9" Type="http://schemas.openxmlformats.org/officeDocument/2006/relationships/image" Target="../media/image98.tiff"/><Relationship Id="rId14" Type="http://schemas.openxmlformats.org/officeDocument/2006/relationships/image" Target="../media/image103.tif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2.tiff"/><Relationship Id="rId13" Type="http://schemas.openxmlformats.org/officeDocument/2006/relationships/image" Target="../media/image117.tiff"/><Relationship Id="rId3" Type="http://schemas.openxmlformats.org/officeDocument/2006/relationships/image" Target="../media/image107.tiff"/><Relationship Id="rId7" Type="http://schemas.openxmlformats.org/officeDocument/2006/relationships/image" Target="../media/image111.tiff"/><Relationship Id="rId12" Type="http://schemas.openxmlformats.org/officeDocument/2006/relationships/image" Target="../media/image116.tiff"/><Relationship Id="rId2" Type="http://schemas.openxmlformats.org/officeDocument/2006/relationships/image" Target="../media/image106.tiff"/><Relationship Id="rId16" Type="http://schemas.openxmlformats.org/officeDocument/2006/relationships/image" Target="../media/image12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0.tiff"/><Relationship Id="rId11" Type="http://schemas.openxmlformats.org/officeDocument/2006/relationships/image" Target="../media/image115.tiff"/><Relationship Id="rId5" Type="http://schemas.openxmlformats.org/officeDocument/2006/relationships/image" Target="../media/image109.tiff"/><Relationship Id="rId15" Type="http://schemas.openxmlformats.org/officeDocument/2006/relationships/image" Target="../media/image119.tiff"/><Relationship Id="rId10" Type="http://schemas.openxmlformats.org/officeDocument/2006/relationships/image" Target="../media/image114.tiff"/><Relationship Id="rId4" Type="http://schemas.openxmlformats.org/officeDocument/2006/relationships/image" Target="../media/image108.tiff"/><Relationship Id="rId9" Type="http://schemas.openxmlformats.org/officeDocument/2006/relationships/image" Target="../media/image113.tiff"/><Relationship Id="rId14" Type="http://schemas.openxmlformats.org/officeDocument/2006/relationships/image" Target="../media/image118.tif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6.tiff"/><Relationship Id="rId13" Type="http://schemas.openxmlformats.org/officeDocument/2006/relationships/image" Target="../media/image131.tiff"/><Relationship Id="rId3" Type="http://schemas.openxmlformats.org/officeDocument/2006/relationships/image" Target="../media/image121.tiff"/><Relationship Id="rId7" Type="http://schemas.openxmlformats.org/officeDocument/2006/relationships/image" Target="../media/image125.tiff"/><Relationship Id="rId12" Type="http://schemas.openxmlformats.org/officeDocument/2006/relationships/image" Target="../media/image130.tiff"/><Relationship Id="rId17" Type="http://schemas.openxmlformats.org/officeDocument/2006/relationships/image" Target="../media/image13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4.tiff"/><Relationship Id="rId11" Type="http://schemas.openxmlformats.org/officeDocument/2006/relationships/image" Target="../media/image129.tiff"/><Relationship Id="rId5" Type="http://schemas.openxmlformats.org/officeDocument/2006/relationships/image" Target="../media/image123.tiff"/><Relationship Id="rId15" Type="http://schemas.openxmlformats.org/officeDocument/2006/relationships/image" Target="../media/image133.tiff"/><Relationship Id="rId10" Type="http://schemas.openxmlformats.org/officeDocument/2006/relationships/image" Target="../media/image128.tiff"/><Relationship Id="rId4" Type="http://schemas.openxmlformats.org/officeDocument/2006/relationships/image" Target="../media/image122.tiff"/><Relationship Id="rId9" Type="http://schemas.openxmlformats.org/officeDocument/2006/relationships/image" Target="../media/image127.tiff"/><Relationship Id="rId14" Type="http://schemas.openxmlformats.org/officeDocument/2006/relationships/image" Target="../media/image13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" name="그룹 79"/>
          <p:cNvGrpSpPr>
            <a:grpSpLocks noChangeAspect="1"/>
          </p:cNvGrpSpPr>
          <p:nvPr/>
        </p:nvGrpSpPr>
        <p:grpSpPr>
          <a:xfrm>
            <a:off x="780613" y="551365"/>
            <a:ext cx="5337477" cy="2897195"/>
            <a:chOff x="34279" y="779204"/>
            <a:chExt cx="6796098" cy="3688943"/>
          </a:xfrm>
        </p:grpSpPr>
        <p:sp>
          <p:nvSpPr>
            <p:cNvPr id="6" name="TextBox 5"/>
            <p:cNvSpPr txBox="1"/>
            <p:nvPr/>
          </p:nvSpPr>
          <p:spPr>
            <a:xfrm rot="16200000">
              <a:off x="-411242" y="1754252"/>
              <a:ext cx="1676400" cy="26163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900" b="1" dirty="0"/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-414578" y="3481023"/>
              <a:ext cx="1676400" cy="2616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900" b="1" dirty="0"/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-1536489" y="2617636"/>
              <a:ext cx="3403173" cy="2616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CC tissues</a:t>
              </a:r>
              <a:endParaRPr lang="ko-KR" altLang="en-US" sz="900" b="1" dirty="0"/>
            </a:p>
          </p:txBody>
        </p:sp>
        <p:cxnSp>
          <p:nvCxnSpPr>
            <p:cNvPr id="9" name="직선 연결선 8"/>
            <p:cNvCxnSpPr/>
            <p:nvPr/>
          </p:nvCxnSpPr>
          <p:spPr>
            <a:xfrm flipH="1">
              <a:off x="276691" y="1064974"/>
              <a:ext cx="6098" cy="340317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0207" y="2774261"/>
              <a:ext cx="2048256" cy="16764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" name="그림 10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9080" y="2770751"/>
              <a:ext cx="2048256" cy="1676400"/>
            </a:xfrm>
            <a:prstGeom prst="rect">
              <a:avLst/>
            </a:prstGeom>
          </p:spPr>
        </p:pic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456" y="2773640"/>
              <a:ext cx="2048256" cy="1676400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552449" y="779204"/>
              <a:ext cx="2070170" cy="26163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ko-KR" altLang="en-US" sz="9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655562" y="779853"/>
              <a:ext cx="2070170" cy="26163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 exposure</a:t>
              </a:r>
              <a:endParaRPr lang="ko-KR" altLang="en-US" sz="9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760207" y="781586"/>
              <a:ext cx="2070170" cy="26163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 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xposure</a:t>
              </a:r>
              <a:endParaRPr lang="ko-KR" altLang="en-US" sz="900" b="1" dirty="0"/>
            </a:p>
          </p:txBody>
        </p:sp>
        <p:sp>
          <p:nvSpPr>
            <p:cNvPr id="16" name="직사각형 15"/>
            <p:cNvSpPr/>
            <p:nvPr/>
          </p:nvSpPr>
          <p:spPr>
            <a:xfrm>
              <a:off x="1021085" y="3477689"/>
              <a:ext cx="930002" cy="13766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946215" y="334139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1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159694" y="334139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373174" y="3340117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92107" y="334139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051705" y="3340887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264725" y="3339613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478162" y="334148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696172" y="3340757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직사각형 24"/>
            <p:cNvSpPr/>
            <p:nvPr/>
          </p:nvSpPr>
          <p:spPr>
            <a:xfrm>
              <a:off x="3150709" y="3474800"/>
              <a:ext cx="930002" cy="13766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075840" y="333850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1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289319" y="333850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502798" y="3337228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721731" y="333850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3181329" y="3337998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394349" y="3336724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3607786" y="333859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3825797" y="3337867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5241836" y="3478310"/>
              <a:ext cx="930002" cy="13766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5166966" y="334201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1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5380445" y="334201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5593924" y="3340738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5812857" y="334201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272455" y="3341508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485475" y="3340234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698912" y="334210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5916923" y="3341378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그림 42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67589" y="1032625"/>
              <a:ext cx="2048256" cy="1676400"/>
            </a:xfrm>
            <a:prstGeom prst="rect">
              <a:avLst/>
            </a:prstGeom>
          </p:spPr>
        </p:pic>
        <p:sp>
          <p:nvSpPr>
            <p:cNvPr id="44" name="TextBox 43"/>
            <p:cNvSpPr txBox="1"/>
            <p:nvPr/>
          </p:nvSpPr>
          <p:spPr>
            <a:xfrm>
              <a:off x="506520" y="3445658"/>
              <a:ext cx="515281" cy="1959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572673" y="3445658"/>
              <a:ext cx="581630" cy="1959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27498" y="3447446"/>
              <a:ext cx="614994" cy="1959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7" name="그림 46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654" y="1066723"/>
              <a:ext cx="2048256" cy="1676400"/>
            </a:xfrm>
            <a:prstGeom prst="rect">
              <a:avLst/>
            </a:prstGeom>
          </p:spPr>
        </p:pic>
        <p:pic>
          <p:nvPicPr>
            <p:cNvPr id="48" name="그림 47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55792" y="1066148"/>
              <a:ext cx="2048256" cy="1676400"/>
            </a:xfrm>
            <a:prstGeom prst="rect">
              <a:avLst/>
            </a:prstGeom>
          </p:spPr>
        </p:pic>
        <p:sp>
          <p:nvSpPr>
            <p:cNvPr id="49" name="직사각형 48"/>
            <p:cNvSpPr/>
            <p:nvPr/>
          </p:nvSpPr>
          <p:spPr>
            <a:xfrm>
              <a:off x="1119706" y="1723533"/>
              <a:ext cx="865466" cy="13766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059123" y="1565240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1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258316" y="1565240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462318" y="1563463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662154" y="1565240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155088" y="1564737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356197" y="1563463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557736" y="156533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766220" y="1564607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95454" y="1694391"/>
              <a:ext cx="515281" cy="1959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직사각형 58"/>
            <p:cNvSpPr/>
            <p:nvPr/>
          </p:nvSpPr>
          <p:spPr>
            <a:xfrm>
              <a:off x="3256506" y="1719713"/>
              <a:ext cx="865466" cy="13766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3195922" y="156142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1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395115" y="156142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599118" y="155964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798953" y="156142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291887" y="1560916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492997" y="1559642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694536" y="1561511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3903020" y="1560787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2751142" y="1690573"/>
              <a:ext cx="496392" cy="1959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직사각형 68"/>
            <p:cNvSpPr/>
            <p:nvPr/>
          </p:nvSpPr>
          <p:spPr>
            <a:xfrm>
              <a:off x="5343161" y="1727826"/>
              <a:ext cx="865466" cy="13766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5282577" y="1569534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1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5481770" y="1569534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685773" y="1567756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3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885607" y="1569534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4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378542" y="1569030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1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579652" y="1567756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781190" y="1569624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3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989675" y="1568900"/>
              <a:ext cx="294445" cy="15698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4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727357" y="1698685"/>
              <a:ext cx="606831" cy="1959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1917994" y="1693603"/>
              <a:ext cx="609382" cy="1959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3 </a:t>
              </a:r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1926856" y="3439556"/>
              <a:ext cx="609382" cy="19594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" name="직사각형 78"/>
          <p:cNvSpPr/>
          <p:nvPr/>
        </p:nvSpPr>
        <p:spPr>
          <a:xfrm>
            <a:off x="780612" y="3553684"/>
            <a:ext cx="5337478" cy="7509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: </a:t>
            </a: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7.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of western blots of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. 1b. Th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red box indicated the representative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ands of protein levels in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Fig.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1b. Protein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expression of HIF-1α i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normal and OSCC patient tissues by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GAPDH was used as the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internal control.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373930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165254" y="6128281"/>
            <a:ext cx="4481896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16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he original figure of western blots of Figure 4a. The red box indicated the representative bands of protein levels in Fig. 4a. Protein expression of Par3, TJP1 Par6b and </a:t>
            </a:r>
            <a:r>
              <a:rPr lang="en-US" altLang="ko-KR" sz="1000" kern="1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CC-9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lin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reated with siRNA-Par3 or control siRNA by western blotting. GAPDH was used as the internal control. 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058" y="3882414"/>
            <a:ext cx="1349092" cy="1104167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5274" y="3882414"/>
            <a:ext cx="1349092" cy="110416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6361" y="3883216"/>
            <a:ext cx="1349092" cy="1104167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6361" y="2757631"/>
            <a:ext cx="1349092" cy="1104167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7244" y="5007170"/>
            <a:ext cx="1349092" cy="1104167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7244" y="1633492"/>
            <a:ext cx="1349092" cy="1104167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7244" y="509538"/>
            <a:ext cx="1349092" cy="110416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 rot="16200000">
            <a:off x="893190" y="947373"/>
            <a:ext cx="1104167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900" b="1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890992" y="2074845"/>
            <a:ext cx="11041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900" b="1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-1520218" y="3196175"/>
            <a:ext cx="5601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C9</a:t>
            </a:r>
            <a:endParaRPr lang="ko-KR" altLang="en-US" sz="900" b="1" dirty="0"/>
          </a:p>
        </p:txBody>
      </p:sp>
      <p:cxnSp>
        <p:nvCxnSpPr>
          <p:cNvPr id="14" name="직선 연결선 13"/>
          <p:cNvCxnSpPr/>
          <p:nvPr/>
        </p:nvCxnSpPr>
        <p:spPr>
          <a:xfrm flipH="1">
            <a:off x="1354173" y="522630"/>
            <a:ext cx="4016" cy="559592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535802" y="305155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9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921026" y="305582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 exposure</a:t>
            </a:r>
            <a:endParaRPr lang="ko-KR" altLang="en-US" sz="9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307258" y="306723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ko-KR" altLang="en-US" sz="900" b="1" dirty="0"/>
          </a:p>
        </p:txBody>
      </p:sp>
      <p:sp>
        <p:nvSpPr>
          <p:cNvPr id="18" name="직사각형 17"/>
          <p:cNvSpPr/>
          <p:nvPr/>
        </p:nvSpPr>
        <p:spPr>
          <a:xfrm>
            <a:off x="2121564" y="2126856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576533" y="2085558"/>
            <a:ext cx="33910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525471" y="931382"/>
            <a:ext cx="40084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570834" y="1011453"/>
            <a:ext cx="34933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201046" y="92723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266291" y="93064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직사각형 23"/>
          <p:cNvSpPr/>
          <p:nvPr/>
        </p:nvSpPr>
        <p:spPr>
          <a:xfrm>
            <a:off x="2194915" y="1063019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509437" y="2009912"/>
            <a:ext cx="40696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126832" y="200762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197027" y="201103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890634" y="3198509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9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1479502" y="3210242"/>
            <a:ext cx="4456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517401" y="3095890"/>
            <a:ext cx="41047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872631" y="309589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941737" y="309935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1863348" y="3249602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580428" y="4372557"/>
            <a:ext cx="38772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직사각형 34"/>
          <p:cNvSpPr/>
          <p:nvPr/>
        </p:nvSpPr>
        <p:spPr>
          <a:xfrm>
            <a:off x="2186909" y="4434612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583429" y="4299539"/>
            <a:ext cx="39125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2190775" y="429717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257010" y="430267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889730" y="4322173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900" b="1" dirty="0"/>
          </a:p>
        </p:txBody>
      </p:sp>
      <p:sp>
        <p:nvSpPr>
          <p:cNvPr id="40" name="TextBox 39"/>
          <p:cNvSpPr txBox="1"/>
          <p:nvPr/>
        </p:nvSpPr>
        <p:spPr>
          <a:xfrm rot="16200000">
            <a:off x="888924" y="5444982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1578118" y="5462604"/>
            <a:ext cx="37854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직사각형 41"/>
          <p:cNvSpPr/>
          <p:nvPr/>
        </p:nvSpPr>
        <p:spPr>
          <a:xfrm>
            <a:off x="1889286" y="5512287"/>
            <a:ext cx="150657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559022" y="5388500"/>
            <a:ext cx="40124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891204" y="538746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960061" y="539041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6" name="그림 4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2200" y="514668"/>
            <a:ext cx="1349092" cy="1104167"/>
          </a:xfrm>
          <a:prstGeom prst="rect">
            <a:avLst/>
          </a:prstGeom>
          <a:ln>
            <a:noFill/>
          </a:ln>
        </p:spPr>
      </p:pic>
      <p:pic>
        <p:nvPicPr>
          <p:cNvPr id="47" name="그림 4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3227" y="515482"/>
            <a:ext cx="1349092" cy="1104167"/>
          </a:xfrm>
          <a:prstGeom prst="rect">
            <a:avLst/>
          </a:prstGeom>
          <a:ln>
            <a:noFill/>
          </a:ln>
        </p:spPr>
      </p:pic>
      <p:sp>
        <p:nvSpPr>
          <p:cNvPr id="48" name="TextBox 47"/>
          <p:cNvSpPr txBox="1"/>
          <p:nvPr/>
        </p:nvSpPr>
        <p:spPr>
          <a:xfrm>
            <a:off x="2899209" y="935103"/>
            <a:ext cx="42132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2922201" y="1015174"/>
            <a:ext cx="39219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595269" y="93095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660514" y="93436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직사각형 51"/>
          <p:cNvSpPr/>
          <p:nvPr/>
        </p:nvSpPr>
        <p:spPr>
          <a:xfrm>
            <a:off x="3589137" y="1066740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284551" y="935000"/>
            <a:ext cx="41331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342668" y="1015071"/>
            <a:ext cx="34905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972604" y="93085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5040230" y="93426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직사각형 56"/>
          <p:cNvSpPr/>
          <p:nvPr/>
        </p:nvSpPr>
        <p:spPr>
          <a:xfrm>
            <a:off x="4966473" y="1066637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pic>
        <p:nvPicPr>
          <p:cNvPr id="58" name="그림 5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2200" y="1638150"/>
            <a:ext cx="1349092" cy="1104167"/>
          </a:xfrm>
          <a:prstGeom prst="rect">
            <a:avLst/>
          </a:prstGeom>
          <a:ln>
            <a:noFill/>
          </a:ln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3227" y="1638150"/>
            <a:ext cx="1349092" cy="1104167"/>
          </a:xfrm>
          <a:prstGeom prst="rect">
            <a:avLst/>
          </a:prstGeom>
          <a:ln>
            <a:noFill/>
          </a:ln>
        </p:spPr>
      </p:pic>
      <p:sp>
        <p:nvSpPr>
          <p:cNvPr id="60" name="직사각형 59"/>
          <p:cNvSpPr/>
          <p:nvPr/>
        </p:nvSpPr>
        <p:spPr>
          <a:xfrm>
            <a:off x="3516820" y="2126856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2973414" y="2085558"/>
            <a:ext cx="33748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2904394" y="2009912"/>
            <a:ext cx="40726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522088" y="200762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592282" y="201103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직사각형 64"/>
          <p:cNvSpPr/>
          <p:nvPr/>
        </p:nvSpPr>
        <p:spPr>
          <a:xfrm>
            <a:off x="4898182" y="2126856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315612" y="2085558"/>
            <a:ext cx="37664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4224338" y="2009912"/>
            <a:ext cx="46867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903450" y="200762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4973645" y="201103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그림 6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9389" y="5007415"/>
            <a:ext cx="1349092" cy="1104167"/>
          </a:xfrm>
          <a:prstGeom prst="rect">
            <a:avLst/>
          </a:prstGeom>
        </p:spPr>
      </p:pic>
      <p:pic>
        <p:nvPicPr>
          <p:cNvPr id="71" name="그림 70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9958" y="5007415"/>
            <a:ext cx="1349092" cy="1104167"/>
          </a:xfrm>
          <a:prstGeom prst="rect">
            <a:avLst/>
          </a:prstGeom>
        </p:spPr>
      </p:pic>
      <p:sp>
        <p:nvSpPr>
          <p:cNvPr id="72" name="TextBox 71"/>
          <p:cNvSpPr txBox="1"/>
          <p:nvPr/>
        </p:nvSpPr>
        <p:spPr>
          <a:xfrm>
            <a:off x="2954096" y="5462604"/>
            <a:ext cx="40034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직사각형 72"/>
          <p:cNvSpPr/>
          <p:nvPr/>
        </p:nvSpPr>
        <p:spPr>
          <a:xfrm>
            <a:off x="3287062" y="5512287"/>
            <a:ext cx="150657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930222" y="5388500"/>
            <a:ext cx="42782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288980" y="538746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357837" y="539041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294070" y="5462604"/>
            <a:ext cx="43229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직사각형 77"/>
          <p:cNvSpPr/>
          <p:nvPr/>
        </p:nvSpPr>
        <p:spPr>
          <a:xfrm>
            <a:off x="4658992" y="5512287"/>
            <a:ext cx="150657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279107" y="5388500"/>
            <a:ext cx="45086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660910" y="538746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729767" y="539041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020546" y="4378029"/>
            <a:ext cx="33748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직사각형 82"/>
          <p:cNvSpPr/>
          <p:nvPr/>
        </p:nvSpPr>
        <p:spPr>
          <a:xfrm>
            <a:off x="3576782" y="4435322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929521" y="4300249"/>
            <a:ext cx="43503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3580649" y="429788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646883" y="430338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4345371" y="4380832"/>
            <a:ext cx="39139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직사각형 87"/>
          <p:cNvSpPr/>
          <p:nvPr/>
        </p:nvSpPr>
        <p:spPr>
          <a:xfrm>
            <a:off x="4955513" y="4435744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4318918" y="4300672"/>
            <a:ext cx="42436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959380" y="430015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5025614" y="430381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920286" y="92766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992674" y="93107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직사각형 93"/>
          <p:cNvSpPr/>
          <p:nvPr/>
        </p:nvSpPr>
        <p:spPr>
          <a:xfrm>
            <a:off x="1914155" y="1063447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3314909" y="92928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3387297" y="93269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직사각형 96"/>
          <p:cNvSpPr/>
          <p:nvPr/>
        </p:nvSpPr>
        <p:spPr>
          <a:xfrm>
            <a:off x="3308778" y="1065069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696326" y="93021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771095" y="93362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직사각형 99"/>
          <p:cNvSpPr/>
          <p:nvPr/>
        </p:nvSpPr>
        <p:spPr>
          <a:xfrm>
            <a:off x="4690195" y="1066004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01" name="직사각형 100"/>
          <p:cNvSpPr/>
          <p:nvPr/>
        </p:nvSpPr>
        <p:spPr>
          <a:xfrm>
            <a:off x="1852677" y="2125577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857945" y="200634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928139" y="200975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직사각형 103"/>
          <p:cNvSpPr/>
          <p:nvPr/>
        </p:nvSpPr>
        <p:spPr>
          <a:xfrm>
            <a:off x="3244416" y="2125263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3249684" y="200603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324641" y="200943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직사각형 106"/>
          <p:cNvSpPr/>
          <p:nvPr/>
        </p:nvSpPr>
        <p:spPr>
          <a:xfrm>
            <a:off x="4625713" y="2125263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4630981" y="200603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4705937" y="200943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직사각형 109"/>
          <p:cNvSpPr/>
          <p:nvPr/>
        </p:nvSpPr>
        <p:spPr>
          <a:xfrm>
            <a:off x="1913006" y="4433066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1922013" y="429567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988248" y="430117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직사각형 112"/>
          <p:cNvSpPr/>
          <p:nvPr/>
        </p:nvSpPr>
        <p:spPr>
          <a:xfrm>
            <a:off x="3299059" y="4433066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3307687" y="4295627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378684" y="430113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직사각형 115"/>
          <p:cNvSpPr/>
          <p:nvPr/>
        </p:nvSpPr>
        <p:spPr>
          <a:xfrm>
            <a:off x="4682233" y="4435194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4688480" y="429960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4761858" y="430326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9" name="그림 11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21063" y="2755758"/>
            <a:ext cx="1349092" cy="1104167"/>
          </a:xfrm>
          <a:prstGeom prst="rect">
            <a:avLst/>
          </a:prstGeom>
        </p:spPr>
      </p:pic>
      <p:pic>
        <p:nvPicPr>
          <p:cNvPr id="120" name="그림 11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14051" y="2757631"/>
            <a:ext cx="1349092" cy="1104167"/>
          </a:xfrm>
          <a:prstGeom prst="rect">
            <a:avLst/>
          </a:prstGeom>
        </p:spPr>
      </p:pic>
      <p:sp>
        <p:nvSpPr>
          <p:cNvPr id="121" name="TextBox 120"/>
          <p:cNvSpPr txBox="1"/>
          <p:nvPr/>
        </p:nvSpPr>
        <p:spPr>
          <a:xfrm>
            <a:off x="2158378" y="309750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227484" y="310097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직사각형 122"/>
          <p:cNvSpPr/>
          <p:nvPr/>
        </p:nvSpPr>
        <p:spPr>
          <a:xfrm>
            <a:off x="2149095" y="3251215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991137" y="3202947"/>
            <a:ext cx="34292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2935551" y="3088595"/>
            <a:ext cx="39404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274349" y="308859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343455" y="309206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직사각형 127"/>
          <p:cNvSpPr/>
          <p:nvPr/>
        </p:nvSpPr>
        <p:spPr>
          <a:xfrm>
            <a:off x="3265066" y="3242307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560097" y="309020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3629202" y="309367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직사각형 130"/>
          <p:cNvSpPr/>
          <p:nvPr/>
        </p:nvSpPr>
        <p:spPr>
          <a:xfrm>
            <a:off x="3550813" y="3243920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4323249" y="3199694"/>
            <a:ext cx="39933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314052" y="3085342"/>
            <a:ext cx="40883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667636" y="308534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4736741" y="308881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직사각형 135"/>
          <p:cNvSpPr/>
          <p:nvPr/>
        </p:nvSpPr>
        <p:spPr>
          <a:xfrm>
            <a:off x="4658352" y="3239054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4946240" y="308695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5017726" y="309042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직사각형 138"/>
          <p:cNvSpPr/>
          <p:nvPr/>
        </p:nvSpPr>
        <p:spPr>
          <a:xfrm>
            <a:off x="4944099" y="3240667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0" name="직사각형 139"/>
          <p:cNvSpPr/>
          <p:nvPr/>
        </p:nvSpPr>
        <p:spPr>
          <a:xfrm>
            <a:off x="2165906" y="5512287"/>
            <a:ext cx="150657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2167824" y="538746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2236681" y="539041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직사각형 142"/>
          <p:cNvSpPr/>
          <p:nvPr/>
        </p:nvSpPr>
        <p:spPr>
          <a:xfrm>
            <a:off x="3558396" y="5512287"/>
            <a:ext cx="150657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3560314" y="538746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3629171" y="539041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직사각형 145"/>
          <p:cNvSpPr/>
          <p:nvPr/>
        </p:nvSpPr>
        <p:spPr>
          <a:xfrm>
            <a:off x="4939877" y="5511494"/>
            <a:ext cx="150657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4941795" y="538667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5010652" y="538962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2425507" y="2085558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2468799" y="3212848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476349" y="5467092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462346" y="997290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483108" y="4372557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9425209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159070" y="6164377"/>
            <a:ext cx="4452013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17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he original figure of western blots of Figure 4a. The red box indicated the representative bands of protein levels in Fig. 4a. Protein expression of Par3, TJP1 Par6b and </a:t>
            </a:r>
            <a:r>
              <a:rPr lang="en-US" altLang="ko-KR" sz="1000" kern="100" dirty="0" err="1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CC-25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lin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reated with siRNA-Par3 or control siRNA by western blotting. GAPDH was used as the internal control. 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2899" y="530479"/>
            <a:ext cx="1349092" cy="1104167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1991" y="531488"/>
            <a:ext cx="1349092" cy="110416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1061" y="534608"/>
            <a:ext cx="1349092" cy="1104167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0178" y="1661136"/>
            <a:ext cx="1349092" cy="1104167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0178" y="5028235"/>
            <a:ext cx="1349092" cy="1104167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0178" y="2782534"/>
            <a:ext cx="1349092" cy="1104167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1061" y="3903234"/>
            <a:ext cx="1349092" cy="1104167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 rot="16200000">
            <a:off x="887007" y="968193"/>
            <a:ext cx="1104167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900" b="1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884809" y="2095665"/>
            <a:ext cx="11041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900" b="1" dirty="0"/>
          </a:p>
        </p:txBody>
      </p:sp>
      <p:sp>
        <p:nvSpPr>
          <p:cNvPr id="13" name="TextBox 12"/>
          <p:cNvSpPr txBox="1"/>
          <p:nvPr/>
        </p:nvSpPr>
        <p:spPr>
          <a:xfrm rot="16200000">
            <a:off x="-1526401" y="3216995"/>
            <a:ext cx="5601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C25</a:t>
            </a:r>
            <a:endParaRPr lang="ko-KR" altLang="en-US" sz="900" b="1" dirty="0"/>
          </a:p>
        </p:txBody>
      </p:sp>
      <p:cxnSp>
        <p:nvCxnSpPr>
          <p:cNvPr id="14" name="직선 연결선 13"/>
          <p:cNvCxnSpPr/>
          <p:nvPr/>
        </p:nvCxnSpPr>
        <p:spPr>
          <a:xfrm flipH="1">
            <a:off x="1347990" y="543450"/>
            <a:ext cx="4016" cy="559592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529619" y="325975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9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2914843" y="326402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 exposure</a:t>
            </a:r>
            <a:endParaRPr lang="ko-KR" altLang="en-US" sz="9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4301075" y="327543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ko-KR" altLang="en-US" sz="900" b="1" dirty="0"/>
          </a:p>
        </p:txBody>
      </p:sp>
      <p:sp>
        <p:nvSpPr>
          <p:cNvPr id="18" name="직사각형 17"/>
          <p:cNvSpPr/>
          <p:nvPr/>
        </p:nvSpPr>
        <p:spPr>
          <a:xfrm>
            <a:off x="2145784" y="2156170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1591534" y="2122470"/>
            <a:ext cx="34424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426941" y="927513"/>
            <a:ext cx="42492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311128" y="1000099"/>
            <a:ext cx="52968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070821" y="92746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138356" y="93087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직사각형 23"/>
          <p:cNvSpPr/>
          <p:nvPr/>
        </p:nvSpPr>
        <p:spPr>
          <a:xfrm>
            <a:off x="1781803" y="1054605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480400" y="1962847"/>
            <a:ext cx="45159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6200000">
            <a:off x="884451" y="3219329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9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1539430" y="3245237"/>
            <a:ext cx="38206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496495" y="3162211"/>
            <a:ext cx="42549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867520" y="316174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933370" y="316493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직사각형 30"/>
          <p:cNvSpPr/>
          <p:nvPr/>
        </p:nvSpPr>
        <p:spPr>
          <a:xfrm>
            <a:off x="1862508" y="3278558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559683" y="4444341"/>
            <a:ext cx="40354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2174117" y="4511621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1514071" y="4310051"/>
            <a:ext cx="45079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181817" y="430843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253818" y="431227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 rot="16200000">
            <a:off x="883547" y="4342993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900" b="1" dirty="0"/>
          </a:p>
        </p:txBody>
      </p:sp>
      <p:sp>
        <p:nvSpPr>
          <p:cNvPr id="38" name="TextBox 37"/>
          <p:cNvSpPr txBox="1"/>
          <p:nvPr/>
        </p:nvSpPr>
        <p:spPr>
          <a:xfrm rot="16200000">
            <a:off x="882741" y="5465802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1493817" y="5345746"/>
            <a:ext cx="38740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직사각형 39"/>
          <p:cNvSpPr/>
          <p:nvPr/>
        </p:nvSpPr>
        <p:spPr>
          <a:xfrm>
            <a:off x="2095280" y="5394821"/>
            <a:ext cx="154018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444969" y="5224613"/>
            <a:ext cx="43808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098723" y="522461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167580" y="522756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4" name="그림 43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4843" y="3904914"/>
            <a:ext cx="1349092" cy="1104167"/>
          </a:xfrm>
          <a:prstGeom prst="rect">
            <a:avLst/>
          </a:prstGeom>
          <a:ln>
            <a:noFill/>
          </a:ln>
        </p:spPr>
      </p:pic>
      <p:pic>
        <p:nvPicPr>
          <p:cNvPr id="45" name="그림 4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7044" y="3904914"/>
            <a:ext cx="1349092" cy="1104167"/>
          </a:xfrm>
          <a:prstGeom prst="rect">
            <a:avLst/>
          </a:prstGeom>
          <a:ln>
            <a:noFill/>
          </a:ln>
        </p:spPr>
      </p:pic>
      <p:pic>
        <p:nvPicPr>
          <p:cNvPr id="46" name="그림 45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4843" y="2781876"/>
            <a:ext cx="1349092" cy="1104167"/>
          </a:xfrm>
          <a:prstGeom prst="rect">
            <a:avLst/>
          </a:prstGeom>
        </p:spPr>
      </p:pic>
      <p:pic>
        <p:nvPicPr>
          <p:cNvPr id="47" name="그림 46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7044" y="2780016"/>
            <a:ext cx="1349092" cy="1104167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2974927" y="4446983"/>
            <a:ext cx="37928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3565099" y="4514263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2907573" y="4312693"/>
            <a:ext cx="44827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572799" y="431108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3644800" y="431491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243715" y="4444341"/>
            <a:ext cx="49471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직사각형 53"/>
          <p:cNvSpPr/>
          <p:nvPr/>
        </p:nvSpPr>
        <p:spPr>
          <a:xfrm>
            <a:off x="4949323" y="4511621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271367" y="4310051"/>
            <a:ext cx="46870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4957023" y="430843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029024" y="431227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8" name="그림 57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4843" y="5028235"/>
            <a:ext cx="1349092" cy="1104167"/>
          </a:xfrm>
          <a:prstGeom prst="rect">
            <a:avLst/>
          </a:prstGeom>
        </p:spPr>
      </p:pic>
      <p:pic>
        <p:nvPicPr>
          <p:cNvPr id="59" name="그림 58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7044" y="5028235"/>
            <a:ext cx="1349092" cy="1104167"/>
          </a:xfrm>
          <a:prstGeom prst="rect">
            <a:avLst/>
          </a:prstGeom>
        </p:spPr>
      </p:pic>
      <p:sp>
        <p:nvSpPr>
          <p:cNvPr id="60" name="TextBox 59"/>
          <p:cNvSpPr txBox="1"/>
          <p:nvPr/>
        </p:nvSpPr>
        <p:spPr>
          <a:xfrm>
            <a:off x="2889498" y="5342908"/>
            <a:ext cx="38604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직사각형 60"/>
          <p:cNvSpPr/>
          <p:nvPr/>
        </p:nvSpPr>
        <p:spPr>
          <a:xfrm>
            <a:off x="3489591" y="5391984"/>
            <a:ext cx="154018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839920" y="5221775"/>
            <a:ext cx="43744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493034" y="522177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3561891" y="5224727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151318" y="5345746"/>
            <a:ext cx="50714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직사각형 65"/>
          <p:cNvSpPr/>
          <p:nvPr/>
        </p:nvSpPr>
        <p:spPr>
          <a:xfrm>
            <a:off x="4872519" y="5394821"/>
            <a:ext cx="154018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109295" y="5224613"/>
            <a:ext cx="55099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875962" y="522461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4944819" y="522756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직사각형 69"/>
          <p:cNvSpPr/>
          <p:nvPr/>
        </p:nvSpPr>
        <p:spPr>
          <a:xfrm>
            <a:off x="1899216" y="4512039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1906917" y="4308857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978918" y="431269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직사각형 72"/>
          <p:cNvSpPr/>
          <p:nvPr/>
        </p:nvSpPr>
        <p:spPr>
          <a:xfrm>
            <a:off x="3296556" y="4515519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304256" y="431233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376257" y="431617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직사각형 75"/>
          <p:cNvSpPr/>
          <p:nvPr/>
        </p:nvSpPr>
        <p:spPr>
          <a:xfrm>
            <a:off x="4679410" y="4511977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687110" y="430879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759111" y="431263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9" name="그림 7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4843" y="1661027"/>
            <a:ext cx="1349092" cy="1104167"/>
          </a:xfrm>
          <a:prstGeom prst="rect">
            <a:avLst/>
          </a:prstGeom>
        </p:spPr>
      </p:pic>
      <p:pic>
        <p:nvPicPr>
          <p:cNvPr id="80" name="그림 7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6399" y="1661921"/>
            <a:ext cx="1349092" cy="1104167"/>
          </a:xfrm>
          <a:prstGeom prst="rect">
            <a:avLst/>
          </a:prstGeom>
        </p:spPr>
      </p:pic>
      <p:sp>
        <p:nvSpPr>
          <p:cNvPr id="81" name="직사각형 80"/>
          <p:cNvSpPr/>
          <p:nvPr/>
        </p:nvSpPr>
        <p:spPr>
          <a:xfrm>
            <a:off x="1873859" y="2156197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876141" y="196211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949774" y="196588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147482" y="196761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217907" y="196990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직사각형 85"/>
          <p:cNvSpPr/>
          <p:nvPr/>
        </p:nvSpPr>
        <p:spPr>
          <a:xfrm>
            <a:off x="3542647" y="2154546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2927042" y="2120845"/>
            <a:ext cx="4055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2913856" y="1958060"/>
            <a:ext cx="42151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직사각형 88"/>
          <p:cNvSpPr/>
          <p:nvPr/>
        </p:nvSpPr>
        <p:spPr>
          <a:xfrm>
            <a:off x="3270721" y="2154572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3272055" y="196126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3346637" y="196425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3543737" y="196538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3614770" y="1968277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직사각형 93"/>
          <p:cNvSpPr/>
          <p:nvPr/>
        </p:nvSpPr>
        <p:spPr>
          <a:xfrm>
            <a:off x="4894203" y="2159972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323905" y="2126271"/>
            <a:ext cx="3602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4277936" y="1963486"/>
            <a:ext cx="40899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직사각형 96"/>
          <p:cNvSpPr/>
          <p:nvPr/>
        </p:nvSpPr>
        <p:spPr>
          <a:xfrm>
            <a:off x="4622278" y="2159998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626748" y="1966107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698193" y="196968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4894872" y="197125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966326" y="197370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직사각형 101"/>
          <p:cNvSpPr/>
          <p:nvPr/>
        </p:nvSpPr>
        <p:spPr>
          <a:xfrm>
            <a:off x="2057020" y="1054605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792702" y="92645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860237" y="92986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817291" y="920807"/>
            <a:ext cx="42745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2831168" y="965291"/>
            <a:ext cx="40730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3463703" y="92075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3531238" y="92416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직사각형 108"/>
          <p:cNvSpPr/>
          <p:nvPr/>
        </p:nvSpPr>
        <p:spPr>
          <a:xfrm>
            <a:off x="3174685" y="1047899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0" name="직사각형 109"/>
          <p:cNvSpPr/>
          <p:nvPr/>
        </p:nvSpPr>
        <p:spPr>
          <a:xfrm>
            <a:off x="3449902" y="1047899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185584" y="91974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3253120" y="92315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4132937" y="920092"/>
            <a:ext cx="46236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217771" y="964576"/>
            <a:ext cx="37125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4814258" y="92004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4881793" y="92345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직사각형 116"/>
          <p:cNvSpPr/>
          <p:nvPr/>
        </p:nvSpPr>
        <p:spPr>
          <a:xfrm>
            <a:off x="4525240" y="1047184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8" name="직사각형 117"/>
          <p:cNvSpPr/>
          <p:nvPr/>
        </p:nvSpPr>
        <p:spPr>
          <a:xfrm>
            <a:off x="4800457" y="1047184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536139" y="91903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4603674" y="92244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153846" y="316258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2219696" y="316577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직사각형 122"/>
          <p:cNvSpPr/>
          <p:nvPr/>
        </p:nvSpPr>
        <p:spPr>
          <a:xfrm>
            <a:off x="2148024" y="3279131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2902968" y="3244118"/>
            <a:ext cx="41459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2903457" y="3161092"/>
            <a:ext cx="4145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263586" y="316062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329436" y="316381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직사각형 127"/>
          <p:cNvSpPr/>
          <p:nvPr/>
        </p:nvSpPr>
        <p:spPr>
          <a:xfrm>
            <a:off x="3258574" y="3277439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549912" y="316146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3615762" y="316465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직사각형 130"/>
          <p:cNvSpPr/>
          <p:nvPr/>
        </p:nvSpPr>
        <p:spPr>
          <a:xfrm>
            <a:off x="3544090" y="3278011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2" name="TextBox 131"/>
          <p:cNvSpPr txBox="1"/>
          <p:nvPr/>
        </p:nvSpPr>
        <p:spPr>
          <a:xfrm>
            <a:off x="4258000" y="3241549"/>
            <a:ext cx="44224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192149" y="3158523"/>
            <a:ext cx="50858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646266" y="315805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4712116" y="316124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직사각형 135"/>
          <p:cNvSpPr/>
          <p:nvPr/>
        </p:nvSpPr>
        <p:spPr>
          <a:xfrm>
            <a:off x="4641254" y="3274870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4932592" y="315889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4998442" y="316208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직사각형 138"/>
          <p:cNvSpPr/>
          <p:nvPr/>
        </p:nvSpPr>
        <p:spPr>
          <a:xfrm>
            <a:off x="4926769" y="3275443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0" name="직사각형 139"/>
          <p:cNvSpPr/>
          <p:nvPr/>
        </p:nvSpPr>
        <p:spPr>
          <a:xfrm>
            <a:off x="1814458" y="5382574"/>
            <a:ext cx="154018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1817902" y="522491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1886759" y="522786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3227738" y="522252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3296595" y="522547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직사각형 144"/>
          <p:cNvSpPr/>
          <p:nvPr/>
        </p:nvSpPr>
        <p:spPr>
          <a:xfrm>
            <a:off x="3214104" y="5382574"/>
            <a:ext cx="154018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4609651" y="522541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4678508" y="5228368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직사각형 147"/>
          <p:cNvSpPr/>
          <p:nvPr/>
        </p:nvSpPr>
        <p:spPr>
          <a:xfrm>
            <a:off x="4594523" y="5382574"/>
            <a:ext cx="154018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2459023" y="2122928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2434590" y="3244558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398751" y="534336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367275" y="1016080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474463" y="4442217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721344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1" name="그룹 170"/>
          <p:cNvGrpSpPr>
            <a:grpSpLocks noChangeAspect="1"/>
          </p:cNvGrpSpPr>
          <p:nvPr/>
        </p:nvGrpSpPr>
        <p:grpSpPr>
          <a:xfrm>
            <a:off x="983375" y="546289"/>
            <a:ext cx="4934207" cy="3900551"/>
            <a:chOff x="34012" y="6220408"/>
            <a:chExt cx="6796365" cy="5372608"/>
          </a:xfrm>
        </p:grpSpPr>
        <p:pic>
          <p:nvPicPr>
            <p:cNvPr id="81" name="그림 8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857" y="9915459"/>
              <a:ext cx="2048256" cy="1676400"/>
            </a:xfrm>
            <a:prstGeom prst="rect">
              <a:avLst/>
            </a:prstGeom>
          </p:spPr>
        </p:pic>
        <p:pic>
          <p:nvPicPr>
            <p:cNvPr id="82" name="그림 81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857" y="8208847"/>
              <a:ext cx="2048256" cy="1676400"/>
            </a:xfrm>
            <a:prstGeom prst="rect">
              <a:avLst/>
            </a:prstGeom>
          </p:spPr>
        </p:pic>
        <p:sp>
          <p:nvSpPr>
            <p:cNvPr id="84" name="TextBox 83"/>
            <p:cNvSpPr txBox="1"/>
            <p:nvPr/>
          </p:nvSpPr>
          <p:spPr>
            <a:xfrm rot="16200000">
              <a:off x="-421478" y="7211086"/>
              <a:ext cx="1676402" cy="26216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900" b="1" dirty="0"/>
            </a:p>
          </p:txBody>
        </p:sp>
        <p:sp>
          <p:nvSpPr>
            <p:cNvPr id="85" name="TextBox 84"/>
            <p:cNvSpPr txBox="1"/>
            <p:nvPr/>
          </p:nvSpPr>
          <p:spPr>
            <a:xfrm rot="16200000">
              <a:off x="-414698" y="8925394"/>
              <a:ext cx="1662992" cy="2621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ko-KR" altLang="en-US" sz="900" b="1" dirty="0"/>
            </a:p>
          </p:txBody>
        </p:sp>
        <p:sp>
          <p:nvSpPr>
            <p:cNvPr id="86" name="TextBox 85"/>
            <p:cNvSpPr txBox="1"/>
            <p:nvPr/>
          </p:nvSpPr>
          <p:spPr>
            <a:xfrm rot="16200000">
              <a:off x="-2381957" y="8903657"/>
              <a:ext cx="5094105" cy="2621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CC cell lines</a:t>
              </a:r>
              <a:endParaRPr lang="ko-KR" altLang="en-US" sz="900" b="1" dirty="0"/>
            </a:p>
          </p:txBody>
        </p:sp>
        <p:cxnSp>
          <p:nvCxnSpPr>
            <p:cNvPr id="87" name="직선 연결선 86"/>
            <p:cNvCxnSpPr/>
            <p:nvPr/>
          </p:nvCxnSpPr>
          <p:spPr>
            <a:xfrm flipH="1">
              <a:off x="276691" y="6505794"/>
              <a:ext cx="6098" cy="507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8" name="TextBox 87"/>
            <p:cNvSpPr txBox="1"/>
            <p:nvPr/>
          </p:nvSpPr>
          <p:spPr>
            <a:xfrm>
              <a:off x="533672" y="6250469"/>
              <a:ext cx="2050073" cy="26216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ko-KR" altLang="en-US" sz="900" b="1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655562" y="6220408"/>
              <a:ext cx="2070170" cy="26216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 exposure</a:t>
              </a:r>
              <a:endParaRPr lang="ko-KR" altLang="en-US" sz="900" b="1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760207" y="6222141"/>
              <a:ext cx="2070170" cy="26216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 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xposure</a:t>
              </a:r>
              <a:endParaRPr lang="ko-KR" altLang="en-US" sz="900" b="1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807214" y="8937813"/>
              <a:ext cx="420781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 rot="16200000">
              <a:off x="-424227" y="10623731"/>
              <a:ext cx="1676402" cy="26216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900" b="1" dirty="0"/>
            </a:p>
          </p:txBody>
        </p:sp>
        <p:pic>
          <p:nvPicPr>
            <p:cNvPr id="93" name="그림 92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5072" y="6506754"/>
              <a:ext cx="2048256" cy="1676400"/>
            </a:xfrm>
            <a:prstGeom prst="rect">
              <a:avLst/>
            </a:prstGeom>
          </p:spPr>
        </p:pic>
        <p:pic>
          <p:nvPicPr>
            <p:cNvPr id="94" name="그림 9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8057" y="6503969"/>
              <a:ext cx="2048256" cy="1676400"/>
            </a:xfrm>
            <a:prstGeom prst="rect">
              <a:avLst/>
            </a:prstGeom>
          </p:spPr>
        </p:pic>
        <p:pic>
          <p:nvPicPr>
            <p:cNvPr id="95" name="그림 94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60207" y="6548582"/>
              <a:ext cx="2048256" cy="1676400"/>
            </a:xfrm>
            <a:prstGeom prst="rect">
              <a:avLst/>
            </a:prstGeom>
          </p:spPr>
        </p:pic>
        <p:sp>
          <p:nvSpPr>
            <p:cNvPr id="96" name="TextBox 95"/>
            <p:cNvSpPr txBox="1"/>
            <p:nvPr/>
          </p:nvSpPr>
          <p:spPr>
            <a:xfrm>
              <a:off x="465405" y="7197746"/>
              <a:ext cx="552200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직사각형 96"/>
            <p:cNvSpPr/>
            <p:nvPr/>
          </p:nvSpPr>
          <p:spPr>
            <a:xfrm>
              <a:off x="1017615" y="7258019"/>
              <a:ext cx="644537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 rot="16200000">
              <a:off x="874649" y="7011798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 rot="16200000">
              <a:off x="970034" y="7011797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6200000">
              <a:off x="1068491" y="701198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2669883" y="7199889"/>
              <a:ext cx="482640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직사각형 101"/>
            <p:cNvSpPr/>
            <p:nvPr/>
          </p:nvSpPr>
          <p:spPr>
            <a:xfrm>
              <a:off x="3152533" y="7260164"/>
              <a:ext cx="631772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 rot="16200000">
              <a:off x="3009567" y="7013942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 rot="16200000">
              <a:off x="3104952" y="7013941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 rot="16200000">
              <a:off x="3203409" y="7014129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4734555" y="7238114"/>
              <a:ext cx="503424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직사각형 106"/>
            <p:cNvSpPr/>
            <p:nvPr/>
          </p:nvSpPr>
          <p:spPr>
            <a:xfrm>
              <a:off x="5237989" y="7298389"/>
              <a:ext cx="640581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 rot="16200000">
              <a:off x="5095023" y="7052167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 rot="16200000">
              <a:off x="5190408" y="7052166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 rot="16200000">
              <a:off x="5288865" y="705235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1" name="그림 110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59230" y="8208063"/>
              <a:ext cx="2048256" cy="1676400"/>
            </a:xfrm>
            <a:prstGeom prst="rect">
              <a:avLst/>
            </a:prstGeom>
          </p:spPr>
        </p:pic>
        <p:pic>
          <p:nvPicPr>
            <p:cNvPr id="112" name="그림 111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9356" y="8208063"/>
              <a:ext cx="2048256" cy="1676400"/>
            </a:xfrm>
            <a:prstGeom prst="rect">
              <a:avLst/>
            </a:prstGeom>
          </p:spPr>
        </p:pic>
        <p:sp>
          <p:nvSpPr>
            <p:cNvPr id="113" name="TextBox 112"/>
            <p:cNvSpPr txBox="1"/>
            <p:nvPr/>
          </p:nvSpPr>
          <p:spPr>
            <a:xfrm rot="16200000">
              <a:off x="1262178" y="8690331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 rot="16200000">
              <a:off x="1157429" y="868796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 rot="16200000">
              <a:off x="1053553" y="8689886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직사각형 115"/>
            <p:cNvSpPr/>
            <p:nvPr/>
          </p:nvSpPr>
          <p:spPr>
            <a:xfrm>
              <a:off x="1205552" y="9000230"/>
              <a:ext cx="672730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2938765" y="8941459"/>
              <a:ext cx="420781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 rot="16200000">
              <a:off x="3393730" y="8693978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 rot="16200000">
              <a:off x="3288981" y="8691611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 rot="16200000">
              <a:off x="3185105" y="8693532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직사각형 120"/>
            <p:cNvSpPr/>
            <p:nvPr/>
          </p:nvSpPr>
          <p:spPr>
            <a:xfrm>
              <a:off x="3337104" y="9003877"/>
              <a:ext cx="651876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5013803" y="8941931"/>
              <a:ext cx="420781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 rot="16200000">
              <a:off x="5468768" y="8694450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 rot="16200000">
              <a:off x="5364018" y="8692083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 rot="16200000">
              <a:off x="5260143" y="869400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직사각형 125"/>
            <p:cNvSpPr/>
            <p:nvPr/>
          </p:nvSpPr>
          <p:spPr>
            <a:xfrm>
              <a:off x="5412142" y="9004349"/>
              <a:ext cx="671342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127" name="직사각형 126"/>
            <p:cNvSpPr/>
            <p:nvPr/>
          </p:nvSpPr>
          <p:spPr>
            <a:xfrm>
              <a:off x="1103481" y="10992194"/>
              <a:ext cx="654096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525466" y="10920907"/>
              <a:ext cx="593908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 rot="16200000">
              <a:off x="1281610" y="10735318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 rot="16200000">
              <a:off x="1390049" y="1073352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 rot="16200000">
              <a:off x="1492307" y="1073352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 rot="16200000">
              <a:off x="1180977" y="7007206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 rot="16200000">
              <a:off x="1276361" y="7007205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 rot="16200000">
              <a:off x="1374818" y="7007393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 rot="16200000">
              <a:off x="3303128" y="701157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 rot="16200000">
              <a:off x="3398514" y="7011573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 rot="16200000">
              <a:off x="3496971" y="7011761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 rot="16200000">
              <a:off x="5397392" y="7053271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 rot="16200000">
              <a:off x="5492778" y="7053270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 rot="16200000">
              <a:off x="5591235" y="7053457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 rot="16200000">
              <a:off x="1590947" y="8694450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 rot="16200000">
              <a:off x="1486198" y="8692083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 rot="16200000">
              <a:off x="1382322" y="869400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 rot="16200000">
              <a:off x="3722448" y="8694450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 rot="16200000">
              <a:off x="3617698" y="8692083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 rot="16200000">
              <a:off x="3513822" y="869400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 rot="16200000">
              <a:off x="5800134" y="8699287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 rot="16200000">
              <a:off x="5695385" y="8696920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 rot="16200000">
              <a:off x="5591509" y="8698841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50" name="그림 149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55792" y="9911828"/>
              <a:ext cx="2048256" cy="1676400"/>
            </a:xfrm>
            <a:prstGeom prst="rect">
              <a:avLst/>
            </a:prstGeom>
          </p:spPr>
        </p:pic>
        <p:pic>
          <p:nvPicPr>
            <p:cNvPr id="151" name="그림 150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72523" y="9915459"/>
              <a:ext cx="2048256" cy="1676400"/>
            </a:xfrm>
            <a:prstGeom prst="rect">
              <a:avLst/>
            </a:prstGeom>
          </p:spPr>
        </p:pic>
        <p:sp>
          <p:nvSpPr>
            <p:cNvPr id="152" name="TextBox 151"/>
            <p:cNvSpPr txBox="1"/>
            <p:nvPr/>
          </p:nvSpPr>
          <p:spPr>
            <a:xfrm rot="16200000">
              <a:off x="957912" y="10734480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 rot="16200000">
              <a:off x="1066351" y="10732686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 rot="16200000">
              <a:off x="1168609" y="10732686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직사각형 154"/>
            <p:cNvSpPr/>
            <p:nvPr/>
          </p:nvSpPr>
          <p:spPr>
            <a:xfrm>
              <a:off x="3242654" y="10992194"/>
              <a:ext cx="654096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2645073" y="10920907"/>
              <a:ext cx="613474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 rot="16200000">
              <a:off x="3420783" y="10735318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 rot="16200000">
              <a:off x="3529222" y="1073352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 rot="16200000">
              <a:off x="3631480" y="10733524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 rot="16200000">
              <a:off x="3097085" y="10734480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 rot="16200000">
              <a:off x="3205523" y="10732686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 rot="16200000">
              <a:off x="3307782" y="10732686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직사각형 162"/>
            <p:cNvSpPr/>
            <p:nvPr/>
          </p:nvSpPr>
          <p:spPr>
            <a:xfrm>
              <a:off x="5322188" y="10991315"/>
              <a:ext cx="654096" cy="833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600">
                <a:solidFill>
                  <a:schemeClr val="tx1"/>
                </a:solidFill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4691294" y="10920028"/>
              <a:ext cx="646787" cy="211965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 rot="16200000">
              <a:off x="5500318" y="10734439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 rot="16200000">
              <a:off x="5608756" y="10732645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TextBox 166"/>
            <p:cNvSpPr txBox="1"/>
            <p:nvPr/>
          </p:nvSpPr>
          <p:spPr>
            <a:xfrm rot="16200000">
              <a:off x="5711014" y="10732645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 rot="16200000">
              <a:off x="5176619" y="10733601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 rot="16200000">
              <a:off x="5285058" y="10731807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9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 rot="16200000">
              <a:off x="5387316" y="10731807"/>
              <a:ext cx="420781" cy="157300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3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3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2" name="직사각형 171"/>
          <p:cNvSpPr/>
          <p:nvPr/>
        </p:nvSpPr>
        <p:spPr>
          <a:xfrm>
            <a:off x="983375" y="4454556"/>
            <a:ext cx="4934207" cy="7389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S8.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he origina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of western blots of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1e. Th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red box indicated the representative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ands of protein levels in Figure 1e. Protein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HIF-1α and p53 in OSCC cell lines by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GAPDH was used as the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internal control. 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2245461" y="3963323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2327028" y="2519845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3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2407289" y="1257398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89014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직사각형 368"/>
          <p:cNvSpPr/>
          <p:nvPr/>
        </p:nvSpPr>
        <p:spPr>
          <a:xfrm>
            <a:off x="1177794" y="8238849"/>
            <a:ext cx="4507759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9.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origina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of western blots of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2a. Th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red box indicated the representative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ands of protein levels in Fig. 2a. Protein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HIF-1α, E-cad, Snail, Par3, TJP1 and </a:t>
            </a:r>
            <a:r>
              <a:rPr lang="en-US" altLang="ko-KR" sz="1000" kern="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in HSC-2 cell line under </a:t>
            </a:r>
            <a:r>
              <a:rPr lang="en-US" altLang="ko-KR" sz="1000" kern="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hypoxic conditions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GAPDH was used as the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internal control.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3" name="그룹 372"/>
          <p:cNvGrpSpPr/>
          <p:nvPr/>
        </p:nvGrpSpPr>
        <p:grpSpPr>
          <a:xfrm>
            <a:off x="1177796" y="109379"/>
            <a:ext cx="4509567" cy="8102738"/>
            <a:chOff x="1177796" y="184329"/>
            <a:chExt cx="4509567" cy="8102738"/>
          </a:xfrm>
        </p:grpSpPr>
        <p:grpSp>
          <p:nvGrpSpPr>
            <p:cNvPr id="368" name="그룹 367"/>
            <p:cNvGrpSpPr/>
            <p:nvPr/>
          </p:nvGrpSpPr>
          <p:grpSpPr>
            <a:xfrm>
              <a:off x="1177796" y="403067"/>
              <a:ext cx="4509567" cy="7884000"/>
              <a:chOff x="902030" y="371247"/>
              <a:chExt cx="4509567" cy="7884000"/>
            </a:xfrm>
          </p:grpSpPr>
          <p:pic>
            <p:nvPicPr>
              <p:cNvPr id="187" name="그림 186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5151" y="1512204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188" name="그림 187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54508" y="371247"/>
                <a:ext cx="1356249" cy="1110033"/>
              </a:xfrm>
              <a:prstGeom prst="rect">
                <a:avLst/>
              </a:prstGeom>
            </p:spPr>
          </p:pic>
          <p:pic>
            <p:nvPicPr>
              <p:cNvPr id="189" name="그림 188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3282" y="381466"/>
                <a:ext cx="1355279" cy="1109239"/>
              </a:xfrm>
              <a:prstGeom prst="rect">
                <a:avLst/>
              </a:prstGeom>
            </p:spPr>
          </p:pic>
          <p:sp>
            <p:nvSpPr>
              <p:cNvPr id="190" name="TextBox 189"/>
              <p:cNvSpPr txBox="1"/>
              <p:nvPr/>
            </p:nvSpPr>
            <p:spPr>
              <a:xfrm rot="16200000">
                <a:off x="636093" y="820670"/>
                <a:ext cx="1109239" cy="230832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F-1</a:t>
                </a:r>
                <a:r>
                  <a:rPr lang="el-GR" altLang="ko-K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ko-KR" altLang="en-US" sz="900" b="1" dirty="0"/>
              </a:p>
            </p:txBody>
          </p:sp>
          <p:sp>
            <p:nvSpPr>
              <p:cNvPr id="191" name="TextBox 190"/>
              <p:cNvSpPr txBox="1"/>
              <p:nvPr/>
            </p:nvSpPr>
            <p:spPr>
              <a:xfrm rot="16200000">
                <a:off x="633885" y="1953320"/>
                <a:ext cx="110923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-cad</a:t>
                </a:r>
                <a:endParaRPr lang="ko-KR" altLang="en-US" sz="900" b="1" dirty="0"/>
              </a:p>
            </p:txBody>
          </p:sp>
          <p:sp>
            <p:nvSpPr>
              <p:cNvPr id="192" name="TextBox 191"/>
              <p:cNvSpPr txBox="1"/>
              <p:nvPr/>
            </p:nvSpPr>
            <p:spPr>
              <a:xfrm rot="16200000">
                <a:off x="-2907009" y="4190502"/>
                <a:ext cx="784891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SC2</a:t>
                </a:r>
                <a:endParaRPr lang="ko-KR" altLang="en-US" sz="900" b="1" dirty="0"/>
              </a:p>
            </p:txBody>
          </p:sp>
          <p:cxnSp>
            <p:nvCxnSpPr>
              <p:cNvPr id="193" name="직선 연결선 192"/>
              <p:cNvCxnSpPr/>
              <p:nvPr/>
            </p:nvCxnSpPr>
            <p:spPr>
              <a:xfrm flipH="1">
                <a:off x="1091286" y="393445"/>
                <a:ext cx="4035" cy="783692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4" name="직사각형 193"/>
              <p:cNvSpPr/>
              <p:nvPr/>
            </p:nvSpPr>
            <p:spPr>
              <a:xfrm>
                <a:off x="1752444" y="1988768"/>
                <a:ext cx="154938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95" name="TextBox 194"/>
              <p:cNvSpPr txBox="1"/>
              <p:nvPr/>
            </p:nvSpPr>
            <p:spPr>
              <a:xfrm>
                <a:off x="1275618" y="1941616"/>
                <a:ext cx="351543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-cad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96" name="그림 195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5151" y="381466"/>
                <a:ext cx="1355279" cy="1109239"/>
              </a:xfrm>
              <a:prstGeom prst="rect">
                <a:avLst/>
              </a:prstGeom>
            </p:spPr>
          </p:pic>
          <p:sp>
            <p:nvSpPr>
              <p:cNvPr id="197" name="TextBox 196"/>
              <p:cNvSpPr txBox="1"/>
              <p:nvPr/>
            </p:nvSpPr>
            <p:spPr>
              <a:xfrm>
                <a:off x="1479396" y="777261"/>
                <a:ext cx="326284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8" name="TextBox 197"/>
              <p:cNvSpPr txBox="1"/>
              <p:nvPr/>
            </p:nvSpPr>
            <p:spPr>
              <a:xfrm>
                <a:off x="1431624" y="832547"/>
                <a:ext cx="369709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IF-1</a:t>
                </a:r>
                <a:r>
                  <a:rPr lang="el-GR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9" name="TextBox 198"/>
              <p:cNvSpPr txBox="1"/>
              <p:nvPr/>
            </p:nvSpPr>
            <p:spPr>
              <a:xfrm>
                <a:off x="1927527" y="77309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0" name="TextBox 199"/>
              <p:cNvSpPr txBox="1"/>
              <p:nvPr/>
            </p:nvSpPr>
            <p:spPr>
              <a:xfrm>
                <a:off x="2008128" y="77651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1" name="직사각형 200"/>
              <p:cNvSpPr/>
              <p:nvPr/>
            </p:nvSpPr>
            <p:spPr>
              <a:xfrm>
                <a:off x="1790398" y="883997"/>
                <a:ext cx="286976" cy="5370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02" name="TextBox 201"/>
              <p:cNvSpPr txBox="1"/>
              <p:nvPr/>
            </p:nvSpPr>
            <p:spPr>
              <a:xfrm>
                <a:off x="2851406" y="776085"/>
                <a:ext cx="367519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3" name="TextBox 202"/>
              <p:cNvSpPr txBox="1"/>
              <p:nvPr/>
            </p:nvSpPr>
            <p:spPr>
              <a:xfrm>
                <a:off x="2851406" y="832365"/>
                <a:ext cx="366236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F-1</a:t>
                </a:r>
                <a:r>
                  <a:rPr lang="el-GR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4" name="TextBox 203"/>
              <p:cNvSpPr txBox="1"/>
              <p:nvPr/>
            </p:nvSpPr>
            <p:spPr>
              <a:xfrm>
                <a:off x="3340772" y="77191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5" name="TextBox 204"/>
              <p:cNvSpPr txBox="1"/>
              <p:nvPr/>
            </p:nvSpPr>
            <p:spPr>
              <a:xfrm>
                <a:off x="3421373" y="775343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6" name="직사각형 205"/>
              <p:cNvSpPr/>
              <p:nvPr/>
            </p:nvSpPr>
            <p:spPr>
              <a:xfrm>
                <a:off x="3197822" y="882822"/>
                <a:ext cx="292797" cy="5370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4150408" y="766640"/>
                <a:ext cx="447228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4206685" y="823891"/>
                <a:ext cx="383862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IF-1</a:t>
                </a:r>
                <a:r>
                  <a:rPr lang="el-GR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>
                <a:off x="4719483" y="76247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4800083" y="76589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직사각형 210"/>
              <p:cNvSpPr/>
              <p:nvPr/>
            </p:nvSpPr>
            <p:spPr>
              <a:xfrm>
                <a:off x="4569073" y="873376"/>
                <a:ext cx="300257" cy="53706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pic>
            <p:nvPicPr>
              <p:cNvPr id="212" name="그림 211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2575" y="1509431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13" name="그림 212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54508" y="1509431"/>
                <a:ext cx="1355279" cy="1109239"/>
              </a:xfrm>
              <a:prstGeom prst="rect">
                <a:avLst/>
              </a:prstGeom>
            </p:spPr>
          </p:pic>
          <p:sp>
            <p:nvSpPr>
              <p:cNvPr id="214" name="TextBox 213"/>
              <p:cNvSpPr txBox="1"/>
              <p:nvPr/>
            </p:nvSpPr>
            <p:spPr>
              <a:xfrm>
                <a:off x="1293935" y="1876819"/>
                <a:ext cx="334908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1755732" y="187265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1826249" y="187607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직사각형 216"/>
              <p:cNvSpPr/>
              <p:nvPr/>
            </p:nvSpPr>
            <p:spPr>
              <a:xfrm>
                <a:off x="3158165" y="1985311"/>
                <a:ext cx="154938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2701331" y="1938159"/>
                <a:ext cx="331551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-cad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2667776" y="1873363"/>
                <a:ext cx="366788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3161453" y="1869196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3231970" y="1872621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직사각형 221"/>
              <p:cNvSpPr/>
              <p:nvPr/>
            </p:nvSpPr>
            <p:spPr>
              <a:xfrm>
                <a:off x="4539113" y="1981854"/>
                <a:ext cx="154938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4026865" y="1934703"/>
                <a:ext cx="386964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-cad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4" name="TextBox 223"/>
              <p:cNvSpPr txBox="1"/>
              <p:nvPr/>
            </p:nvSpPr>
            <p:spPr>
              <a:xfrm>
                <a:off x="3919558" y="1869906"/>
                <a:ext cx="495954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4542401" y="186573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6" name="TextBox 225"/>
              <p:cNvSpPr txBox="1"/>
              <p:nvPr/>
            </p:nvSpPr>
            <p:spPr>
              <a:xfrm>
                <a:off x="4612917" y="1869165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27" name="그림 226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5151" y="2642942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28" name="그림 227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2575" y="2643364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29" name="그림 228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56318" y="2642942"/>
                <a:ext cx="1355279" cy="1109239"/>
              </a:xfrm>
              <a:prstGeom prst="rect">
                <a:avLst/>
              </a:prstGeom>
            </p:spPr>
          </p:pic>
          <p:sp>
            <p:nvSpPr>
              <p:cNvPr id="230" name="TextBox 229"/>
              <p:cNvSpPr txBox="1"/>
              <p:nvPr/>
            </p:nvSpPr>
            <p:spPr>
              <a:xfrm rot="16200000">
                <a:off x="625617" y="3082146"/>
                <a:ext cx="11092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nail</a:t>
                </a:r>
                <a:endParaRPr lang="ko-KR" altLang="en-US" sz="900" b="1" dirty="0"/>
              </a:p>
            </p:txBody>
          </p:sp>
          <p:sp>
            <p:nvSpPr>
              <p:cNvPr id="231" name="TextBox 230"/>
              <p:cNvSpPr txBox="1"/>
              <p:nvPr/>
            </p:nvSpPr>
            <p:spPr>
              <a:xfrm>
                <a:off x="1355589" y="3112015"/>
                <a:ext cx="370267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nail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2" name="TextBox 231"/>
              <p:cNvSpPr txBox="1"/>
              <p:nvPr/>
            </p:nvSpPr>
            <p:spPr>
              <a:xfrm>
                <a:off x="1395291" y="3029686"/>
                <a:ext cx="327111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3" name="TextBox 232"/>
              <p:cNvSpPr txBox="1"/>
              <p:nvPr/>
            </p:nvSpPr>
            <p:spPr>
              <a:xfrm>
                <a:off x="1717121" y="3029686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4" name="TextBox 233"/>
              <p:cNvSpPr txBox="1"/>
              <p:nvPr/>
            </p:nvSpPr>
            <p:spPr>
              <a:xfrm>
                <a:off x="1790398" y="303341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5" name="직사각형 234"/>
              <p:cNvSpPr/>
              <p:nvPr/>
            </p:nvSpPr>
            <p:spPr>
              <a:xfrm>
                <a:off x="1712929" y="3148422"/>
                <a:ext cx="282612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36" name="TextBox 235"/>
              <p:cNvSpPr txBox="1"/>
              <p:nvPr/>
            </p:nvSpPr>
            <p:spPr>
              <a:xfrm>
                <a:off x="2745733" y="3112015"/>
                <a:ext cx="387547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nail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7" name="TextBox 236"/>
              <p:cNvSpPr txBox="1"/>
              <p:nvPr/>
            </p:nvSpPr>
            <p:spPr>
              <a:xfrm>
                <a:off x="2756574" y="3029686"/>
                <a:ext cx="373252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8" name="TextBox 237"/>
              <p:cNvSpPr txBox="1"/>
              <p:nvPr/>
            </p:nvSpPr>
            <p:spPr>
              <a:xfrm>
                <a:off x="3124545" y="3029686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9" name="TextBox 238"/>
              <p:cNvSpPr txBox="1"/>
              <p:nvPr/>
            </p:nvSpPr>
            <p:spPr>
              <a:xfrm>
                <a:off x="3197822" y="303341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직사각형 239"/>
              <p:cNvSpPr/>
              <p:nvPr/>
            </p:nvSpPr>
            <p:spPr>
              <a:xfrm>
                <a:off x="3120353" y="3148422"/>
                <a:ext cx="296754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41" name="TextBox 240"/>
              <p:cNvSpPr txBox="1"/>
              <p:nvPr/>
            </p:nvSpPr>
            <p:spPr>
              <a:xfrm>
                <a:off x="4150408" y="3114673"/>
                <a:ext cx="366862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nail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2" name="TextBox 241"/>
              <p:cNvSpPr txBox="1"/>
              <p:nvPr/>
            </p:nvSpPr>
            <p:spPr>
              <a:xfrm>
                <a:off x="4087790" y="3032344"/>
                <a:ext cx="426026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3" name="TextBox 242"/>
              <p:cNvSpPr txBox="1"/>
              <p:nvPr/>
            </p:nvSpPr>
            <p:spPr>
              <a:xfrm>
                <a:off x="4508534" y="303234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4" name="TextBox 243"/>
              <p:cNvSpPr txBox="1"/>
              <p:nvPr/>
            </p:nvSpPr>
            <p:spPr>
              <a:xfrm>
                <a:off x="4581811" y="3036076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5" name="직사각형 244"/>
              <p:cNvSpPr/>
              <p:nvPr/>
            </p:nvSpPr>
            <p:spPr>
              <a:xfrm>
                <a:off x="4504343" y="3151080"/>
                <a:ext cx="295741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pic>
            <p:nvPicPr>
              <p:cNvPr id="246" name="그림 245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1586" y="3771768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47" name="그림 246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54508" y="3771768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48" name="그림 247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5151" y="3771768"/>
                <a:ext cx="1355279" cy="1109239"/>
              </a:xfrm>
              <a:prstGeom prst="rect">
                <a:avLst/>
              </a:prstGeom>
            </p:spPr>
          </p:pic>
          <p:sp>
            <p:nvSpPr>
              <p:cNvPr id="249" name="TextBox 248"/>
              <p:cNvSpPr txBox="1"/>
              <p:nvPr/>
            </p:nvSpPr>
            <p:spPr>
              <a:xfrm>
                <a:off x="1395291" y="4243993"/>
                <a:ext cx="357153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ar3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0" name="직사각형 249"/>
              <p:cNvSpPr/>
              <p:nvPr/>
            </p:nvSpPr>
            <p:spPr>
              <a:xfrm>
                <a:off x="1729945" y="4305167"/>
                <a:ext cx="293623" cy="4680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51" name="TextBox 250"/>
              <p:cNvSpPr txBox="1"/>
              <p:nvPr/>
            </p:nvSpPr>
            <p:spPr>
              <a:xfrm>
                <a:off x="1395291" y="4184950"/>
                <a:ext cx="357153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2" name="TextBox 251"/>
              <p:cNvSpPr txBox="1"/>
              <p:nvPr/>
            </p:nvSpPr>
            <p:spPr>
              <a:xfrm>
                <a:off x="1737577" y="4188016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TextBox 252"/>
              <p:cNvSpPr txBox="1"/>
              <p:nvPr/>
            </p:nvSpPr>
            <p:spPr>
              <a:xfrm>
                <a:off x="1804455" y="4191090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TextBox 253"/>
              <p:cNvSpPr txBox="1"/>
              <p:nvPr/>
            </p:nvSpPr>
            <p:spPr>
              <a:xfrm>
                <a:off x="2761190" y="4242002"/>
                <a:ext cx="401212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r3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5" name="직사각형 254"/>
              <p:cNvSpPr/>
              <p:nvPr/>
            </p:nvSpPr>
            <p:spPr>
              <a:xfrm>
                <a:off x="3139904" y="4303176"/>
                <a:ext cx="290630" cy="4680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56" name="TextBox 255"/>
              <p:cNvSpPr txBox="1"/>
              <p:nvPr/>
            </p:nvSpPr>
            <p:spPr>
              <a:xfrm>
                <a:off x="2808421" y="4182960"/>
                <a:ext cx="353981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7" name="TextBox 256"/>
              <p:cNvSpPr txBox="1"/>
              <p:nvPr/>
            </p:nvSpPr>
            <p:spPr>
              <a:xfrm>
                <a:off x="3145740" y="4186025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TextBox 257"/>
              <p:cNvSpPr txBox="1"/>
              <p:nvPr/>
            </p:nvSpPr>
            <p:spPr>
              <a:xfrm>
                <a:off x="3212618" y="418909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9" name="TextBox 258"/>
              <p:cNvSpPr txBox="1"/>
              <p:nvPr/>
            </p:nvSpPr>
            <p:spPr>
              <a:xfrm>
                <a:off x="4002614" y="4238928"/>
                <a:ext cx="546758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r3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직사각형 259"/>
              <p:cNvSpPr/>
              <p:nvPr/>
            </p:nvSpPr>
            <p:spPr>
              <a:xfrm>
                <a:off x="4526873" y="4300103"/>
                <a:ext cx="291325" cy="4680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61" name="TextBox 260"/>
              <p:cNvSpPr txBox="1"/>
              <p:nvPr/>
            </p:nvSpPr>
            <p:spPr>
              <a:xfrm>
                <a:off x="4067216" y="4179886"/>
                <a:ext cx="482156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2" name="TextBox 261"/>
              <p:cNvSpPr txBox="1"/>
              <p:nvPr/>
            </p:nvSpPr>
            <p:spPr>
              <a:xfrm>
                <a:off x="4527325" y="418295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3" name="TextBox 262"/>
              <p:cNvSpPr txBox="1"/>
              <p:nvPr/>
            </p:nvSpPr>
            <p:spPr>
              <a:xfrm>
                <a:off x="4594203" y="4186025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4" name="TextBox 263"/>
              <p:cNvSpPr txBox="1"/>
              <p:nvPr/>
            </p:nvSpPr>
            <p:spPr>
              <a:xfrm rot="16200000">
                <a:off x="624709" y="4210971"/>
                <a:ext cx="11092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r3</a:t>
                </a:r>
                <a:endParaRPr lang="ko-KR" altLang="en-US" sz="900" b="1" dirty="0"/>
              </a:p>
            </p:txBody>
          </p:sp>
          <p:pic>
            <p:nvPicPr>
              <p:cNvPr id="265" name="그림 264"/>
              <p:cNvPicPr>
                <a:picLocks noChangeAspect="1"/>
              </p:cNvPicPr>
              <p:nvPr/>
            </p:nvPicPr>
            <p:blipFill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5151" y="4900592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66" name="그림 265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1586" y="4899733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67" name="그림 266"/>
              <p:cNvPicPr>
                <a:picLocks noChangeAspect="1"/>
              </p:cNvPicPr>
              <p:nvPr/>
            </p:nvPicPr>
            <p:blipFill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54508" y="4899733"/>
                <a:ext cx="1355279" cy="1109239"/>
              </a:xfrm>
              <a:prstGeom prst="rect">
                <a:avLst/>
              </a:prstGeom>
            </p:spPr>
          </p:pic>
          <p:sp>
            <p:nvSpPr>
              <p:cNvPr id="268" name="TextBox 267"/>
              <p:cNvSpPr txBox="1"/>
              <p:nvPr/>
            </p:nvSpPr>
            <p:spPr>
              <a:xfrm rot="16200000">
                <a:off x="623899" y="5338937"/>
                <a:ext cx="11092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JP1</a:t>
                </a:r>
                <a:endParaRPr lang="ko-KR" altLang="en-US" sz="900" b="1" dirty="0"/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>
                <a:off x="1260554" y="5354518"/>
                <a:ext cx="349686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JP1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0" name="직사각형 269"/>
              <p:cNvSpPr/>
              <p:nvPr/>
            </p:nvSpPr>
            <p:spPr>
              <a:xfrm>
                <a:off x="1880791" y="5412330"/>
                <a:ext cx="298856" cy="64537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71" name="TextBox 270"/>
              <p:cNvSpPr txBox="1"/>
              <p:nvPr/>
            </p:nvSpPr>
            <p:spPr>
              <a:xfrm>
                <a:off x="1235216" y="5256264"/>
                <a:ext cx="37782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TextBox 271"/>
              <p:cNvSpPr txBox="1"/>
              <p:nvPr/>
            </p:nvSpPr>
            <p:spPr>
              <a:xfrm>
                <a:off x="2026739" y="525932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3" name="TextBox 272"/>
              <p:cNvSpPr txBox="1"/>
              <p:nvPr/>
            </p:nvSpPr>
            <p:spPr>
              <a:xfrm>
                <a:off x="2102019" y="526240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TextBox 273"/>
              <p:cNvSpPr txBox="1"/>
              <p:nvPr/>
            </p:nvSpPr>
            <p:spPr>
              <a:xfrm>
                <a:off x="2639346" y="5352373"/>
                <a:ext cx="376719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JP1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직사각형 274"/>
              <p:cNvSpPr/>
              <p:nvPr/>
            </p:nvSpPr>
            <p:spPr>
              <a:xfrm>
                <a:off x="3288954" y="5413547"/>
                <a:ext cx="296518" cy="6331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76" name="TextBox 275"/>
              <p:cNvSpPr txBox="1"/>
              <p:nvPr/>
            </p:nvSpPr>
            <p:spPr>
              <a:xfrm>
                <a:off x="2643943" y="5254118"/>
                <a:ext cx="374922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7" name="TextBox 276"/>
              <p:cNvSpPr txBox="1"/>
              <p:nvPr/>
            </p:nvSpPr>
            <p:spPr>
              <a:xfrm>
                <a:off x="3432564" y="525718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TextBox 277"/>
              <p:cNvSpPr txBox="1"/>
              <p:nvPr/>
            </p:nvSpPr>
            <p:spPr>
              <a:xfrm>
                <a:off x="3507844" y="526025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TextBox 278"/>
              <p:cNvSpPr txBox="1"/>
              <p:nvPr/>
            </p:nvSpPr>
            <p:spPr>
              <a:xfrm>
                <a:off x="3997877" y="5352373"/>
                <a:ext cx="398697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JP1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직사각형 279"/>
              <p:cNvSpPr/>
              <p:nvPr/>
            </p:nvSpPr>
            <p:spPr>
              <a:xfrm>
                <a:off x="4677311" y="5413547"/>
                <a:ext cx="295442" cy="6331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81" name="TextBox 280"/>
              <p:cNvSpPr txBox="1"/>
              <p:nvPr/>
            </p:nvSpPr>
            <p:spPr>
              <a:xfrm>
                <a:off x="4026865" y="5254118"/>
                <a:ext cx="372510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TextBox 281"/>
              <p:cNvSpPr txBox="1"/>
              <p:nvPr/>
            </p:nvSpPr>
            <p:spPr>
              <a:xfrm>
                <a:off x="4813073" y="525718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TextBox 282"/>
              <p:cNvSpPr txBox="1"/>
              <p:nvPr/>
            </p:nvSpPr>
            <p:spPr>
              <a:xfrm>
                <a:off x="4891821" y="526025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84" name="그림 283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5151" y="6025347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85" name="그림 284"/>
              <p:cNvPicPr>
                <a:picLocks noChangeAspect="1"/>
              </p:cNvPicPr>
              <p:nvPr/>
            </p:nvPicPr>
            <p:blipFill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1586" y="6023896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286" name="그림 285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54508" y="6023896"/>
                <a:ext cx="1355279" cy="1109239"/>
              </a:xfrm>
              <a:prstGeom prst="rect">
                <a:avLst/>
              </a:prstGeom>
            </p:spPr>
          </p:pic>
          <p:sp>
            <p:nvSpPr>
              <p:cNvPr id="287" name="TextBox 286"/>
              <p:cNvSpPr txBox="1"/>
              <p:nvPr/>
            </p:nvSpPr>
            <p:spPr>
              <a:xfrm rot="16200000">
                <a:off x="629659" y="6464552"/>
                <a:ext cx="11092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laudin</a:t>
                </a:r>
                <a:endParaRPr lang="ko-KR" altLang="en-US" sz="900" b="1" dirty="0"/>
              </a:p>
            </p:txBody>
          </p:sp>
          <p:sp>
            <p:nvSpPr>
              <p:cNvPr id="288" name="TextBox 287"/>
              <p:cNvSpPr txBox="1"/>
              <p:nvPr/>
            </p:nvSpPr>
            <p:spPr>
              <a:xfrm>
                <a:off x="1447993" y="6345150"/>
                <a:ext cx="379809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TextBox 288"/>
              <p:cNvSpPr txBox="1"/>
              <p:nvPr/>
            </p:nvSpPr>
            <p:spPr>
              <a:xfrm>
                <a:off x="1379285" y="6472408"/>
                <a:ext cx="448808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laudin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TextBox 289"/>
              <p:cNvSpPr txBox="1"/>
              <p:nvPr/>
            </p:nvSpPr>
            <p:spPr>
              <a:xfrm>
                <a:off x="1963246" y="634732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TextBox 290"/>
              <p:cNvSpPr txBox="1"/>
              <p:nvPr/>
            </p:nvSpPr>
            <p:spPr>
              <a:xfrm>
                <a:off x="2029109" y="6350481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직사각형 291"/>
              <p:cNvSpPr/>
              <p:nvPr/>
            </p:nvSpPr>
            <p:spPr>
              <a:xfrm>
                <a:off x="1826249" y="6515783"/>
                <a:ext cx="280497" cy="6203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93" name="TextBox 292"/>
              <p:cNvSpPr txBox="1"/>
              <p:nvPr/>
            </p:nvSpPr>
            <p:spPr>
              <a:xfrm>
                <a:off x="2851406" y="6345150"/>
                <a:ext cx="382752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TextBox 293"/>
              <p:cNvSpPr txBox="1"/>
              <p:nvPr/>
            </p:nvSpPr>
            <p:spPr>
              <a:xfrm>
                <a:off x="2778751" y="6472408"/>
                <a:ext cx="455699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laudin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5" name="TextBox 294"/>
              <p:cNvSpPr txBox="1"/>
              <p:nvPr/>
            </p:nvSpPr>
            <p:spPr>
              <a:xfrm>
                <a:off x="3369603" y="634732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TextBox 295"/>
              <p:cNvSpPr txBox="1"/>
              <p:nvPr/>
            </p:nvSpPr>
            <p:spPr>
              <a:xfrm>
                <a:off x="3435465" y="6350481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7" name="직사각형 296"/>
              <p:cNvSpPr/>
              <p:nvPr/>
            </p:nvSpPr>
            <p:spPr>
              <a:xfrm>
                <a:off x="3222076" y="6515783"/>
                <a:ext cx="291026" cy="62039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298" name="TextBox 297"/>
              <p:cNvSpPr txBox="1"/>
              <p:nvPr/>
            </p:nvSpPr>
            <p:spPr>
              <a:xfrm>
                <a:off x="4093963" y="6345150"/>
                <a:ext cx="522929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9" name="TextBox 298"/>
              <p:cNvSpPr txBox="1"/>
              <p:nvPr/>
            </p:nvSpPr>
            <p:spPr>
              <a:xfrm>
                <a:off x="4134030" y="6472408"/>
                <a:ext cx="483153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Claudin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TextBox 299"/>
              <p:cNvSpPr txBox="1"/>
              <p:nvPr/>
            </p:nvSpPr>
            <p:spPr>
              <a:xfrm>
                <a:off x="4752336" y="634732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1" name="TextBox 300"/>
              <p:cNvSpPr txBox="1"/>
              <p:nvPr/>
            </p:nvSpPr>
            <p:spPr>
              <a:xfrm>
                <a:off x="4818199" y="6350481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2" name="직사각형 301"/>
              <p:cNvSpPr/>
              <p:nvPr/>
            </p:nvSpPr>
            <p:spPr>
              <a:xfrm>
                <a:off x="4612917" y="6522797"/>
                <a:ext cx="282918" cy="5502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pic>
            <p:nvPicPr>
              <p:cNvPr id="303" name="그림 302"/>
              <p:cNvPicPr>
                <a:picLocks noChangeAspect="1"/>
              </p:cNvPicPr>
              <p:nvPr/>
            </p:nvPicPr>
            <p:blipFill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673454" y="7146007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304" name="그림 303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54508" y="7146006"/>
                <a:ext cx="1355279" cy="1109239"/>
              </a:xfrm>
              <a:prstGeom prst="rect">
                <a:avLst/>
              </a:prstGeom>
            </p:spPr>
          </p:pic>
          <p:pic>
            <p:nvPicPr>
              <p:cNvPr id="305" name="그림 304"/>
              <p:cNvPicPr>
                <a:picLocks noChangeAspect="1"/>
              </p:cNvPicPr>
              <p:nvPr/>
            </p:nvPicPr>
            <p:blipFill>
              <a:blip r:embed="rId2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265151" y="7146007"/>
                <a:ext cx="1355279" cy="1109239"/>
              </a:xfrm>
              <a:prstGeom prst="rect">
                <a:avLst/>
              </a:prstGeom>
            </p:spPr>
          </p:pic>
          <p:sp>
            <p:nvSpPr>
              <p:cNvPr id="306" name="TextBox 305"/>
              <p:cNvSpPr txBox="1"/>
              <p:nvPr/>
            </p:nvSpPr>
            <p:spPr>
              <a:xfrm rot="16200000">
                <a:off x="628913" y="7585211"/>
                <a:ext cx="1109240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ko-KR" altLang="en-US" sz="900" b="1" dirty="0"/>
              </a:p>
            </p:txBody>
          </p:sp>
          <p:sp>
            <p:nvSpPr>
              <p:cNvPr id="307" name="TextBox 306"/>
              <p:cNvSpPr txBox="1"/>
              <p:nvPr/>
            </p:nvSpPr>
            <p:spPr>
              <a:xfrm>
                <a:off x="1162374" y="7660753"/>
                <a:ext cx="455867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TextBox 307"/>
              <p:cNvSpPr txBox="1"/>
              <p:nvPr/>
            </p:nvSpPr>
            <p:spPr>
              <a:xfrm>
                <a:off x="1241638" y="7588913"/>
                <a:ext cx="374839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9" name="TextBox 308"/>
              <p:cNvSpPr txBox="1"/>
              <p:nvPr/>
            </p:nvSpPr>
            <p:spPr>
              <a:xfrm>
                <a:off x="1594946" y="7595030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0" name="TextBox 309"/>
              <p:cNvSpPr txBox="1"/>
              <p:nvPr/>
            </p:nvSpPr>
            <p:spPr>
              <a:xfrm>
                <a:off x="1667250" y="7601146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1" name="직사각형 310"/>
              <p:cNvSpPr/>
              <p:nvPr/>
            </p:nvSpPr>
            <p:spPr>
              <a:xfrm>
                <a:off x="1591233" y="7713511"/>
                <a:ext cx="299315" cy="5332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12" name="TextBox 311"/>
              <p:cNvSpPr txBox="1"/>
              <p:nvPr/>
            </p:nvSpPr>
            <p:spPr>
              <a:xfrm>
                <a:off x="2584014" y="7658846"/>
                <a:ext cx="441904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3" name="TextBox 312"/>
              <p:cNvSpPr txBox="1"/>
              <p:nvPr/>
            </p:nvSpPr>
            <p:spPr>
              <a:xfrm>
                <a:off x="2643943" y="7587006"/>
                <a:ext cx="380210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TextBox 313"/>
              <p:cNvSpPr txBox="1"/>
              <p:nvPr/>
            </p:nvSpPr>
            <p:spPr>
              <a:xfrm>
                <a:off x="3002623" y="759312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5" name="TextBox 314"/>
              <p:cNvSpPr txBox="1"/>
              <p:nvPr/>
            </p:nvSpPr>
            <p:spPr>
              <a:xfrm>
                <a:off x="3074926" y="759923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6" name="직사각형 315"/>
              <p:cNvSpPr/>
              <p:nvPr/>
            </p:nvSpPr>
            <p:spPr>
              <a:xfrm>
                <a:off x="2998909" y="7713179"/>
                <a:ext cx="303596" cy="5332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317" name="TextBox 316"/>
              <p:cNvSpPr txBox="1"/>
              <p:nvPr/>
            </p:nvSpPr>
            <p:spPr>
              <a:xfrm>
                <a:off x="3923668" y="7659521"/>
                <a:ext cx="479598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8" name="TextBox 317"/>
              <p:cNvSpPr txBox="1"/>
              <p:nvPr/>
            </p:nvSpPr>
            <p:spPr>
              <a:xfrm>
                <a:off x="3919558" y="7587681"/>
                <a:ext cx="481944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r"/>
                <a:r>
                  <a:rPr lang="en-US" altLang="ko-KR" sz="4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: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9" name="TextBox 318"/>
              <p:cNvSpPr txBox="1"/>
              <p:nvPr/>
            </p:nvSpPr>
            <p:spPr>
              <a:xfrm>
                <a:off x="4379972" y="759379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0" name="TextBox 319"/>
              <p:cNvSpPr txBox="1"/>
              <p:nvPr/>
            </p:nvSpPr>
            <p:spPr>
              <a:xfrm>
                <a:off x="4452275" y="759991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1" name="직사각형 320"/>
              <p:cNvSpPr/>
              <p:nvPr/>
            </p:nvSpPr>
            <p:spPr>
              <a:xfrm>
                <a:off x="4376258" y="7715429"/>
                <a:ext cx="312934" cy="53325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322" name="TextBox 321"/>
              <p:cNvSpPr txBox="1"/>
              <p:nvPr/>
            </p:nvSpPr>
            <p:spPr>
              <a:xfrm>
                <a:off x="1785376" y="773940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3" name="TextBox 322"/>
              <p:cNvSpPr txBox="1"/>
              <p:nvPr/>
            </p:nvSpPr>
            <p:spPr>
              <a:xfrm>
                <a:off x="1865977" y="777365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4" name="TextBox 323"/>
              <p:cNvSpPr txBox="1"/>
              <p:nvPr/>
            </p:nvSpPr>
            <p:spPr>
              <a:xfrm>
                <a:off x="3184985" y="77211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TextBox 324"/>
              <p:cNvSpPr txBox="1"/>
              <p:nvPr/>
            </p:nvSpPr>
            <p:spPr>
              <a:xfrm>
                <a:off x="3265586" y="775543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TextBox 325"/>
              <p:cNvSpPr txBox="1"/>
              <p:nvPr/>
            </p:nvSpPr>
            <p:spPr>
              <a:xfrm>
                <a:off x="4569073" y="76248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7" name="TextBox 326"/>
              <p:cNvSpPr txBox="1"/>
              <p:nvPr/>
            </p:nvSpPr>
            <p:spPr>
              <a:xfrm>
                <a:off x="4649673" y="76590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TextBox 327"/>
              <p:cNvSpPr txBox="1"/>
              <p:nvPr/>
            </p:nvSpPr>
            <p:spPr>
              <a:xfrm>
                <a:off x="2033754" y="187351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9" name="TextBox 328"/>
              <p:cNvSpPr txBox="1"/>
              <p:nvPr/>
            </p:nvSpPr>
            <p:spPr>
              <a:xfrm>
                <a:off x="2104270" y="187693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0" name="직사각형 329"/>
              <p:cNvSpPr/>
              <p:nvPr/>
            </p:nvSpPr>
            <p:spPr>
              <a:xfrm>
                <a:off x="2029109" y="1990410"/>
                <a:ext cx="154938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31" name="직사각형 330"/>
              <p:cNvSpPr/>
              <p:nvPr/>
            </p:nvSpPr>
            <p:spPr>
              <a:xfrm>
                <a:off x="3435231" y="1985311"/>
                <a:ext cx="154938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332" name="TextBox 331"/>
              <p:cNvSpPr txBox="1"/>
              <p:nvPr/>
            </p:nvSpPr>
            <p:spPr>
              <a:xfrm>
                <a:off x="3438519" y="1869196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3" name="TextBox 332"/>
              <p:cNvSpPr txBox="1"/>
              <p:nvPr/>
            </p:nvSpPr>
            <p:spPr>
              <a:xfrm>
                <a:off x="3509035" y="1872621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4" name="직사각형 333"/>
              <p:cNvSpPr/>
              <p:nvPr/>
            </p:nvSpPr>
            <p:spPr>
              <a:xfrm>
                <a:off x="4818533" y="1982727"/>
                <a:ext cx="154938" cy="77248"/>
              </a:xfrm>
              <a:prstGeom prst="rect">
                <a:avLst/>
              </a:prstGeom>
              <a:noFill/>
              <a:ln>
                <a:solidFill>
                  <a:srgbClr val="FF0000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>
                  <a:solidFill>
                    <a:schemeClr val="tx1"/>
                  </a:solidFill>
                </a:endParaRPr>
              </a:p>
            </p:txBody>
          </p:sp>
          <p:sp>
            <p:nvSpPr>
              <p:cNvPr id="335" name="TextBox 334"/>
              <p:cNvSpPr txBox="1"/>
              <p:nvPr/>
            </p:nvSpPr>
            <p:spPr>
              <a:xfrm>
                <a:off x="4821821" y="186661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6" name="TextBox 335"/>
              <p:cNvSpPr txBox="1"/>
              <p:nvPr/>
            </p:nvSpPr>
            <p:spPr>
              <a:xfrm>
                <a:off x="4892338" y="187003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7" name="TextBox 336"/>
              <p:cNvSpPr txBox="1"/>
              <p:nvPr/>
            </p:nvSpPr>
            <p:spPr>
              <a:xfrm>
                <a:off x="1858546" y="302951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8" name="TextBox 337"/>
              <p:cNvSpPr txBox="1"/>
              <p:nvPr/>
            </p:nvSpPr>
            <p:spPr>
              <a:xfrm>
                <a:off x="1931823" y="303324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9" name="TextBox 338"/>
              <p:cNvSpPr txBox="1"/>
              <p:nvPr/>
            </p:nvSpPr>
            <p:spPr>
              <a:xfrm>
                <a:off x="4644805" y="3032745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0" name="TextBox 339"/>
              <p:cNvSpPr txBox="1"/>
              <p:nvPr/>
            </p:nvSpPr>
            <p:spPr>
              <a:xfrm>
                <a:off x="4718082" y="303647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1" name="TextBox 340"/>
              <p:cNvSpPr txBox="1"/>
              <p:nvPr/>
            </p:nvSpPr>
            <p:spPr>
              <a:xfrm>
                <a:off x="3265553" y="3030072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2" name="TextBox 341"/>
              <p:cNvSpPr txBox="1"/>
              <p:nvPr/>
            </p:nvSpPr>
            <p:spPr>
              <a:xfrm>
                <a:off x="3338830" y="303380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3" name="TextBox 342"/>
              <p:cNvSpPr txBox="1"/>
              <p:nvPr/>
            </p:nvSpPr>
            <p:spPr>
              <a:xfrm>
                <a:off x="1875553" y="4187555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4" name="TextBox 343"/>
              <p:cNvSpPr txBox="1"/>
              <p:nvPr/>
            </p:nvSpPr>
            <p:spPr>
              <a:xfrm>
                <a:off x="1947817" y="419062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5" name="TextBox 344"/>
              <p:cNvSpPr txBox="1"/>
              <p:nvPr/>
            </p:nvSpPr>
            <p:spPr>
              <a:xfrm>
                <a:off x="3280515" y="4186221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6" name="TextBox 345"/>
              <p:cNvSpPr txBox="1"/>
              <p:nvPr/>
            </p:nvSpPr>
            <p:spPr>
              <a:xfrm>
                <a:off x="3352779" y="4189295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7" name="TextBox 346"/>
              <p:cNvSpPr txBox="1"/>
              <p:nvPr/>
            </p:nvSpPr>
            <p:spPr>
              <a:xfrm>
                <a:off x="4663305" y="418296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8" name="TextBox 347"/>
              <p:cNvSpPr txBox="1"/>
              <p:nvPr/>
            </p:nvSpPr>
            <p:spPr>
              <a:xfrm>
                <a:off x="4737363" y="418603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9" name="TextBox 348"/>
              <p:cNvSpPr txBox="1"/>
              <p:nvPr/>
            </p:nvSpPr>
            <p:spPr>
              <a:xfrm>
                <a:off x="1885789" y="525893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0" name="TextBox 349"/>
              <p:cNvSpPr txBox="1"/>
              <p:nvPr/>
            </p:nvSpPr>
            <p:spPr>
              <a:xfrm>
                <a:off x="1956028" y="5262011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1" name="TextBox 350"/>
              <p:cNvSpPr txBox="1"/>
              <p:nvPr/>
            </p:nvSpPr>
            <p:spPr>
              <a:xfrm>
                <a:off x="3289370" y="525700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2" name="TextBox 351"/>
              <p:cNvSpPr txBox="1"/>
              <p:nvPr/>
            </p:nvSpPr>
            <p:spPr>
              <a:xfrm>
                <a:off x="3364651" y="5260083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3" name="TextBox 352"/>
              <p:cNvSpPr txBox="1"/>
              <p:nvPr/>
            </p:nvSpPr>
            <p:spPr>
              <a:xfrm>
                <a:off x="4673886" y="525720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4" name="TextBox 353"/>
              <p:cNvSpPr txBox="1"/>
              <p:nvPr/>
            </p:nvSpPr>
            <p:spPr>
              <a:xfrm>
                <a:off x="4747433" y="526027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5" name="TextBox 354"/>
              <p:cNvSpPr txBox="1"/>
              <p:nvPr/>
            </p:nvSpPr>
            <p:spPr>
              <a:xfrm>
                <a:off x="1821178" y="634865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6" name="TextBox 355"/>
              <p:cNvSpPr txBox="1"/>
              <p:nvPr/>
            </p:nvSpPr>
            <p:spPr>
              <a:xfrm>
                <a:off x="1890548" y="635180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7" name="TextBox 356"/>
              <p:cNvSpPr txBox="1"/>
              <p:nvPr/>
            </p:nvSpPr>
            <p:spPr>
              <a:xfrm>
                <a:off x="3226170" y="634653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8" name="TextBox 357"/>
              <p:cNvSpPr txBox="1"/>
              <p:nvPr/>
            </p:nvSpPr>
            <p:spPr>
              <a:xfrm>
                <a:off x="3294004" y="634968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9" name="TextBox 358"/>
              <p:cNvSpPr txBox="1"/>
              <p:nvPr/>
            </p:nvSpPr>
            <p:spPr>
              <a:xfrm>
                <a:off x="4612857" y="634771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0" name="TextBox 359"/>
              <p:cNvSpPr txBox="1"/>
              <p:nvPr/>
            </p:nvSpPr>
            <p:spPr>
              <a:xfrm>
                <a:off x="4678720" y="635086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1" name="TextBox 360"/>
              <p:cNvSpPr txBox="1"/>
              <p:nvPr/>
            </p:nvSpPr>
            <p:spPr>
              <a:xfrm>
                <a:off x="1742211" y="7599318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2" name="TextBox 361"/>
              <p:cNvSpPr txBox="1"/>
              <p:nvPr/>
            </p:nvSpPr>
            <p:spPr>
              <a:xfrm>
                <a:off x="1814515" y="7605434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3" name="TextBox 362"/>
              <p:cNvSpPr txBox="1"/>
              <p:nvPr/>
            </p:nvSpPr>
            <p:spPr>
              <a:xfrm>
                <a:off x="3149757" y="7596247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4" name="TextBox 363"/>
              <p:cNvSpPr txBox="1"/>
              <p:nvPr/>
            </p:nvSpPr>
            <p:spPr>
              <a:xfrm>
                <a:off x="3222060" y="7602363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5" name="TextBox 364"/>
              <p:cNvSpPr txBox="1"/>
              <p:nvPr/>
            </p:nvSpPr>
            <p:spPr>
              <a:xfrm>
                <a:off x="4529526" y="7597849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6" name="TextBox 365"/>
              <p:cNvSpPr txBox="1"/>
              <p:nvPr/>
            </p:nvSpPr>
            <p:spPr>
              <a:xfrm>
                <a:off x="4601830" y="7603965"/>
                <a:ext cx="76335" cy="153888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4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4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70" name="TextBox 369"/>
            <p:cNvSpPr txBox="1"/>
            <p:nvPr/>
          </p:nvSpPr>
          <p:spPr>
            <a:xfrm>
              <a:off x="1533767" y="184329"/>
              <a:ext cx="1342105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ko-KR" altLang="en-US" sz="900" b="1" dirty="0"/>
            </a:p>
          </p:txBody>
        </p:sp>
        <p:sp>
          <p:nvSpPr>
            <p:cNvPr id="371" name="TextBox 370"/>
            <p:cNvSpPr txBox="1"/>
            <p:nvPr/>
          </p:nvSpPr>
          <p:spPr>
            <a:xfrm>
              <a:off x="2897229" y="184749"/>
              <a:ext cx="1342105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 exposure</a:t>
              </a:r>
              <a:endParaRPr lang="ko-KR" altLang="en-US" sz="900" b="1" dirty="0"/>
            </a:p>
          </p:txBody>
        </p:sp>
        <p:sp>
          <p:nvSpPr>
            <p:cNvPr id="372" name="TextBox 371"/>
            <p:cNvSpPr txBox="1"/>
            <p:nvPr/>
          </p:nvSpPr>
          <p:spPr>
            <a:xfrm>
              <a:off x="4261684" y="185873"/>
              <a:ext cx="1342105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 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xposure</a:t>
              </a:r>
              <a:endParaRPr lang="ko-KR" altLang="en-US" sz="900" b="1" dirty="0"/>
            </a:p>
          </p:txBody>
        </p:sp>
      </p:grpSp>
      <p:sp>
        <p:nvSpPr>
          <p:cNvPr id="367" name="TextBox 366"/>
          <p:cNvSpPr txBox="1"/>
          <p:nvPr/>
        </p:nvSpPr>
        <p:spPr>
          <a:xfrm>
            <a:off x="2315666" y="793309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4" name="TextBox 373"/>
          <p:cNvSpPr txBox="1"/>
          <p:nvPr/>
        </p:nvSpPr>
        <p:spPr>
          <a:xfrm>
            <a:off x="2459435" y="1911197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5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TextBox 374"/>
          <p:cNvSpPr txBox="1"/>
          <p:nvPr/>
        </p:nvSpPr>
        <p:spPr>
          <a:xfrm>
            <a:off x="2419259" y="3063326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TextBox 375"/>
          <p:cNvSpPr txBox="1"/>
          <p:nvPr/>
        </p:nvSpPr>
        <p:spPr>
          <a:xfrm>
            <a:off x="2302913" y="4195798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2473721" y="5324524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/>
          <p:cNvSpPr txBox="1"/>
          <p:nvPr/>
        </p:nvSpPr>
        <p:spPr>
          <a:xfrm>
            <a:off x="2335916" y="6429278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9" name="TextBox 378"/>
          <p:cNvSpPr txBox="1"/>
          <p:nvPr/>
        </p:nvSpPr>
        <p:spPr>
          <a:xfrm>
            <a:off x="2478909" y="7622727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54679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208792" y="8118929"/>
            <a:ext cx="4436562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10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he origina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of western blots of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2a. Th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red box indicated the representative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ands of protein levels in Fig. 2a. Protein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expression of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HIF-1α, E-cad, Snail, Par3, TJP1 and </a:t>
            </a:r>
            <a:r>
              <a:rPr lang="en-US" altLang="ko-KR" sz="1000" kern="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in SCC-9 cell line under </a:t>
            </a:r>
            <a:r>
              <a:rPr lang="en-US" altLang="ko-KR" sz="1000" kern="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or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hypoxic conditions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y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blotting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GAPDH was used as the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internal control.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7484" y="2564114"/>
            <a:ext cx="1328848" cy="1087605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6459" y="1461502"/>
            <a:ext cx="1328848" cy="1087605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6641" y="6970752"/>
            <a:ext cx="1328848" cy="1087605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6459" y="5873028"/>
            <a:ext cx="1328848" cy="1087605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5121" y="4772974"/>
            <a:ext cx="1327898" cy="1086827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6459" y="3667021"/>
            <a:ext cx="1328848" cy="1087605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0334" y="344491"/>
            <a:ext cx="1327898" cy="1086827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3165" y="345838"/>
            <a:ext cx="1327898" cy="1086827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66588" y="358643"/>
            <a:ext cx="1327898" cy="1086827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 rot="16200000">
            <a:off x="950561" y="773997"/>
            <a:ext cx="1086827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900" b="1" dirty="0"/>
          </a:p>
        </p:txBody>
      </p:sp>
      <p:sp>
        <p:nvSpPr>
          <p:cNvPr id="14" name="TextBox 13"/>
          <p:cNvSpPr txBox="1"/>
          <p:nvPr/>
        </p:nvSpPr>
        <p:spPr>
          <a:xfrm rot="16200000">
            <a:off x="948397" y="1883762"/>
            <a:ext cx="10868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-cad</a:t>
            </a:r>
            <a:endParaRPr lang="ko-KR" altLang="en-US" sz="900" b="1" dirty="0"/>
          </a:p>
        </p:txBody>
      </p:sp>
      <p:sp>
        <p:nvSpPr>
          <p:cNvPr id="15" name="TextBox 14"/>
          <p:cNvSpPr txBox="1"/>
          <p:nvPr/>
        </p:nvSpPr>
        <p:spPr>
          <a:xfrm rot="16200000">
            <a:off x="-2520953" y="4077528"/>
            <a:ext cx="769032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C9</a:t>
            </a:r>
            <a:endParaRPr lang="ko-KR" altLang="en-US" sz="900" b="1" dirty="0"/>
          </a:p>
        </p:txBody>
      </p:sp>
      <p:cxnSp>
        <p:nvCxnSpPr>
          <p:cNvPr id="16" name="직선 연결선 15"/>
          <p:cNvCxnSpPr/>
          <p:nvPr/>
        </p:nvCxnSpPr>
        <p:spPr>
          <a:xfrm flipH="1">
            <a:off x="1396556" y="357736"/>
            <a:ext cx="3953" cy="767858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1575332" y="141864"/>
            <a:ext cx="134210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9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2938794" y="142284"/>
            <a:ext cx="134210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 exposure</a:t>
            </a:r>
            <a:endParaRPr lang="ko-KR" altLang="en-US" sz="9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303249" y="143408"/>
            <a:ext cx="134210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ko-KR" altLang="en-US" sz="900" b="1" dirty="0"/>
          </a:p>
        </p:txBody>
      </p:sp>
      <p:sp>
        <p:nvSpPr>
          <p:cNvPr id="20" name="직사각형 19"/>
          <p:cNvSpPr/>
          <p:nvPr/>
        </p:nvSpPr>
        <p:spPr>
          <a:xfrm>
            <a:off x="2470296" y="1908578"/>
            <a:ext cx="206242" cy="7670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1" name="TextBox 20"/>
          <p:cNvSpPr txBox="1"/>
          <p:nvPr/>
        </p:nvSpPr>
        <p:spPr>
          <a:xfrm>
            <a:off x="1523017" y="1886168"/>
            <a:ext cx="33655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-cad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1654970" y="780699"/>
            <a:ext cx="33178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619676" y="875441"/>
            <a:ext cx="36618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970131" y="778885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048872" y="78311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직사각형 25"/>
          <p:cNvSpPr/>
          <p:nvPr/>
        </p:nvSpPr>
        <p:spPr>
          <a:xfrm>
            <a:off x="1969823" y="920073"/>
            <a:ext cx="154641" cy="52621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/>
          <p:cNvSpPr txBox="1"/>
          <p:nvPr/>
        </p:nvSpPr>
        <p:spPr>
          <a:xfrm>
            <a:off x="3049738" y="778885"/>
            <a:ext cx="31964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008181" y="869778"/>
            <a:ext cx="3630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346767" y="79167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3418021" y="79503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직사각형 30"/>
          <p:cNvSpPr/>
          <p:nvPr/>
        </p:nvSpPr>
        <p:spPr>
          <a:xfrm>
            <a:off x="3354778" y="915146"/>
            <a:ext cx="140915" cy="52621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548656" y="1693751"/>
            <a:ext cx="31463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2480928" y="169341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579512" y="169676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 rot="16200000">
            <a:off x="940296" y="2989780"/>
            <a:ext cx="1086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  <a:endParaRPr lang="ko-KR" altLang="en-US" sz="9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1537048" y="2976016"/>
            <a:ext cx="32950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485113" y="2885127"/>
            <a:ext cx="38205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2128932" y="288512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225696" y="289074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직사각형 39"/>
          <p:cNvSpPr/>
          <p:nvPr/>
        </p:nvSpPr>
        <p:spPr>
          <a:xfrm>
            <a:off x="2125998" y="3015114"/>
            <a:ext cx="197035" cy="75688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1" name="TextBox 40"/>
          <p:cNvSpPr txBox="1"/>
          <p:nvPr/>
        </p:nvSpPr>
        <p:spPr>
          <a:xfrm>
            <a:off x="1602036" y="4151860"/>
            <a:ext cx="32970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직사각형 41"/>
          <p:cNvSpPr/>
          <p:nvPr/>
        </p:nvSpPr>
        <p:spPr>
          <a:xfrm>
            <a:off x="2361264" y="4205872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TextBox 42"/>
          <p:cNvSpPr txBox="1"/>
          <p:nvPr/>
        </p:nvSpPr>
        <p:spPr>
          <a:xfrm>
            <a:off x="1619676" y="4030471"/>
            <a:ext cx="31460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363496" y="403031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2437841" y="4035852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939407" y="4095798"/>
            <a:ext cx="1086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900" b="1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938613" y="5200973"/>
            <a:ext cx="1086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9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1585931" y="5244631"/>
            <a:ext cx="35105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2114118" y="5297010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0" name="TextBox 49"/>
          <p:cNvSpPr txBox="1"/>
          <p:nvPr/>
        </p:nvSpPr>
        <p:spPr>
          <a:xfrm>
            <a:off x="1622477" y="5152101"/>
            <a:ext cx="31565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2113719" y="5150231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2186845" y="5153242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944257" y="6303844"/>
            <a:ext cx="1086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endParaRPr lang="ko-KR" altLang="en-US" sz="9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1663255" y="6104894"/>
            <a:ext cx="35154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607227" y="6261953"/>
            <a:ext cx="41261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312518" y="610608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413373" y="6109906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직사각형 57"/>
          <p:cNvSpPr/>
          <p:nvPr/>
        </p:nvSpPr>
        <p:spPr>
          <a:xfrm>
            <a:off x="2097651" y="6307959"/>
            <a:ext cx="405042" cy="6092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9" name="TextBox 58"/>
          <p:cNvSpPr txBox="1"/>
          <p:nvPr/>
        </p:nvSpPr>
        <p:spPr>
          <a:xfrm rot="16200000">
            <a:off x="943525" y="7401860"/>
            <a:ext cx="1086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b="1" dirty="0"/>
          </a:p>
        </p:txBody>
      </p:sp>
      <p:sp>
        <p:nvSpPr>
          <p:cNvPr id="60" name="TextBox 59"/>
          <p:cNvSpPr txBox="1"/>
          <p:nvPr/>
        </p:nvSpPr>
        <p:spPr>
          <a:xfrm>
            <a:off x="1654970" y="7351719"/>
            <a:ext cx="37846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695300" y="7276652"/>
            <a:ext cx="33837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2302231" y="727902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400445" y="7281971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직사각형 63"/>
          <p:cNvSpPr/>
          <p:nvPr/>
        </p:nvSpPr>
        <p:spPr>
          <a:xfrm>
            <a:off x="2055105" y="7398651"/>
            <a:ext cx="433269" cy="5591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TextBox 64"/>
          <p:cNvSpPr txBox="1"/>
          <p:nvPr/>
        </p:nvSpPr>
        <p:spPr>
          <a:xfrm>
            <a:off x="4287348" y="778885"/>
            <a:ext cx="41753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4322062" y="879126"/>
            <a:ext cx="3887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714324" y="79436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785578" y="79772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직사각형 68"/>
          <p:cNvSpPr/>
          <p:nvPr/>
        </p:nvSpPr>
        <p:spPr>
          <a:xfrm>
            <a:off x="4714070" y="916116"/>
            <a:ext cx="140915" cy="52621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pic>
        <p:nvPicPr>
          <p:cNvPr id="70" name="그림 69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2215" y="3667022"/>
            <a:ext cx="1328848" cy="1087605"/>
          </a:xfrm>
          <a:prstGeom prst="rect">
            <a:avLst/>
          </a:prstGeom>
        </p:spPr>
      </p:pic>
      <p:pic>
        <p:nvPicPr>
          <p:cNvPr id="71" name="그림 70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0804" y="3667022"/>
            <a:ext cx="1328848" cy="1087605"/>
          </a:xfrm>
          <a:prstGeom prst="rect">
            <a:avLst/>
          </a:prstGeom>
        </p:spPr>
      </p:pic>
      <p:sp>
        <p:nvSpPr>
          <p:cNvPr id="72" name="TextBox 71"/>
          <p:cNvSpPr txBox="1"/>
          <p:nvPr/>
        </p:nvSpPr>
        <p:spPr>
          <a:xfrm>
            <a:off x="2976649" y="4151860"/>
            <a:ext cx="32806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직사각형 72"/>
          <p:cNvSpPr/>
          <p:nvPr/>
        </p:nvSpPr>
        <p:spPr>
          <a:xfrm>
            <a:off x="3734239" y="4205872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2990953" y="4030471"/>
            <a:ext cx="31630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736471" y="403031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810817" y="4035852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340050" y="4149685"/>
            <a:ext cx="32919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직사각형 77"/>
          <p:cNvSpPr/>
          <p:nvPr/>
        </p:nvSpPr>
        <p:spPr>
          <a:xfrm>
            <a:off x="5098770" y="4203697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314824" y="4028296"/>
            <a:ext cx="35696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101002" y="402813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5172966" y="403367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2" name="그림 81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8794" y="4772974"/>
            <a:ext cx="1327898" cy="1086827"/>
          </a:xfrm>
          <a:prstGeom prst="rect">
            <a:avLst/>
          </a:prstGeom>
        </p:spPr>
      </p:pic>
      <p:pic>
        <p:nvPicPr>
          <p:cNvPr id="83" name="그림 82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8961" y="4774764"/>
            <a:ext cx="1327898" cy="1086827"/>
          </a:xfrm>
          <a:prstGeom prst="rect">
            <a:avLst/>
          </a:prstGeom>
        </p:spPr>
      </p:pic>
      <p:sp>
        <p:nvSpPr>
          <p:cNvPr id="84" name="TextBox 83"/>
          <p:cNvSpPr txBox="1"/>
          <p:nvPr/>
        </p:nvSpPr>
        <p:spPr>
          <a:xfrm>
            <a:off x="3007100" y="5245774"/>
            <a:ext cx="30575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직사각형 84"/>
          <p:cNvSpPr/>
          <p:nvPr/>
        </p:nvSpPr>
        <p:spPr>
          <a:xfrm>
            <a:off x="3489984" y="5294582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003385" y="5153244"/>
            <a:ext cx="31061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491370" y="5151374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3562712" y="5154385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4338034" y="5245336"/>
            <a:ext cx="32643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직사각형 89"/>
          <p:cNvSpPr/>
          <p:nvPr/>
        </p:nvSpPr>
        <p:spPr>
          <a:xfrm>
            <a:off x="4843382" y="5297715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338035" y="5152807"/>
            <a:ext cx="32757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842983" y="5150936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916743" y="515394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4" name="그림 93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36517" y="5870794"/>
            <a:ext cx="1328848" cy="1087605"/>
          </a:xfrm>
          <a:prstGeom prst="rect">
            <a:avLst/>
          </a:prstGeom>
        </p:spPr>
      </p:pic>
      <p:pic>
        <p:nvPicPr>
          <p:cNvPr id="95" name="그림 94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4265" y="5875069"/>
            <a:ext cx="1328848" cy="1087605"/>
          </a:xfrm>
          <a:prstGeom prst="rect">
            <a:avLst/>
          </a:prstGeom>
        </p:spPr>
      </p:pic>
      <p:sp>
        <p:nvSpPr>
          <p:cNvPr id="96" name="TextBox 95"/>
          <p:cNvSpPr txBox="1"/>
          <p:nvPr/>
        </p:nvSpPr>
        <p:spPr>
          <a:xfrm>
            <a:off x="3054274" y="6104894"/>
            <a:ext cx="33281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3003386" y="6261953"/>
            <a:ext cx="38875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679973" y="610608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3783247" y="6109906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직사각형 99"/>
          <p:cNvSpPr/>
          <p:nvPr/>
        </p:nvSpPr>
        <p:spPr>
          <a:xfrm>
            <a:off x="3457202" y="6307959"/>
            <a:ext cx="417784" cy="6092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4392199" y="6105778"/>
            <a:ext cx="36737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356621" y="6262837"/>
            <a:ext cx="4079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5045195" y="6106971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5150888" y="611078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직사각형 104"/>
          <p:cNvSpPr/>
          <p:nvPr/>
        </p:nvSpPr>
        <p:spPr>
          <a:xfrm>
            <a:off x="4824937" y="6308843"/>
            <a:ext cx="422527" cy="6092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pic>
        <p:nvPicPr>
          <p:cNvPr id="106" name="그림 105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7438" y="6969392"/>
            <a:ext cx="1328848" cy="1087605"/>
          </a:xfrm>
          <a:prstGeom prst="rect">
            <a:avLst/>
          </a:prstGeom>
        </p:spPr>
      </p:pic>
      <p:pic>
        <p:nvPicPr>
          <p:cNvPr id="107" name="그림 106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5795" y="6973861"/>
            <a:ext cx="1328848" cy="1087605"/>
          </a:xfrm>
          <a:prstGeom prst="rect">
            <a:avLst/>
          </a:prstGeom>
        </p:spPr>
      </p:pic>
      <p:sp>
        <p:nvSpPr>
          <p:cNvPr id="108" name="TextBox 107"/>
          <p:cNvSpPr txBox="1"/>
          <p:nvPr/>
        </p:nvSpPr>
        <p:spPr>
          <a:xfrm>
            <a:off x="3012113" y="7349558"/>
            <a:ext cx="3720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3061622" y="7274491"/>
            <a:ext cx="32281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653000" y="727685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751215" y="727981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직사각형 111"/>
          <p:cNvSpPr/>
          <p:nvPr/>
        </p:nvSpPr>
        <p:spPr>
          <a:xfrm>
            <a:off x="3433463" y="7396491"/>
            <a:ext cx="405682" cy="5591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4356622" y="7355026"/>
            <a:ext cx="40569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4411169" y="7279960"/>
            <a:ext cx="35137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5031105" y="728232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5126901" y="728527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직사각형 116"/>
          <p:cNvSpPr/>
          <p:nvPr/>
        </p:nvSpPr>
        <p:spPr>
          <a:xfrm>
            <a:off x="4798747" y="7401959"/>
            <a:ext cx="418503" cy="5591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2239481" y="78023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2315036" y="78446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직사각형 119"/>
          <p:cNvSpPr/>
          <p:nvPr/>
        </p:nvSpPr>
        <p:spPr>
          <a:xfrm>
            <a:off x="2236086" y="919325"/>
            <a:ext cx="154641" cy="52621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21" name="직사각형 120"/>
          <p:cNvSpPr/>
          <p:nvPr/>
        </p:nvSpPr>
        <p:spPr>
          <a:xfrm>
            <a:off x="3619624" y="913307"/>
            <a:ext cx="140915" cy="52621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620941" y="79117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3692195" y="794534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직사각형 123"/>
          <p:cNvSpPr/>
          <p:nvPr/>
        </p:nvSpPr>
        <p:spPr>
          <a:xfrm>
            <a:off x="4974816" y="916787"/>
            <a:ext cx="140915" cy="52621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4976349" y="794662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5047603" y="79801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2097652" y="402848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2171995" y="403402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직사각형 128"/>
          <p:cNvSpPr/>
          <p:nvPr/>
        </p:nvSpPr>
        <p:spPr>
          <a:xfrm>
            <a:off x="2100618" y="4207949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0" name="TextBox 129"/>
          <p:cNvSpPr txBox="1"/>
          <p:nvPr/>
        </p:nvSpPr>
        <p:spPr>
          <a:xfrm>
            <a:off x="3480575" y="4028541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549562" y="403408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직사각형 131"/>
          <p:cNvSpPr/>
          <p:nvPr/>
        </p:nvSpPr>
        <p:spPr>
          <a:xfrm>
            <a:off x="3471873" y="4207949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3" name="직사각형 132"/>
          <p:cNvSpPr/>
          <p:nvPr/>
        </p:nvSpPr>
        <p:spPr>
          <a:xfrm>
            <a:off x="4831655" y="4207949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833550" y="402670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4903132" y="403224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직사각형 135"/>
          <p:cNvSpPr/>
          <p:nvPr/>
        </p:nvSpPr>
        <p:spPr>
          <a:xfrm>
            <a:off x="2389829" y="5293456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7" name="TextBox 136"/>
          <p:cNvSpPr txBox="1"/>
          <p:nvPr/>
        </p:nvSpPr>
        <p:spPr>
          <a:xfrm>
            <a:off x="2385701" y="514888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2458826" y="5151894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직사각형 138"/>
          <p:cNvSpPr/>
          <p:nvPr/>
        </p:nvSpPr>
        <p:spPr>
          <a:xfrm>
            <a:off x="3755871" y="5292937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3756550" y="515158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>
            <a:off x="3830310" y="5154591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직사각형 141"/>
          <p:cNvSpPr/>
          <p:nvPr/>
        </p:nvSpPr>
        <p:spPr>
          <a:xfrm>
            <a:off x="5120451" y="5292937"/>
            <a:ext cx="151807" cy="458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5119640" y="515104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5188561" y="515406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2111321" y="6106451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2214597" y="611026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3478560" y="610608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3581835" y="6109906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4848407" y="6106604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4949262" y="6110422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1" name="그림 150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2215" y="1461328"/>
            <a:ext cx="1328848" cy="1087605"/>
          </a:xfrm>
          <a:prstGeom prst="rect">
            <a:avLst/>
          </a:prstGeom>
        </p:spPr>
      </p:pic>
      <p:pic>
        <p:nvPicPr>
          <p:cNvPr id="152" name="그림 151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0335" y="1459659"/>
            <a:ext cx="1328848" cy="1087605"/>
          </a:xfrm>
          <a:prstGeom prst="rect">
            <a:avLst/>
          </a:prstGeom>
        </p:spPr>
      </p:pic>
      <p:sp>
        <p:nvSpPr>
          <p:cNvPr id="153" name="직사각형 152"/>
          <p:cNvSpPr/>
          <p:nvPr/>
        </p:nvSpPr>
        <p:spPr>
          <a:xfrm>
            <a:off x="2091202" y="1918052"/>
            <a:ext cx="206242" cy="7670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54" name="TextBox 153"/>
          <p:cNvSpPr txBox="1"/>
          <p:nvPr/>
        </p:nvSpPr>
        <p:spPr>
          <a:xfrm>
            <a:off x="2108902" y="1693051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>
            <a:off x="2207486" y="169640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직사각형 155"/>
          <p:cNvSpPr/>
          <p:nvPr/>
        </p:nvSpPr>
        <p:spPr>
          <a:xfrm>
            <a:off x="3847610" y="1913615"/>
            <a:ext cx="206242" cy="7670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2900077" y="1880897"/>
            <a:ext cx="34984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-cad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2902994" y="1695048"/>
            <a:ext cx="33278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3858241" y="169845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3956825" y="1701806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직사각형 160"/>
          <p:cNvSpPr/>
          <p:nvPr/>
        </p:nvSpPr>
        <p:spPr>
          <a:xfrm>
            <a:off x="3468514" y="1923090"/>
            <a:ext cx="206242" cy="7670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3486215" y="169808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3584798" y="1701445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직사각형 163"/>
          <p:cNvSpPr/>
          <p:nvPr/>
        </p:nvSpPr>
        <p:spPr>
          <a:xfrm>
            <a:off x="5204033" y="1907218"/>
            <a:ext cx="206242" cy="7670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4235803" y="1877949"/>
            <a:ext cx="32895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-cad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4245552" y="1697298"/>
            <a:ext cx="31319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" name="TextBox 166"/>
          <p:cNvSpPr txBox="1"/>
          <p:nvPr/>
        </p:nvSpPr>
        <p:spPr>
          <a:xfrm>
            <a:off x="5214664" y="1692053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5313248" y="169540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직사각형 168"/>
          <p:cNvSpPr/>
          <p:nvPr/>
        </p:nvSpPr>
        <p:spPr>
          <a:xfrm>
            <a:off x="4824937" y="1916693"/>
            <a:ext cx="206242" cy="7670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4842638" y="1691692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4941221" y="169504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2102692" y="727920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2200905" y="7282158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3449229" y="727757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3547444" y="728053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>
            <a:off x="4831699" y="7283804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>
            <a:off x="4932333" y="7286755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8" name="그림 177"/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0335" y="2566058"/>
            <a:ext cx="1328848" cy="1087605"/>
          </a:xfrm>
          <a:prstGeom prst="rect">
            <a:avLst/>
          </a:prstGeom>
        </p:spPr>
      </p:pic>
      <p:pic>
        <p:nvPicPr>
          <p:cNvPr id="179" name="그림 178"/>
          <p:cNvPicPr>
            <a:picLocks noChangeAspect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1819" y="2563036"/>
            <a:ext cx="1328848" cy="1087605"/>
          </a:xfrm>
          <a:prstGeom prst="rect">
            <a:avLst/>
          </a:prstGeom>
        </p:spPr>
      </p:pic>
      <p:sp>
        <p:nvSpPr>
          <p:cNvPr id="180" name="TextBox 179"/>
          <p:cNvSpPr txBox="1"/>
          <p:nvPr/>
        </p:nvSpPr>
        <p:spPr>
          <a:xfrm>
            <a:off x="2516895" y="2888062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/>
          <p:cNvSpPr txBox="1"/>
          <p:nvPr/>
        </p:nvSpPr>
        <p:spPr>
          <a:xfrm>
            <a:off x="2613659" y="2893684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직사각형 181"/>
          <p:cNvSpPr/>
          <p:nvPr/>
        </p:nvSpPr>
        <p:spPr>
          <a:xfrm>
            <a:off x="2513962" y="3018050"/>
            <a:ext cx="197035" cy="75688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3" name="TextBox 182"/>
          <p:cNvSpPr txBox="1"/>
          <p:nvPr/>
        </p:nvSpPr>
        <p:spPr>
          <a:xfrm>
            <a:off x="2913973" y="2976016"/>
            <a:ext cx="34176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>
            <a:off x="2936517" y="2885123"/>
            <a:ext cx="31983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3518118" y="2885125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3614881" y="289074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직사각형 186"/>
          <p:cNvSpPr/>
          <p:nvPr/>
        </p:nvSpPr>
        <p:spPr>
          <a:xfrm>
            <a:off x="3515183" y="3015111"/>
            <a:ext cx="197035" cy="75688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88" name="TextBox 187"/>
          <p:cNvSpPr txBox="1"/>
          <p:nvPr/>
        </p:nvSpPr>
        <p:spPr>
          <a:xfrm>
            <a:off x="3906081" y="288805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" name="TextBox 188"/>
          <p:cNvSpPr txBox="1"/>
          <p:nvPr/>
        </p:nvSpPr>
        <p:spPr>
          <a:xfrm>
            <a:off x="4002845" y="2893680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직사각형 189"/>
          <p:cNvSpPr/>
          <p:nvPr/>
        </p:nvSpPr>
        <p:spPr>
          <a:xfrm>
            <a:off x="3903148" y="3018045"/>
            <a:ext cx="197035" cy="75688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91" name="TextBox 190"/>
          <p:cNvSpPr txBox="1"/>
          <p:nvPr/>
        </p:nvSpPr>
        <p:spPr>
          <a:xfrm>
            <a:off x="4275970" y="2976016"/>
            <a:ext cx="32739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nail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4273601" y="2885128"/>
            <a:ext cx="33037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yp</a:t>
            </a:r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4872884" y="2885127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/>
          <p:cNvSpPr txBox="1"/>
          <p:nvPr/>
        </p:nvSpPr>
        <p:spPr>
          <a:xfrm>
            <a:off x="4972030" y="289074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직사각형 194"/>
          <p:cNvSpPr/>
          <p:nvPr/>
        </p:nvSpPr>
        <p:spPr>
          <a:xfrm>
            <a:off x="4862807" y="3015113"/>
            <a:ext cx="197035" cy="75688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5258466" y="2888065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5352849" y="2893689"/>
            <a:ext cx="747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" name="직사각형 197"/>
          <p:cNvSpPr/>
          <p:nvPr/>
        </p:nvSpPr>
        <p:spPr>
          <a:xfrm>
            <a:off x="5250764" y="3018046"/>
            <a:ext cx="197035" cy="75688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2540383" y="862105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2608022" y="1867754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5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2640533" y="2973245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2476093" y="414764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2499164" y="5232586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2450219" y="6261389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2453216" y="7348994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26888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207522" y="8103939"/>
            <a:ext cx="4413631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S11.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The original figure of western blots of Figure 2a. The red box indicated the representative bands of protein levels in Fig. 2a. Protein expression of HIF-1α, E-cad, Snail, Par3, TJP1 and </a:t>
            </a:r>
            <a:r>
              <a:rPr lang="en-US" altLang="ko-KR" sz="1000" kern="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laudin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in SCC-25 cell line under </a:t>
            </a:r>
            <a:r>
              <a:rPr lang="en-US" altLang="ko-KR" sz="1000" kern="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rmoxia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or hypoxic conditions by western blotting. GAPDH was used as the internal control.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6" name="그룹 205"/>
          <p:cNvGrpSpPr/>
          <p:nvPr/>
        </p:nvGrpSpPr>
        <p:grpSpPr>
          <a:xfrm>
            <a:off x="1207524" y="105602"/>
            <a:ext cx="4436505" cy="7919604"/>
            <a:chOff x="1207524" y="315462"/>
            <a:chExt cx="4436505" cy="7919604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0231" y="4941458"/>
              <a:ext cx="1327881" cy="1086806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6286" y="7148260"/>
              <a:ext cx="1327881" cy="1086806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58756" y="6044240"/>
              <a:ext cx="1327881" cy="1086806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0455" y="3841034"/>
              <a:ext cx="1327881" cy="1086806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3652" y="2732076"/>
              <a:ext cx="1327881" cy="1086806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3652" y="1626859"/>
              <a:ext cx="1327881" cy="1086806"/>
            </a:xfrm>
            <a:prstGeom prst="rect">
              <a:avLst/>
            </a:prstGeom>
          </p:spPr>
        </p:pic>
        <p:pic>
          <p:nvPicPr>
            <p:cNvPr id="10" name="그림 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65186" y="521128"/>
              <a:ext cx="1327881" cy="1086806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 rot="16200000">
              <a:off x="949300" y="947584"/>
              <a:ext cx="1086806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9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947137" y="2057327"/>
              <a:ext cx="10868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-cad</a:t>
              </a:r>
              <a:endParaRPr lang="ko-KR" altLang="en-US" sz="900" b="1" dirty="0"/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-2522148" y="4249265"/>
              <a:ext cx="769017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900" b="1" dirty="0"/>
            </a:p>
          </p:txBody>
        </p:sp>
        <p:cxnSp>
          <p:nvCxnSpPr>
            <p:cNvPr id="14" name="직선 연결선 13"/>
            <p:cNvCxnSpPr/>
            <p:nvPr/>
          </p:nvCxnSpPr>
          <p:spPr>
            <a:xfrm flipH="1">
              <a:off x="1395286" y="531332"/>
              <a:ext cx="3953" cy="767843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1574059" y="315462"/>
              <a:ext cx="1342088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ko-KR" altLang="en-US" sz="9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937505" y="315882"/>
              <a:ext cx="1342088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 exposure</a:t>
              </a:r>
              <a:endParaRPr lang="ko-KR" altLang="en-US" sz="9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301941" y="317005"/>
              <a:ext cx="1342088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 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xposure</a:t>
              </a:r>
              <a:endParaRPr lang="ko-KR" altLang="en-US" sz="900" b="1" dirty="0"/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2103533" y="2156693"/>
              <a:ext cx="150825" cy="6417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593042" y="2108555"/>
              <a:ext cx="33650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-cad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663279" y="954286"/>
              <a:ext cx="34166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646944" y="1030565"/>
              <a:ext cx="35462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109479" y="95247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179566" y="956697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직사각형 23"/>
            <p:cNvSpPr/>
            <p:nvPr/>
          </p:nvSpPr>
          <p:spPr>
            <a:xfrm>
              <a:off x="2103533" y="1083456"/>
              <a:ext cx="154639" cy="5262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560632" y="2037861"/>
              <a:ext cx="36891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106862" y="203582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174518" y="2040379"/>
              <a:ext cx="7682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6200000">
              <a:off x="939036" y="3163324"/>
              <a:ext cx="10868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nail</a:t>
              </a:r>
              <a:endParaRPr lang="ko-KR" altLang="en-US" sz="9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578128" y="3217865"/>
              <a:ext cx="34620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nail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545195" y="3137441"/>
              <a:ext cx="37975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372644" y="314668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2440177" y="3150786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2359982" y="3263141"/>
              <a:ext cx="168564" cy="6255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586198" y="4325382"/>
              <a:ext cx="33954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직사각형 34"/>
            <p:cNvSpPr/>
            <p:nvPr/>
          </p:nvSpPr>
          <p:spPr>
            <a:xfrm>
              <a:off x="2371791" y="4365223"/>
              <a:ext cx="151806" cy="5932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592598" y="4241783"/>
              <a:ext cx="33804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376385" y="4241626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450729" y="424716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938146" y="4269320"/>
              <a:ext cx="10868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900" b="1" dirty="0"/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937353" y="5374474"/>
              <a:ext cx="10868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900" b="1" dirty="0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545195" y="5383601"/>
              <a:ext cx="36403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직사각형 41"/>
            <p:cNvSpPr/>
            <p:nvPr/>
          </p:nvSpPr>
          <p:spPr>
            <a:xfrm>
              <a:off x="2290365" y="5432474"/>
              <a:ext cx="152272" cy="5545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548927" y="5251212"/>
              <a:ext cx="36143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293212" y="5252038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2364410" y="5254897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935539" y="6477325"/>
              <a:ext cx="10868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laudin</a:t>
              </a:r>
              <a:endParaRPr lang="ko-KR" altLang="en-US" sz="900" b="1" dirty="0"/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1523224" y="6442114"/>
              <a:ext cx="37526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1499125" y="6506418"/>
              <a:ext cx="3977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audin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2086510" y="6440259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2157156" y="644363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직사각형 50"/>
            <p:cNvSpPr/>
            <p:nvPr/>
          </p:nvSpPr>
          <p:spPr>
            <a:xfrm>
              <a:off x="2080673" y="6555968"/>
              <a:ext cx="152265" cy="6092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2" name="TextBox 51"/>
            <p:cNvSpPr txBox="1"/>
            <p:nvPr/>
          </p:nvSpPr>
          <p:spPr>
            <a:xfrm rot="16200000">
              <a:off x="938537" y="7575320"/>
              <a:ext cx="10868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900" b="1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470116" y="7615713"/>
              <a:ext cx="44802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554688" y="7527636"/>
              <a:ext cx="36504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092930" y="752830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2162645" y="7531387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직사각형 56"/>
            <p:cNvSpPr/>
            <p:nvPr/>
          </p:nvSpPr>
          <p:spPr>
            <a:xfrm>
              <a:off x="2088054" y="7655126"/>
              <a:ext cx="157110" cy="7566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pic>
          <p:nvPicPr>
            <p:cNvPr id="58" name="그림 57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40924" y="520276"/>
              <a:ext cx="1327881" cy="1086806"/>
            </a:xfrm>
            <a:prstGeom prst="rect">
              <a:avLst/>
            </a:prstGeom>
          </p:spPr>
        </p:pic>
        <p:pic>
          <p:nvPicPr>
            <p:cNvPr id="59" name="그림 58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4924" y="522225"/>
              <a:ext cx="1327881" cy="1086806"/>
            </a:xfrm>
            <a:prstGeom prst="rect">
              <a:avLst/>
            </a:prstGeom>
          </p:spPr>
        </p:pic>
        <p:sp>
          <p:nvSpPr>
            <p:cNvPr id="60" name="TextBox 59"/>
            <p:cNvSpPr txBox="1"/>
            <p:nvPr/>
          </p:nvSpPr>
          <p:spPr>
            <a:xfrm>
              <a:off x="3045319" y="955025"/>
              <a:ext cx="33571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995031" y="1031303"/>
              <a:ext cx="38263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485573" y="95321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555660" y="95743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직사각형 63"/>
            <p:cNvSpPr/>
            <p:nvPr/>
          </p:nvSpPr>
          <p:spPr>
            <a:xfrm>
              <a:off x="3479627" y="1084194"/>
              <a:ext cx="154639" cy="5262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365575" y="954572"/>
              <a:ext cx="36905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357428" y="1030850"/>
              <a:ext cx="37382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839164" y="952757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909251" y="95698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직사각형 68"/>
            <p:cNvSpPr/>
            <p:nvPr/>
          </p:nvSpPr>
          <p:spPr>
            <a:xfrm>
              <a:off x="4833218" y="1083741"/>
              <a:ext cx="154639" cy="5262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pic>
          <p:nvPicPr>
            <p:cNvPr id="70" name="그림 69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7090" y="1626859"/>
              <a:ext cx="1327881" cy="1086806"/>
            </a:xfrm>
            <a:prstGeom prst="rect">
              <a:avLst/>
            </a:prstGeom>
          </p:spPr>
        </p:pic>
        <p:pic>
          <p:nvPicPr>
            <p:cNvPr id="71" name="그림 70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4924" y="1625839"/>
              <a:ext cx="1327881" cy="1086806"/>
            </a:xfrm>
            <a:prstGeom prst="rect">
              <a:avLst/>
            </a:prstGeom>
          </p:spPr>
        </p:pic>
        <p:sp>
          <p:nvSpPr>
            <p:cNvPr id="72" name="직사각형 71"/>
            <p:cNvSpPr/>
            <p:nvPr/>
          </p:nvSpPr>
          <p:spPr>
            <a:xfrm>
              <a:off x="3477409" y="2156693"/>
              <a:ext cx="150825" cy="6417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2959866" y="2108555"/>
              <a:ext cx="34355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-cad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956537" y="2037861"/>
              <a:ext cx="34688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3480738" y="203582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3548394" y="2040379"/>
              <a:ext cx="7682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직사각형 76"/>
            <p:cNvSpPr/>
            <p:nvPr/>
          </p:nvSpPr>
          <p:spPr>
            <a:xfrm>
              <a:off x="4833218" y="2156693"/>
              <a:ext cx="150825" cy="6417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263583" y="2108555"/>
              <a:ext cx="39564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-cad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4332626" y="2037861"/>
              <a:ext cx="32660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4836547" y="203582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4904203" y="2040379"/>
              <a:ext cx="7682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2" name="그림 81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7006" y="2731065"/>
              <a:ext cx="1327881" cy="1086806"/>
            </a:xfrm>
            <a:prstGeom prst="rect">
              <a:avLst/>
            </a:prstGeom>
          </p:spPr>
        </p:pic>
        <p:pic>
          <p:nvPicPr>
            <p:cNvPr id="83" name="그림 82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6163" y="2731313"/>
              <a:ext cx="1327881" cy="1086806"/>
            </a:xfrm>
            <a:prstGeom prst="rect">
              <a:avLst/>
            </a:prstGeom>
          </p:spPr>
        </p:pic>
        <p:sp>
          <p:nvSpPr>
            <p:cNvPr id="84" name="TextBox 83"/>
            <p:cNvSpPr txBox="1"/>
            <p:nvPr/>
          </p:nvSpPr>
          <p:spPr>
            <a:xfrm>
              <a:off x="2963578" y="3216176"/>
              <a:ext cx="33551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nail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956537" y="3135753"/>
              <a:ext cx="34316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747398" y="314499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814931" y="3149098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직사각형 87"/>
            <p:cNvSpPr/>
            <p:nvPr/>
          </p:nvSpPr>
          <p:spPr>
            <a:xfrm>
              <a:off x="3734736" y="3261453"/>
              <a:ext cx="168564" cy="6255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4291459" y="3214002"/>
              <a:ext cx="36469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nail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310360" y="3133578"/>
              <a:ext cx="34641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5104465" y="3142818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5171999" y="3146923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직사각형 92"/>
            <p:cNvSpPr/>
            <p:nvPr/>
          </p:nvSpPr>
          <p:spPr>
            <a:xfrm>
              <a:off x="5091804" y="3259279"/>
              <a:ext cx="168564" cy="6255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pic>
          <p:nvPicPr>
            <p:cNvPr id="94" name="그림 93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5702" y="3840575"/>
              <a:ext cx="1327881" cy="1086806"/>
            </a:xfrm>
            <a:prstGeom prst="rect">
              <a:avLst/>
            </a:prstGeom>
          </p:spPr>
        </p:pic>
        <p:pic>
          <p:nvPicPr>
            <p:cNvPr id="95" name="그림 94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4271" y="3840364"/>
              <a:ext cx="1327881" cy="1086806"/>
            </a:xfrm>
            <a:prstGeom prst="rect">
              <a:avLst/>
            </a:prstGeom>
          </p:spPr>
        </p:pic>
        <p:sp>
          <p:nvSpPr>
            <p:cNvPr id="96" name="TextBox 95"/>
            <p:cNvSpPr txBox="1"/>
            <p:nvPr/>
          </p:nvSpPr>
          <p:spPr>
            <a:xfrm>
              <a:off x="2920479" y="4324037"/>
              <a:ext cx="37831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직사각형 96"/>
            <p:cNvSpPr/>
            <p:nvPr/>
          </p:nvSpPr>
          <p:spPr>
            <a:xfrm>
              <a:off x="3744847" y="4363878"/>
              <a:ext cx="151806" cy="5932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2956537" y="4240438"/>
              <a:ext cx="34716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3749441" y="424028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823785" y="424582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4301938" y="4320122"/>
              <a:ext cx="359511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직사각형 101"/>
            <p:cNvSpPr/>
            <p:nvPr/>
          </p:nvSpPr>
          <p:spPr>
            <a:xfrm>
              <a:off x="5107499" y="4359963"/>
              <a:ext cx="151806" cy="5932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4332626" y="4236523"/>
              <a:ext cx="33372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5112093" y="423636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5186437" y="4241904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6" name="그림 105"/>
            <p:cNvPicPr>
              <a:picLocks noChangeAspect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4130" y="6043130"/>
              <a:ext cx="1327881" cy="1086806"/>
            </a:xfrm>
            <a:prstGeom prst="rect">
              <a:avLst/>
            </a:prstGeom>
          </p:spPr>
        </p:pic>
        <p:pic>
          <p:nvPicPr>
            <p:cNvPr id="107" name="그림 106"/>
            <p:cNvPicPr>
              <a:picLocks noChangeAspect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3995" y="6041369"/>
              <a:ext cx="1327881" cy="1086806"/>
            </a:xfrm>
            <a:prstGeom prst="rect">
              <a:avLst/>
            </a:prstGeom>
          </p:spPr>
        </p:pic>
        <p:sp>
          <p:nvSpPr>
            <p:cNvPr id="108" name="TextBox 107"/>
            <p:cNvSpPr txBox="1"/>
            <p:nvPr/>
          </p:nvSpPr>
          <p:spPr>
            <a:xfrm>
              <a:off x="2950070" y="6441498"/>
              <a:ext cx="33460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863485" y="6505802"/>
              <a:ext cx="41961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laudin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3472695" y="6439643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543341" y="6443014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직사각형 111"/>
            <p:cNvSpPr/>
            <p:nvPr/>
          </p:nvSpPr>
          <p:spPr>
            <a:xfrm>
              <a:off x="3466859" y="6555352"/>
              <a:ext cx="152265" cy="6092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4187579" y="6441498"/>
              <a:ext cx="44422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157689" y="6505802"/>
              <a:ext cx="472531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laudin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819818" y="6439643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4890463" y="6443014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직사각형 116"/>
            <p:cNvSpPr/>
            <p:nvPr/>
          </p:nvSpPr>
          <p:spPr>
            <a:xfrm>
              <a:off x="4813981" y="6555352"/>
              <a:ext cx="152265" cy="6092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pic>
          <p:nvPicPr>
            <p:cNvPr id="118" name="그림 117"/>
            <p:cNvPicPr>
              <a:picLocks noChangeAspect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40924" y="7147081"/>
              <a:ext cx="1327881" cy="1086806"/>
            </a:xfrm>
            <a:prstGeom prst="rect">
              <a:avLst/>
            </a:prstGeom>
          </p:spPr>
        </p:pic>
        <p:pic>
          <p:nvPicPr>
            <p:cNvPr id="119" name="그림 118"/>
            <p:cNvPicPr>
              <a:picLocks noChangeAspect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3995" y="7147081"/>
              <a:ext cx="1327881" cy="1086806"/>
            </a:xfrm>
            <a:prstGeom prst="rect">
              <a:avLst/>
            </a:prstGeom>
          </p:spPr>
        </p:pic>
        <p:sp>
          <p:nvSpPr>
            <p:cNvPr id="120" name="TextBox 119"/>
            <p:cNvSpPr txBox="1"/>
            <p:nvPr/>
          </p:nvSpPr>
          <p:spPr>
            <a:xfrm>
              <a:off x="2871208" y="7614002"/>
              <a:ext cx="43221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2956537" y="7525925"/>
              <a:ext cx="34848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478218" y="7526589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3547934" y="7529676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직사각형 123"/>
            <p:cNvSpPr/>
            <p:nvPr/>
          </p:nvSpPr>
          <p:spPr>
            <a:xfrm>
              <a:off x="3473342" y="7653415"/>
              <a:ext cx="157110" cy="7566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4183060" y="7613105"/>
              <a:ext cx="47093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4227734" y="7525028"/>
              <a:ext cx="427861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4828789" y="752569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4898504" y="7528779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직사각형 128"/>
            <p:cNvSpPr/>
            <p:nvPr/>
          </p:nvSpPr>
          <p:spPr>
            <a:xfrm>
              <a:off x="4823913" y="7652518"/>
              <a:ext cx="157110" cy="7566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30" name="직사각형 129"/>
            <p:cNvSpPr/>
            <p:nvPr/>
          </p:nvSpPr>
          <p:spPr>
            <a:xfrm>
              <a:off x="2370117" y="1083719"/>
              <a:ext cx="154639" cy="5262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2375165" y="952498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2445252" y="956723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직사각형 132"/>
            <p:cNvSpPr/>
            <p:nvPr/>
          </p:nvSpPr>
          <p:spPr>
            <a:xfrm>
              <a:off x="3748662" y="1083456"/>
              <a:ext cx="154639" cy="5262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755306" y="95325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3825393" y="95747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직사각형 135"/>
            <p:cNvSpPr/>
            <p:nvPr/>
          </p:nvSpPr>
          <p:spPr>
            <a:xfrm>
              <a:off x="5099710" y="1085668"/>
              <a:ext cx="154639" cy="5262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5104796" y="95447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5174883" y="95869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직사각형 138"/>
            <p:cNvSpPr/>
            <p:nvPr/>
          </p:nvSpPr>
          <p:spPr>
            <a:xfrm>
              <a:off x="2370117" y="2156693"/>
              <a:ext cx="150825" cy="6417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2376141" y="203816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443796" y="2042718"/>
              <a:ext cx="7682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직사각형 141"/>
            <p:cNvSpPr/>
            <p:nvPr/>
          </p:nvSpPr>
          <p:spPr>
            <a:xfrm>
              <a:off x="3746522" y="2156693"/>
              <a:ext cx="150825" cy="6417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3749585" y="203739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3817241" y="2041948"/>
              <a:ext cx="7682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직사각형 144"/>
            <p:cNvSpPr/>
            <p:nvPr/>
          </p:nvSpPr>
          <p:spPr>
            <a:xfrm>
              <a:off x="5107989" y="2158450"/>
              <a:ext cx="150825" cy="6417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5112447" y="2037686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5180102" y="2042242"/>
              <a:ext cx="7682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직사각형 147"/>
            <p:cNvSpPr/>
            <p:nvPr/>
          </p:nvSpPr>
          <p:spPr>
            <a:xfrm>
              <a:off x="2097061" y="3262360"/>
              <a:ext cx="168564" cy="6255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2106955" y="3146059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2174489" y="3150164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직사각형 150"/>
            <p:cNvSpPr/>
            <p:nvPr/>
          </p:nvSpPr>
          <p:spPr>
            <a:xfrm>
              <a:off x="3471995" y="3259279"/>
              <a:ext cx="168564" cy="6255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3480369" y="314451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3547903" y="3148621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직사각형 153"/>
            <p:cNvSpPr/>
            <p:nvPr/>
          </p:nvSpPr>
          <p:spPr>
            <a:xfrm>
              <a:off x="4824931" y="3258024"/>
              <a:ext cx="168564" cy="6255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4835661" y="314293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903194" y="3147036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직사각형 156"/>
            <p:cNvSpPr/>
            <p:nvPr/>
          </p:nvSpPr>
          <p:spPr>
            <a:xfrm>
              <a:off x="2101936" y="4364624"/>
              <a:ext cx="151806" cy="5932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2106282" y="4238661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2180625" y="424420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직사각형 159"/>
            <p:cNvSpPr/>
            <p:nvPr/>
          </p:nvSpPr>
          <p:spPr>
            <a:xfrm>
              <a:off x="3477987" y="4361534"/>
              <a:ext cx="151806" cy="5932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3481290" y="423899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3555634" y="4244531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직사각형 162"/>
            <p:cNvSpPr/>
            <p:nvPr/>
          </p:nvSpPr>
          <p:spPr>
            <a:xfrm>
              <a:off x="4836434" y="4359308"/>
              <a:ext cx="151806" cy="59322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64" name="TextBox 163"/>
            <p:cNvSpPr txBox="1"/>
            <p:nvPr/>
          </p:nvSpPr>
          <p:spPr>
            <a:xfrm>
              <a:off x="4836109" y="4234459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4910453" y="4239998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직사각형 165"/>
            <p:cNvSpPr/>
            <p:nvPr/>
          </p:nvSpPr>
          <p:spPr>
            <a:xfrm>
              <a:off x="2355950" y="6557724"/>
              <a:ext cx="152265" cy="6092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7" name="TextBox 166"/>
            <p:cNvSpPr txBox="1"/>
            <p:nvPr/>
          </p:nvSpPr>
          <p:spPr>
            <a:xfrm>
              <a:off x="2358522" y="6440346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2429168" y="6443717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직사각형 168"/>
            <p:cNvSpPr/>
            <p:nvPr/>
          </p:nvSpPr>
          <p:spPr>
            <a:xfrm>
              <a:off x="3732032" y="6554506"/>
              <a:ext cx="152265" cy="6092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3733684" y="643826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3804330" y="6441633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직사각형 171"/>
            <p:cNvSpPr/>
            <p:nvPr/>
          </p:nvSpPr>
          <p:spPr>
            <a:xfrm>
              <a:off x="5087839" y="6551566"/>
              <a:ext cx="152265" cy="6092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5090231" y="6439258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4" name="TextBox 173"/>
            <p:cNvSpPr txBox="1"/>
            <p:nvPr/>
          </p:nvSpPr>
          <p:spPr>
            <a:xfrm>
              <a:off x="5160876" y="6442629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5" name="그림 174"/>
            <p:cNvPicPr>
              <a:picLocks noChangeAspect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4130" y="4942005"/>
              <a:ext cx="1327881" cy="1086806"/>
            </a:xfrm>
            <a:prstGeom prst="rect">
              <a:avLst/>
            </a:prstGeom>
          </p:spPr>
        </p:pic>
        <p:pic>
          <p:nvPicPr>
            <p:cNvPr id="176" name="그림 175"/>
            <p:cNvPicPr>
              <a:picLocks noChangeAspect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3272" y="4938346"/>
              <a:ext cx="1327881" cy="1086806"/>
            </a:xfrm>
            <a:prstGeom prst="rect">
              <a:avLst/>
            </a:prstGeom>
          </p:spPr>
        </p:pic>
        <p:sp>
          <p:nvSpPr>
            <p:cNvPr id="177" name="직사각형 176"/>
            <p:cNvSpPr/>
            <p:nvPr/>
          </p:nvSpPr>
          <p:spPr>
            <a:xfrm>
              <a:off x="2023746" y="5432474"/>
              <a:ext cx="152272" cy="5545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2026998" y="525172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2098197" y="5254584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2931531" y="5381782"/>
              <a:ext cx="34959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직사각형 180"/>
            <p:cNvSpPr/>
            <p:nvPr/>
          </p:nvSpPr>
          <p:spPr>
            <a:xfrm>
              <a:off x="3662260" y="5430655"/>
              <a:ext cx="152272" cy="5545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2919879" y="5249394"/>
              <a:ext cx="36238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3665107" y="525022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3736306" y="5253078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직사각형 184"/>
            <p:cNvSpPr/>
            <p:nvPr/>
          </p:nvSpPr>
          <p:spPr>
            <a:xfrm>
              <a:off x="3395642" y="5430655"/>
              <a:ext cx="152272" cy="5545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3398894" y="5249907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3470093" y="525276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4291459" y="5378256"/>
              <a:ext cx="34950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직사각형 188"/>
            <p:cNvSpPr/>
            <p:nvPr/>
          </p:nvSpPr>
          <p:spPr>
            <a:xfrm>
              <a:off x="5022100" y="5427129"/>
              <a:ext cx="152272" cy="5545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4312250" y="5245868"/>
              <a:ext cx="32984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Hyp</a:t>
              </a:r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TextBox 190"/>
            <p:cNvSpPr txBox="1"/>
            <p:nvPr/>
          </p:nvSpPr>
          <p:spPr>
            <a:xfrm>
              <a:off x="5024947" y="5246694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5096146" y="524955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직사각형 192"/>
            <p:cNvSpPr/>
            <p:nvPr/>
          </p:nvSpPr>
          <p:spPr>
            <a:xfrm>
              <a:off x="4755482" y="5427129"/>
              <a:ext cx="152272" cy="5545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4758734" y="5246381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4829932" y="5249239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2373938" y="7527680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2443654" y="7530767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직사각형 197"/>
            <p:cNvSpPr/>
            <p:nvPr/>
          </p:nvSpPr>
          <p:spPr>
            <a:xfrm>
              <a:off x="2369062" y="7654506"/>
              <a:ext cx="157110" cy="7566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3753781" y="7525028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3823497" y="7528115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직사각형 200"/>
            <p:cNvSpPr/>
            <p:nvPr/>
          </p:nvSpPr>
          <p:spPr>
            <a:xfrm>
              <a:off x="3748906" y="7651854"/>
              <a:ext cx="157110" cy="7566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5106242" y="7525492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5175958" y="7528579"/>
              <a:ext cx="747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직사각형 203"/>
            <p:cNvSpPr/>
            <p:nvPr/>
          </p:nvSpPr>
          <p:spPr>
            <a:xfrm>
              <a:off x="5101366" y="7652318"/>
              <a:ext cx="157110" cy="7566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</p:grpSp>
      <p:sp>
        <p:nvSpPr>
          <p:cNvPr id="205" name="TextBox 204"/>
          <p:cNvSpPr txBox="1"/>
          <p:nvPr/>
        </p:nvSpPr>
        <p:spPr>
          <a:xfrm>
            <a:off x="2530249" y="81984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>
            <a:off x="2486364" y="1900973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5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TextBox 207"/>
          <p:cNvSpPr txBox="1"/>
          <p:nvPr/>
        </p:nvSpPr>
        <p:spPr>
          <a:xfrm>
            <a:off x="2476125" y="3009902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2488663" y="4111619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TextBox 209"/>
          <p:cNvSpPr txBox="1"/>
          <p:nvPr/>
        </p:nvSpPr>
        <p:spPr>
          <a:xfrm>
            <a:off x="2455314" y="5172806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TextBox 210"/>
          <p:cNvSpPr txBox="1"/>
          <p:nvPr/>
        </p:nvSpPr>
        <p:spPr>
          <a:xfrm>
            <a:off x="2464239" y="6298323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2480850" y="7403245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10088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172576" y="6143107"/>
            <a:ext cx="4480295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S12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he original figure of western blots of Figure 3a. The red box indicated the representative bands of protein levels in Fig. 3a. Protein expression of HIF-1α, Par3, TJP1 and Par6b i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HSC-2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line treated with siRNA-HIF-1</a:t>
            </a:r>
            <a:r>
              <a:rPr lang="el-GR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or control siRNA by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western blotting. GAPDH was used as the interna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. 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1172578" y="323899"/>
            <a:ext cx="4505528" cy="5813398"/>
            <a:chOff x="1172578" y="323899"/>
            <a:chExt cx="4505528" cy="5813398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4567" y="5026054"/>
              <a:ext cx="1349092" cy="1104167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4567" y="2777931"/>
              <a:ext cx="1349092" cy="1104167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4567" y="1651930"/>
              <a:ext cx="1349092" cy="1104167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5511" y="3901881"/>
              <a:ext cx="1349092" cy="1104167"/>
            </a:xfrm>
            <a:prstGeom prst="rect">
              <a:avLst/>
            </a:prstGeom>
          </p:spPr>
        </p:pic>
        <p:pic>
          <p:nvPicPr>
            <p:cNvPr id="9" name="그림 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34567" y="531081"/>
              <a:ext cx="1349092" cy="1104167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 rot="16200000">
              <a:off x="908385" y="966117"/>
              <a:ext cx="1104167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9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906187" y="2093589"/>
              <a:ext cx="11041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900" b="1" dirty="0"/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-1512895" y="3214919"/>
              <a:ext cx="560177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C2</a:t>
              </a:r>
              <a:endParaRPr lang="ko-KR" altLang="en-US" sz="900" b="1" dirty="0"/>
            </a:p>
          </p:txBody>
        </p:sp>
        <p:cxnSp>
          <p:nvCxnSpPr>
            <p:cNvPr id="13" name="직선 연결선 12"/>
            <p:cNvCxnSpPr/>
            <p:nvPr/>
          </p:nvCxnSpPr>
          <p:spPr>
            <a:xfrm flipH="1">
              <a:off x="1361496" y="541374"/>
              <a:ext cx="4016" cy="559592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TextBox 13"/>
            <p:cNvSpPr txBox="1"/>
            <p:nvPr/>
          </p:nvSpPr>
          <p:spPr>
            <a:xfrm>
              <a:off x="1543125" y="323899"/>
              <a:ext cx="1363525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ko-KR" altLang="en-US" sz="9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928349" y="324326"/>
              <a:ext cx="1363525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 exposure</a:t>
              </a:r>
              <a:endParaRPr lang="ko-KR" altLang="en-US" sz="9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314581" y="325467"/>
              <a:ext cx="1363525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 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xposure</a:t>
              </a:r>
              <a:endParaRPr lang="ko-KR" altLang="en-US" sz="900" b="1" dirty="0"/>
            </a:p>
          </p:txBody>
        </p:sp>
        <p:sp>
          <p:nvSpPr>
            <p:cNvPr id="17" name="직사각형 16"/>
            <p:cNvSpPr/>
            <p:nvPr/>
          </p:nvSpPr>
          <p:spPr>
            <a:xfrm>
              <a:off x="1875307" y="2149050"/>
              <a:ext cx="154230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588662" y="2112080"/>
              <a:ext cx="33148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474655" y="829770"/>
              <a:ext cx="457161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554432" y="884804"/>
              <a:ext cx="37305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929255" y="82562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009487" y="82903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직사각형 22"/>
            <p:cNvSpPr/>
            <p:nvPr/>
          </p:nvSpPr>
          <p:spPr>
            <a:xfrm>
              <a:off x="1921309" y="936371"/>
              <a:ext cx="157109" cy="5346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471583" y="1979217"/>
              <a:ext cx="44907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884525" y="197838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954720" y="198179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6200000">
              <a:off x="897957" y="3217253"/>
              <a:ext cx="11041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9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602507" y="3206896"/>
              <a:ext cx="35930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484645" y="3120502"/>
              <a:ext cx="47372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931061" y="3119660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004003" y="312337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직사각형 31"/>
            <p:cNvSpPr/>
            <p:nvPr/>
          </p:nvSpPr>
          <p:spPr>
            <a:xfrm>
              <a:off x="1921309" y="3245392"/>
              <a:ext cx="162753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573872" y="4442265"/>
              <a:ext cx="37184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1899964" y="4503511"/>
              <a:ext cx="154230" cy="4659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499755" y="4253104"/>
              <a:ext cx="44596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1905491" y="425615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1972064" y="425921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897053" y="4340917"/>
              <a:ext cx="11041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900" b="1" dirty="0"/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896247" y="5463726"/>
              <a:ext cx="11041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900" b="1" dirty="0"/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1527167" y="5403835"/>
              <a:ext cx="38304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직사각형 40"/>
            <p:cNvSpPr/>
            <p:nvPr/>
          </p:nvSpPr>
          <p:spPr>
            <a:xfrm>
              <a:off x="1859234" y="5452421"/>
              <a:ext cx="148604" cy="5573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463399" y="5325164"/>
              <a:ext cx="44777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856659" y="532516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936272" y="5328116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5" name="그림 4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34581" y="531081"/>
              <a:ext cx="1349092" cy="1104167"/>
            </a:xfrm>
            <a:prstGeom prst="rect">
              <a:avLst/>
            </a:prstGeom>
          </p:spPr>
        </p:pic>
        <p:pic>
          <p:nvPicPr>
            <p:cNvPr id="46" name="그림 4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11190" y="531169"/>
              <a:ext cx="1349092" cy="1104167"/>
            </a:xfrm>
            <a:prstGeom prst="rect">
              <a:avLst/>
            </a:prstGeom>
          </p:spPr>
        </p:pic>
        <p:sp>
          <p:nvSpPr>
            <p:cNvPr id="47" name="TextBox 46"/>
            <p:cNvSpPr txBox="1"/>
            <p:nvPr/>
          </p:nvSpPr>
          <p:spPr>
            <a:xfrm>
              <a:off x="2902975" y="829770"/>
              <a:ext cx="43110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2910089" y="884804"/>
              <a:ext cx="41966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329271" y="82562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3400515" y="82903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직사각형 50"/>
            <p:cNvSpPr/>
            <p:nvPr/>
          </p:nvSpPr>
          <p:spPr>
            <a:xfrm>
              <a:off x="3323573" y="936371"/>
              <a:ext cx="157109" cy="5346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215043" y="828903"/>
              <a:ext cx="49178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259666" y="883938"/>
              <a:ext cx="44283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704267" y="82475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784499" y="82816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직사각형 55"/>
            <p:cNvSpPr/>
            <p:nvPr/>
          </p:nvSpPr>
          <p:spPr>
            <a:xfrm>
              <a:off x="4696321" y="935504"/>
              <a:ext cx="157109" cy="5346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pic>
          <p:nvPicPr>
            <p:cNvPr id="57" name="그림 56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8349" y="3904248"/>
              <a:ext cx="1349092" cy="1104167"/>
            </a:xfrm>
            <a:prstGeom prst="rect">
              <a:avLst/>
            </a:prstGeom>
          </p:spPr>
        </p:pic>
        <p:pic>
          <p:nvPicPr>
            <p:cNvPr id="58" name="그림 5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17339" y="3904248"/>
              <a:ext cx="1349092" cy="1104167"/>
            </a:xfrm>
            <a:prstGeom prst="rect">
              <a:avLst/>
            </a:prstGeom>
          </p:spPr>
        </p:pic>
        <p:sp>
          <p:nvSpPr>
            <p:cNvPr id="59" name="TextBox 58"/>
            <p:cNvSpPr txBox="1"/>
            <p:nvPr/>
          </p:nvSpPr>
          <p:spPr>
            <a:xfrm>
              <a:off x="2956213" y="4442265"/>
              <a:ext cx="3828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직사각형 59"/>
            <p:cNvSpPr/>
            <p:nvPr/>
          </p:nvSpPr>
          <p:spPr>
            <a:xfrm>
              <a:off x="3293348" y="4503511"/>
              <a:ext cx="154230" cy="4659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2882862" y="4253104"/>
              <a:ext cx="45624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298876" y="425615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365449" y="425921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289167" y="4442265"/>
              <a:ext cx="438791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직사각형 64"/>
            <p:cNvSpPr/>
            <p:nvPr/>
          </p:nvSpPr>
          <p:spPr>
            <a:xfrm>
              <a:off x="4682202" y="4503511"/>
              <a:ext cx="154230" cy="4659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283025" y="4253104"/>
              <a:ext cx="44493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687730" y="425615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4754303" y="425921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직사각형 68"/>
            <p:cNvSpPr/>
            <p:nvPr/>
          </p:nvSpPr>
          <p:spPr>
            <a:xfrm>
              <a:off x="2202786" y="939796"/>
              <a:ext cx="157109" cy="5346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2210755" y="823946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279751" y="827356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직사각형 71"/>
            <p:cNvSpPr/>
            <p:nvPr/>
          </p:nvSpPr>
          <p:spPr>
            <a:xfrm>
              <a:off x="3605257" y="935504"/>
              <a:ext cx="157109" cy="5346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611887" y="823681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3683131" y="827091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직사각형 74"/>
            <p:cNvSpPr/>
            <p:nvPr/>
          </p:nvSpPr>
          <p:spPr>
            <a:xfrm>
              <a:off x="4981198" y="932851"/>
              <a:ext cx="157109" cy="53460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985971" y="82506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059461" y="82847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2192812" y="3120063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2265754" y="312377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0" name="직사각형 79"/>
            <p:cNvSpPr/>
            <p:nvPr/>
          </p:nvSpPr>
          <p:spPr>
            <a:xfrm>
              <a:off x="2177113" y="4501370"/>
              <a:ext cx="154230" cy="4659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188375" y="425577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254948" y="4258831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직사각형 82"/>
            <p:cNvSpPr/>
            <p:nvPr/>
          </p:nvSpPr>
          <p:spPr>
            <a:xfrm>
              <a:off x="3575236" y="4501370"/>
              <a:ext cx="154230" cy="4659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588538" y="425577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655111" y="4258831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직사각형 85"/>
            <p:cNvSpPr/>
            <p:nvPr/>
          </p:nvSpPr>
          <p:spPr>
            <a:xfrm>
              <a:off x="4964074" y="4503461"/>
              <a:ext cx="154230" cy="4659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4975829" y="425603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5042402" y="425909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9" name="그림 88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6137" y="1651758"/>
              <a:ext cx="1349092" cy="1104167"/>
            </a:xfrm>
            <a:prstGeom prst="rect">
              <a:avLst/>
            </a:prstGeom>
          </p:spPr>
        </p:pic>
        <p:pic>
          <p:nvPicPr>
            <p:cNvPr id="90" name="그림 89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09171" y="1649977"/>
              <a:ext cx="1349092" cy="1104167"/>
            </a:xfrm>
            <a:prstGeom prst="rect">
              <a:avLst/>
            </a:prstGeom>
          </p:spPr>
        </p:pic>
        <p:sp>
          <p:nvSpPr>
            <p:cNvPr id="91" name="직사각형 90"/>
            <p:cNvSpPr/>
            <p:nvPr/>
          </p:nvSpPr>
          <p:spPr>
            <a:xfrm>
              <a:off x="2157379" y="2149874"/>
              <a:ext cx="154230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166597" y="197920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2236792" y="198261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직사각형 93"/>
            <p:cNvSpPr/>
            <p:nvPr/>
          </p:nvSpPr>
          <p:spPr>
            <a:xfrm>
              <a:off x="3268756" y="2149050"/>
              <a:ext cx="154230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2949544" y="2112080"/>
              <a:ext cx="36405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2863154" y="1979217"/>
              <a:ext cx="45095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277974" y="197838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341637" y="198179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직사각형 98"/>
            <p:cNvSpPr/>
            <p:nvPr/>
          </p:nvSpPr>
          <p:spPr>
            <a:xfrm>
              <a:off x="3550827" y="2149874"/>
              <a:ext cx="154230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3560046" y="197920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3630241" y="198261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직사각형 101"/>
            <p:cNvSpPr/>
            <p:nvPr/>
          </p:nvSpPr>
          <p:spPr>
            <a:xfrm>
              <a:off x="4655472" y="2148720"/>
              <a:ext cx="154230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4293897" y="2111750"/>
              <a:ext cx="40641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4270339" y="1978887"/>
              <a:ext cx="4304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4654893" y="197805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4725087" y="198146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직사각형 106"/>
            <p:cNvSpPr/>
            <p:nvPr/>
          </p:nvSpPr>
          <p:spPr>
            <a:xfrm>
              <a:off x="4937544" y="2149544"/>
              <a:ext cx="154230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4943496" y="197887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5013691" y="198228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0" name="그림 10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5100" y="2777931"/>
              <a:ext cx="1349092" cy="1104167"/>
            </a:xfrm>
            <a:prstGeom prst="rect">
              <a:avLst/>
            </a:prstGeom>
          </p:spPr>
        </p:pic>
        <p:pic>
          <p:nvPicPr>
            <p:cNvPr id="111" name="그림 110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03779" y="2777770"/>
              <a:ext cx="1349092" cy="1104167"/>
            </a:xfrm>
            <a:prstGeom prst="rect">
              <a:avLst/>
            </a:prstGeom>
          </p:spPr>
        </p:pic>
        <p:sp>
          <p:nvSpPr>
            <p:cNvPr id="112" name="직사각형 111"/>
            <p:cNvSpPr/>
            <p:nvPr/>
          </p:nvSpPr>
          <p:spPr>
            <a:xfrm>
              <a:off x="2189173" y="3246068"/>
              <a:ext cx="162753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978364" y="3210738"/>
              <a:ext cx="37674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2886967" y="3124343"/>
              <a:ext cx="46470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3324358" y="312350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3397300" y="3127217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직사각형 116"/>
            <p:cNvSpPr/>
            <p:nvPr/>
          </p:nvSpPr>
          <p:spPr>
            <a:xfrm>
              <a:off x="3314606" y="3249234"/>
              <a:ext cx="162753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3586109" y="312390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659051" y="3127620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직사각형 119"/>
            <p:cNvSpPr/>
            <p:nvPr/>
          </p:nvSpPr>
          <p:spPr>
            <a:xfrm>
              <a:off x="3582470" y="3249910"/>
              <a:ext cx="162753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4288487" y="3206291"/>
              <a:ext cx="44253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4243864" y="3119896"/>
              <a:ext cx="48371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4700265" y="311905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4773207" y="3122769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직사각형 124"/>
            <p:cNvSpPr/>
            <p:nvPr/>
          </p:nvSpPr>
          <p:spPr>
            <a:xfrm>
              <a:off x="4690513" y="3244786"/>
              <a:ext cx="162753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4962016" y="3119457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5034958" y="312317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직사각형 127"/>
            <p:cNvSpPr/>
            <p:nvPr/>
          </p:nvSpPr>
          <p:spPr>
            <a:xfrm>
              <a:off x="4958377" y="3245462"/>
              <a:ext cx="162753" cy="7689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pic>
          <p:nvPicPr>
            <p:cNvPr id="129" name="그림 128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5100" y="5023787"/>
              <a:ext cx="1349092" cy="1104167"/>
            </a:xfrm>
            <a:prstGeom prst="rect">
              <a:avLst/>
            </a:prstGeom>
          </p:spPr>
        </p:pic>
        <p:pic>
          <p:nvPicPr>
            <p:cNvPr id="130" name="그림 12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14581" y="5026977"/>
              <a:ext cx="1349092" cy="1104167"/>
            </a:xfrm>
            <a:prstGeom prst="rect">
              <a:avLst/>
            </a:prstGeom>
          </p:spPr>
        </p:pic>
        <p:sp>
          <p:nvSpPr>
            <p:cNvPr id="131" name="직사각형 130"/>
            <p:cNvSpPr/>
            <p:nvPr/>
          </p:nvSpPr>
          <p:spPr>
            <a:xfrm>
              <a:off x="2139207" y="5452962"/>
              <a:ext cx="148604" cy="5573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bg1"/>
                </a:solidFill>
              </a:endParaRPr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2136632" y="5325706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2216245" y="532865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2784527" y="5400903"/>
              <a:ext cx="51560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직사각형 134"/>
            <p:cNvSpPr/>
            <p:nvPr/>
          </p:nvSpPr>
          <p:spPr>
            <a:xfrm>
              <a:off x="3249156" y="5449489"/>
              <a:ext cx="148604" cy="5573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2847445" y="5322232"/>
              <a:ext cx="45365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246581" y="5322232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3326194" y="5325185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직사각형 138"/>
            <p:cNvSpPr/>
            <p:nvPr/>
          </p:nvSpPr>
          <p:spPr>
            <a:xfrm>
              <a:off x="3529129" y="5450031"/>
              <a:ext cx="148604" cy="5573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3526553" y="532277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3606166" y="5325726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4256941" y="5403835"/>
              <a:ext cx="43633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직사각형 142"/>
            <p:cNvSpPr/>
            <p:nvPr/>
          </p:nvSpPr>
          <p:spPr>
            <a:xfrm>
              <a:off x="4642291" y="5452421"/>
              <a:ext cx="148604" cy="5573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4173240" y="5325164"/>
              <a:ext cx="52099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4639715" y="5325164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4719328" y="5328116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직사각형 146"/>
            <p:cNvSpPr/>
            <p:nvPr/>
          </p:nvSpPr>
          <p:spPr>
            <a:xfrm>
              <a:off x="4922263" y="5452962"/>
              <a:ext cx="148604" cy="55735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919688" y="5325706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4999301" y="5328658"/>
              <a:ext cx="7598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0" name="TextBox 149"/>
          <p:cNvSpPr txBox="1"/>
          <p:nvPr/>
        </p:nvSpPr>
        <p:spPr>
          <a:xfrm>
            <a:off x="2456421" y="211250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464170" y="320583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487711" y="4449202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446226" y="539948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2509269" y="889582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7570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143780" y="6135715"/>
            <a:ext cx="4513639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Additional file 2: Figure 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13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he original figure of western blots of Figure 3a. The red box indicated the representative bands of protein levels in Fig. 3a. Protein expression of HIF-1α, Par3, TJP1 and Par6b in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SCC-9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lin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reated with siRNA-HIF-1</a:t>
            </a:r>
            <a:r>
              <a:rPr lang="el-GR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 or control siRNA by western blotting. GAPDH was used as the interna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control. 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4" name="그림 15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023" y="1635180"/>
            <a:ext cx="1359954" cy="1113061"/>
          </a:xfrm>
          <a:prstGeom prst="rect">
            <a:avLst/>
          </a:prstGeom>
        </p:spPr>
      </p:pic>
      <p:pic>
        <p:nvPicPr>
          <p:cNvPr id="155" name="그림 15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188" y="2766372"/>
            <a:ext cx="1359954" cy="1113061"/>
          </a:xfrm>
          <a:prstGeom prst="rect">
            <a:avLst/>
          </a:prstGeom>
        </p:spPr>
      </p:pic>
      <p:pic>
        <p:nvPicPr>
          <p:cNvPr id="156" name="그림 15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5622" y="3899097"/>
            <a:ext cx="1359954" cy="1113061"/>
          </a:xfrm>
          <a:prstGeom prst="rect">
            <a:avLst/>
          </a:prstGeom>
        </p:spPr>
      </p:pic>
      <p:pic>
        <p:nvPicPr>
          <p:cNvPr id="157" name="그림 15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023" y="505186"/>
            <a:ext cx="1359954" cy="1113061"/>
          </a:xfrm>
          <a:prstGeom prst="rect">
            <a:avLst/>
          </a:prstGeom>
        </p:spPr>
      </p:pic>
      <p:pic>
        <p:nvPicPr>
          <p:cNvPr id="158" name="그림 15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8699" y="5030289"/>
            <a:ext cx="1359954" cy="1113061"/>
          </a:xfrm>
          <a:prstGeom prst="rect">
            <a:avLst/>
          </a:prstGeom>
        </p:spPr>
      </p:pic>
      <p:sp>
        <p:nvSpPr>
          <p:cNvPr id="159" name="TextBox 158"/>
          <p:cNvSpPr txBox="1"/>
          <p:nvPr/>
        </p:nvSpPr>
        <p:spPr>
          <a:xfrm rot="16200000">
            <a:off x="876530" y="942864"/>
            <a:ext cx="1113061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900" b="1" dirty="0"/>
          </a:p>
        </p:txBody>
      </p:sp>
      <p:sp>
        <p:nvSpPr>
          <p:cNvPr id="160" name="TextBox 159"/>
          <p:cNvSpPr txBox="1"/>
          <p:nvPr/>
        </p:nvSpPr>
        <p:spPr>
          <a:xfrm rot="16200000">
            <a:off x="874315" y="2079416"/>
            <a:ext cx="111306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900" b="1" dirty="0"/>
          </a:p>
        </p:txBody>
      </p:sp>
      <p:sp>
        <p:nvSpPr>
          <p:cNvPr id="161" name="TextBox 160"/>
          <p:cNvSpPr txBox="1"/>
          <p:nvPr/>
        </p:nvSpPr>
        <p:spPr>
          <a:xfrm rot="16200000">
            <a:off x="-1564252" y="3209778"/>
            <a:ext cx="564689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CC9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직선 연결선 161"/>
          <p:cNvCxnSpPr/>
          <p:nvPr/>
        </p:nvCxnSpPr>
        <p:spPr>
          <a:xfrm flipH="1">
            <a:off x="1333290" y="513769"/>
            <a:ext cx="4049" cy="564099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/>
          <p:cNvSpPr txBox="1"/>
          <p:nvPr/>
        </p:nvSpPr>
        <p:spPr>
          <a:xfrm>
            <a:off x="1516382" y="295473"/>
            <a:ext cx="1374504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900" b="1" dirty="0"/>
          </a:p>
        </p:txBody>
      </p:sp>
      <p:sp>
        <p:nvSpPr>
          <p:cNvPr id="164" name="TextBox 163"/>
          <p:cNvSpPr txBox="1"/>
          <p:nvPr/>
        </p:nvSpPr>
        <p:spPr>
          <a:xfrm>
            <a:off x="2912759" y="295903"/>
            <a:ext cx="1374504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 exposure</a:t>
            </a:r>
            <a:endParaRPr lang="ko-KR" altLang="en-US" sz="900" b="1" dirty="0"/>
          </a:p>
        </p:txBody>
      </p:sp>
      <p:sp>
        <p:nvSpPr>
          <p:cNvPr id="165" name="TextBox 164"/>
          <p:cNvSpPr txBox="1"/>
          <p:nvPr/>
        </p:nvSpPr>
        <p:spPr>
          <a:xfrm>
            <a:off x="4310152" y="297054"/>
            <a:ext cx="1374504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ko-KR" altLang="en-US" sz="900" b="1" dirty="0"/>
          </a:p>
        </p:txBody>
      </p:sp>
      <p:sp>
        <p:nvSpPr>
          <p:cNvPr id="166" name="직사각형 165"/>
          <p:cNvSpPr/>
          <p:nvPr/>
        </p:nvSpPr>
        <p:spPr>
          <a:xfrm>
            <a:off x="1896842" y="2151773"/>
            <a:ext cx="155472" cy="6119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67" name="TextBox 166"/>
          <p:cNvSpPr txBox="1"/>
          <p:nvPr/>
        </p:nvSpPr>
        <p:spPr>
          <a:xfrm>
            <a:off x="1535178" y="2102550"/>
            <a:ext cx="40767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1450192" y="859706"/>
            <a:ext cx="45859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1498359" y="939218"/>
            <a:ext cx="40491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1850213" y="860448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1922779" y="863540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직사각형 171"/>
          <p:cNvSpPr/>
          <p:nvPr/>
        </p:nvSpPr>
        <p:spPr>
          <a:xfrm>
            <a:off x="1841796" y="984463"/>
            <a:ext cx="158374" cy="707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3" name="TextBox 172"/>
          <p:cNvSpPr txBox="1"/>
          <p:nvPr/>
        </p:nvSpPr>
        <p:spPr>
          <a:xfrm>
            <a:off x="1481342" y="2049187"/>
            <a:ext cx="46897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1904986" y="2049282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1977927" y="2053625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 rot="16200000">
            <a:off x="866018" y="3212131"/>
            <a:ext cx="11130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900" b="1" dirty="0"/>
          </a:p>
        </p:txBody>
      </p:sp>
      <p:sp>
        <p:nvSpPr>
          <p:cNvPr id="177" name="TextBox 176"/>
          <p:cNvSpPr txBox="1"/>
          <p:nvPr/>
        </p:nvSpPr>
        <p:spPr>
          <a:xfrm>
            <a:off x="1602806" y="3272421"/>
            <a:ext cx="33864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>
            <a:off x="1481189" y="3119564"/>
            <a:ext cx="46417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1883051" y="3120099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Box 179"/>
          <p:cNvSpPr txBox="1"/>
          <p:nvPr/>
        </p:nvSpPr>
        <p:spPr>
          <a:xfrm>
            <a:off x="1951390" y="312259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직사각형 180"/>
          <p:cNvSpPr/>
          <p:nvPr/>
        </p:nvSpPr>
        <p:spPr>
          <a:xfrm>
            <a:off x="1881248" y="3317983"/>
            <a:ext cx="155472" cy="7751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2" name="TextBox 181"/>
          <p:cNvSpPr txBox="1"/>
          <p:nvPr/>
        </p:nvSpPr>
        <p:spPr>
          <a:xfrm>
            <a:off x="1509950" y="4332424"/>
            <a:ext cx="41033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직사각형 182"/>
          <p:cNvSpPr/>
          <p:nvPr/>
        </p:nvSpPr>
        <p:spPr>
          <a:xfrm>
            <a:off x="1877417" y="4374832"/>
            <a:ext cx="159303" cy="6907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84" name="TextBox 183"/>
          <p:cNvSpPr txBox="1"/>
          <p:nvPr/>
        </p:nvSpPr>
        <p:spPr>
          <a:xfrm>
            <a:off x="1452009" y="4260194"/>
            <a:ext cx="47162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>
            <a:off x="1886793" y="4255224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" name="TextBox 185"/>
          <p:cNvSpPr txBox="1"/>
          <p:nvPr/>
        </p:nvSpPr>
        <p:spPr>
          <a:xfrm>
            <a:off x="1953902" y="4258308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" name="TextBox 186"/>
          <p:cNvSpPr txBox="1"/>
          <p:nvPr/>
        </p:nvSpPr>
        <p:spPr>
          <a:xfrm rot="16200000">
            <a:off x="865107" y="4344845"/>
            <a:ext cx="11130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900" b="1" dirty="0"/>
          </a:p>
        </p:txBody>
      </p:sp>
      <p:sp>
        <p:nvSpPr>
          <p:cNvPr id="188" name="TextBox 187"/>
          <p:cNvSpPr txBox="1"/>
          <p:nvPr/>
        </p:nvSpPr>
        <p:spPr>
          <a:xfrm rot="16200000">
            <a:off x="864294" y="5476698"/>
            <a:ext cx="111306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b="1" dirty="0"/>
          </a:p>
        </p:txBody>
      </p:sp>
      <p:sp>
        <p:nvSpPr>
          <p:cNvPr id="189" name="TextBox 188"/>
          <p:cNvSpPr txBox="1"/>
          <p:nvPr/>
        </p:nvSpPr>
        <p:spPr>
          <a:xfrm>
            <a:off x="1514527" y="5416314"/>
            <a:ext cx="37618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직사각형 189"/>
          <p:cNvSpPr/>
          <p:nvPr/>
        </p:nvSpPr>
        <p:spPr>
          <a:xfrm>
            <a:off x="1828934" y="5443806"/>
            <a:ext cx="161882" cy="890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91" name="TextBox 190"/>
          <p:cNvSpPr txBox="1"/>
          <p:nvPr/>
        </p:nvSpPr>
        <p:spPr>
          <a:xfrm>
            <a:off x="1458627" y="5328692"/>
            <a:ext cx="43645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" name="TextBox 191"/>
          <p:cNvSpPr txBox="1"/>
          <p:nvPr/>
        </p:nvSpPr>
        <p:spPr>
          <a:xfrm>
            <a:off x="1832164" y="5328692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/>
          <p:cNvSpPr txBox="1"/>
          <p:nvPr/>
        </p:nvSpPr>
        <p:spPr>
          <a:xfrm>
            <a:off x="1912417" y="533166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4" name="그림 193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9805" y="5032350"/>
            <a:ext cx="1359954" cy="1113061"/>
          </a:xfrm>
          <a:prstGeom prst="rect">
            <a:avLst/>
          </a:prstGeom>
        </p:spPr>
      </p:pic>
      <p:pic>
        <p:nvPicPr>
          <p:cNvPr id="195" name="그림 19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6734" y="5030289"/>
            <a:ext cx="1359954" cy="1113061"/>
          </a:xfrm>
          <a:prstGeom prst="rect">
            <a:avLst/>
          </a:prstGeom>
        </p:spPr>
      </p:pic>
      <p:pic>
        <p:nvPicPr>
          <p:cNvPr id="196" name="그림 19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4909" y="502674"/>
            <a:ext cx="1359954" cy="1113061"/>
          </a:xfrm>
          <a:prstGeom prst="rect">
            <a:avLst/>
          </a:prstGeom>
          <a:ln>
            <a:noFill/>
          </a:ln>
        </p:spPr>
      </p:pic>
      <p:pic>
        <p:nvPicPr>
          <p:cNvPr id="197" name="그림 19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5196" y="501745"/>
            <a:ext cx="1359954" cy="1113061"/>
          </a:xfrm>
          <a:prstGeom prst="rect">
            <a:avLst/>
          </a:prstGeom>
          <a:ln>
            <a:noFill/>
          </a:ln>
        </p:spPr>
      </p:pic>
      <p:sp>
        <p:nvSpPr>
          <p:cNvPr id="198" name="TextBox 197"/>
          <p:cNvSpPr txBox="1"/>
          <p:nvPr/>
        </p:nvSpPr>
        <p:spPr>
          <a:xfrm>
            <a:off x="2825107" y="859024"/>
            <a:ext cx="48831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" name="TextBox 198"/>
          <p:cNvSpPr txBox="1"/>
          <p:nvPr/>
        </p:nvSpPr>
        <p:spPr>
          <a:xfrm>
            <a:off x="2902495" y="938537"/>
            <a:ext cx="41256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" name="TextBox 199"/>
          <p:cNvSpPr txBox="1"/>
          <p:nvPr/>
        </p:nvSpPr>
        <p:spPr>
          <a:xfrm>
            <a:off x="3261993" y="859766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" name="TextBox 200"/>
          <p:cNvSpPr txBox="1"/>
          <p:nvPr/>
        </p:nvSpPr>
        <p:spPr>
          <a:xfrm>
            <a:off x="3334559" y="862858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직사각형 201"/>
          <p:cNvSpPr/>
          <p:nvPr/>
        </p:nvSpPr>
        <p:spPr>
          <a:xfrm>
            <a:off x="3253576" y="983781"/>
            <a:ext cx="158374" cy="707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4236095" y="857693"/>
            <a:ext cx="47439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4338041" y="937205"/>
            <a:ext cx="36694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>
            <a:off x="4651919" y="858435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/>
          <p:cNvSpPr txBox="1"/>
          <p:nvPr/>
        </p:nvSpPr>
        <p:spPr>
          <a:xfrm>
            <a:off x="4724485" y="86152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직사각형 206"/>
          <p:cNvSpPr/>
          <p:nvPr/>
        </p:nvSpPr>
        <p:spPr>
          <a:xfrm>
            <a:off x="4643502" y="982450"/>
            <a:ext cx="158374" cy="707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pic>
        <p:nvPicPr>
          <p:cNvPr id="208" name="그림 20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8808" y="3901611"/>
            <a:ext cx="1359954" cy="1113061"/>
          </a:xfrm>
          <a:prstGeom prst="rect">
            <a:avLst/>
          </a:prstGeom>
        </p:spPr>
      </p:pic>
      <p:pic>
        <p:nvPicPr>
          <p:cNvPr id="209" name="그림 20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7597" y="3900621"/>
            <a:ext cx="1359954" cy="1113061"/>
          </a:xfrm>
          <a:prstGeom prst="rect">
            <a:avLst/>
          </a:prstGeom>
        </p:spPr>
      </p:pic>
      <p:sp>
        <p:nvSpPr>
          <p:cNvPr id="210" name="TextBox 209"/>
          <p:cNvSpPr txBox="1"/>
          <p:nvPr/>
        </p:nvSpPr>
        <p:spPr>
          <a:xfrm>
            <a:off x="2976896" y="4335502"/>
            <a:ext cx="35052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직사각형 210"/>
          <p:cNvSpPr/>
          <p:nvPr/>
        </p:nvSpPr>
        <p:spPr>
          <a:xfrm>
            <a:off x="3284546" y="4377911"/>
            <a:ext cx="159303" cy="6907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12" name="TextBox 211"/>
          <p:cNvSpPr txBox="1"/>
          <p:nvPr/>
        </p:nvSpPr>
        <p:spPr>
          <a:xfrm>
            <a:off x="2880314" y="4263272"/>
            <a:ext cx="45045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3" name="TextBox 212"/>
          <p:cNvSpPr txBox="1"/>
          <p:nvPr/>
        </p:nvSpPr>
        <p:spPr>
          <a:xfrm>
            <a:off x="3293923" y="4258303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/>
          <p:cNvSpPr txBox="1"/>
          <p:nvPr/>
        </p:nvSpPr>
        <p:spPr>
          <a:xfrm>
            <a:off x="3361032" y="426138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5" name="TextBox 214"/>
          <p:cNvSpPr txBox="1"/>
          <p:nvPr/>
        </p:nvSpPr>
        <p:spPr>
          <a:xfrm>
            <a:off x="4307532" y="4333352"/>
            <a:ext cx="40740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직사각형 215"/>
          <p:cNvSpPr/>
          <p:nvPr/>
        </p:nvSpPr>
        <p:spPr>
          <a:xfrm>
            <a:off x="4672070" y="4375760"/>
            <a:ext cx="159303" cy="6907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17" name="TextBox 216"/>
          <p:cNvSpPr txBox="1"/>
          <p:nvPr/>
        </p:nvSpPr>
        <p:spPr>
          <a:xfrm>
            <a:off x="4233862" y="4261122"/>
            <a:ext cx="48442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/>
          <p:cNvSpPr txBox="1"/>
          <p:nvPr/>
        </p:nvSpPr>
        <p:spPr>
          <a:xfrm>
            <a:off x="4681446" y="4256152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/>
          <p:cNvSpPr txBox="1"/>
          <p:nvPr/>
        </p:nvSpPr>
        <p:spPr>
          <a:xfrm>
            <a:off x="4748555" y="4259236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0" name="TextBox 219"/>
          <p:cNvSpPr txBox="1"/>
          <p:nvPr/>
        </p:nvSpPr>
        <p:spPr>
          <a:xfrm>
            <a:off x="2848659" y="5416314"/>
            <a:ext cx="43730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직사각형 220"/>
          <p:cNvSpPr/>
          <p:nvPr/>
        </p:nvSpPr>
        <p:spPr>
          <a:xfrm>
            <a:off x="3228353" y="5443806"/>
            <a:ext cx="161882" cy="890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22" name="TextBox 221"/>
          <p:cNvSpPr txBox="1"/>
          <p:nvPr/>
        </p:nvSpPr>
        <p:spPr>
          <a:xfrm>
            <a:off x="2821201" y="5328692"/>
            <a:ext cx="46912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3" name="TextBox 222"/>
          <p:cNvSpPr txBox="1"/>
          <p:nvPr/>
        </p:nvSpPr>
        <p:spPr>
          <a:xfrm>
            <a:off x="3227410" y="5328692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3307664" y="533166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4245957" y="5416314"/>
            <a:ext cx="43677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직사각형 225"/>
          <p:cNvSpPr/>
          <p:nvPr/>
        </p:nvSpPr>
        <p:spPr>
          <a:xfrm>
            <a:off x="4620945" y="5443806"/>
            <a:ext cx="161882" cy="890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4208613" y="5328692"/>
            <a:ext cx="47847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4624175" y="5328692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4704428" y="533166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직사각형 229"/>
          <p:cNvSpPr/>
          <p:nvPr/>
        </p:nvSpPr>
        <p:spPr>
          <a:xfrm>
            <a:off x="1841796" y="1176395"/>
            <a:ext cx="158374" cy="707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33" name="TextBox 232"/>
          <p:cNvSpPr txBox="1"/>
          <p:nvPr/>
        </p:nvSpPr>
        <p:spPr>
          <a:xfrm>
            <a:off x="1473768" y="1124438"/>
            <a:ext cx="43163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직사각형 233"/>
          <p:cNvSpPr/>
          <p:nvPr/>
        </p:nvSpPr>
        <p:spPr>
          <a:xfrm>
            <a:off x="3256450" y="1179409"/>
            <a:ext cx="158374" cy="707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37" name="TextBox 236"/>
          <p:cNvSpPr txBox="1"/>
          <p:nvPr/>
        </p:nvSpPr>
        <p:spPr>
          <a:xfrm>
            <a:off x="2960154" y="1130762"/>
            <a:ext cx="35490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직사각형 237"/>
          <p:cNvSpPr/>
          <p:nvPr/>
        </p:nvSpPr>
        <p:spPr>
          <a:xfrm>
            <a:off x="4648320" y="1177408"/>
            <a:ext cx="158374" cy="707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39" name="TextBox 238"/>
          <p:cNvSpPr txBox="1"/>
          <p:nvPr/>
        </p:nvSpPr>
        <p:spPr>
          <a:xfrm>
            <a:off x="4295776" y="1136147"/>
            <a:ext cx="41254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F1A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5" name="직사각형 244"/>
          <p:cNvSpPr/>
          <p:nvPr/>
        </p:nvSpPr>
        <p:spPr>
          <a:xfrm>
            <a:off x="2153767" y="4375054"/>
            <a:ext cx="159303" cy="6907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6" name="TextBox 245"/>
          <p:cNvSpPr txBox="1"/>
          <p:nvPr/>
        </p:nvSpPr>
        <p:spPr>
          <a:xfrm>
            <a:off x="2163143" y="4255446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7" name="TextBox 246"/>
          <p:cNvSpPr txBox="1"/>
          <p:nvPr/>
        </p:nvSpPr>
        <p:spPr>
          <a:xfrm>
            <a:off x="2230252" y="4258530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8" name="직사각형 247"/>
          <p:cNvSpPr/>
          <p:nvPr/>
        </p:nvSpPr>
        <p:spPr>
          <a:xfrm>
            <a:off x="3557079" y="4377646"/>
            <a:ext cx="159303" cy="6907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49" name="TextBox 248"/>
          <p:cNvSpPr txBox="1"/>
          <p:nvPr/>
        </p:nvSpPr>
        <p:spPr>
          <a:xfrm>
            <a:off x="3566456" y="4258038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0" name="TextBox 249"/>
          <p:cNvSpPr txBox="1"/>
          <p:nvPr/>
        </p:nvSpPr>
        <p:spPr>
          <a:xfrm>
            <a:off x="3633565" y="4261122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직사각형 250"/>
          <p:cNvSpPr/>
          <p:nvPr/>
        </p:nvSpPr>
        <p:spPr>
          <a:xfrm>
            <a:off x="4946093" y="4376413"/>
            <a:ext cx="159303" cy="6907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52" name="TextBox 251"/>
          <p:cNvSpPr txBox="1"/>
          <p:nvPr/>
        </p:nvSpPr>
        <p:spPr>
          <a:xfrm>
            <a:off x="4955469" y="4256805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3" name="TextBox 252"/>
          <p:cNvSpPr txBox="1"/>
          <p:nvPr/>
        </p:nvSpPr>
        <p:spPr>
          <a:xfrm>
            <a:off x="5022578" y="4259889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4" name="그림 253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97465" y="2764761"/>
            <a:ext cx="1359954" cy="1113061"/>
          </a:xfrm>
          <a:prstGeom prst="rect">
            <a:avLst/>
          </a:prstGeom>
        </p:spPr>
      </p:pic>
      <p:pic>
        <p:nvPicPr>
          <p:cNvPr id="255" name="그림 254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9984" y="2766458"/>
            <a:ext cx="1359954" cy="1113061"/>
          </a:xfrm>
          <a:prstGeom prst="rect">
            <a:avLst/>
          </a:prstGeom>
        </p:spPr>
      </p:pic>
      <p:sp>
        <p:nvSpPr>
          <p:cNvPr id="256" name="직사각형 255"/>
          <p:cNvSpPr/>
          <p:nvPr/>
        </p:nvSpPr>
        <p:spPr>
          <a:xfrm>
            <a:off x="1883234" y="3231762"/>
            <a:ext cx="155472" cy="7751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57" name="TextBox 256"/>
          <p:cNvSpPr txBox="1"/>
          <p:nvPr/>
        </p:nvSpPr>
        <p:spPr>
          <a:xfrm>
            <a:off x="2966746" y="3196200"/>
            <a:ext cx="37502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TextBox 257"/>
          <p:cNvSpPr txBox="1"/>
          <p:nvPr/>
        </p:nvSpPr>
        <p:spPr>
          <a:xfrm>
            <a:off x="2872605" y="3119564"/>
            <a:ext cx="47048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/>
          <p:cNvSpPr txBox="1"/>
          <p:nvPr/>
        </p:nvSpPr>
        <p:spPr>
          <a:xfrm>
            <a:off x="3283157" y="3120099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0" name="TextBox 259"/>
          <p:cNvSpPr txBox="1"/>
          <p:nvPr/>
        </p:nvSpPr>
        <p:spPr>
          <a:xfrm>
            <a:off x="3351496" y="312259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1" name="직사각형 260"/>
          <p:cNvSpPr/>
          <p:nvPr/>
        </p:nvSpPr>
        <p:spPr>
          <a:xfrm>
            <a:off x="3281354" y="3317983"/>
            <a:ext cx="155472" cy="7751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62" name="직사각형 261"/>
          <p:cNvSpPr/>
          <p:nvPr/>
        </p:nvSpPr>
        <p:spPr>
          <a:xfrm>
            <a:off x="3283340" y="3231762"/>
            <a:ext cx="155472" cy="7751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63" name="TextBox 262"/>
          <p:cNvSpPr txBox="1"/>
          <p:nvPr/>
        </p:nvSpPr>
        <p:spPr>
          <a:xfrm>
            <a:off x="4370704" y="3193842"/>
            <a:ext cx="34178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263"/>
          <p:cNvSpPr txBox="1"/>
          <p:nvPr/>
        </p:nvSpPr>
        <p:spPr>
          <a:xfrm>
            <a:off x="4264953" y="3121946"/>
            <a:ext cx="43954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64"/>
          <p:cNvSpPr txBox="1"/>
          <p:nvPr/>
        </p:nvSpPr>
        <p:spPr>
          <a:xfrm>
            <a:off x="4670762" y="3122481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265"/>
          <p:cNvSpPr txBox="1"/>
          <p:nvPr/>
        </p:nvSpPr>
        <p:spPr>
          <a:xfrm>
            <a:off x="4739101" y="3124980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직사각형 266"/>
          <p:cNvSpPr/>
          <p:nvPr/>
        </p:nvSpPr>
        <p:spPr>
          <a:xfrm>
            <a:off x="4668959" y="3320366"/>
            <a:ext cx="155472" cy="7751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68" name="직사각형 267"/>
          <p:cNvSpPr/>
          <p:nvPr/>
        </p:nvSpPr>
        <p:spPr>
          <a:xfrm>
            <a:off x="4670945" y="3234145"/>
            <a:ext cx="155472" cy="7751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pic>
        <p:nvPicPr>
          <p:cNvPr id="269" name="그림 268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8799" y="1633402"/>
            <a:ext cx="1359954" cy="1113061"/>
          </a:xfrm>
          <a:prstGeom prst="rect">
            <a:avLst/>
          </a:prstGeom>
        </p:spPr>
      </p:pic>
      <p:pic>
        <p:nvPicPr>
          <p:cNvPr id="270" name="그림 26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5024" y="1633402"/>
            <a:ext cx="1359954" cy="1113061"/>
          </a:xfrm>
          <a:prstGeom prst="rect">
            <a:avLst/>
          </a:prstGeom>
        </p:spPr>
      </p:pic>
      <p:sp>
        <p:nvSpPr>
          <p:cNvPr id="271" name="직사각형 270"/>
          <p:cNvSpPr/>
          <p:nvPr/>
        </p:nvSpPr>
        <p:spPr>
          <a:xfrm>
            <a:off x="2172232" y="2154081"/>
            <a:ext cx="155472" cy="6119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2" name="TextBox 271"/>
          <p:cNvSpPr txBox="1"/>
          <p:nvPr/>
        </p:nvSpPr>
        <p:spPr>
          <a:xfrm>
            <a:off x="2180376" y="2051590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/>
          <p:cNvSpPr txBox="1"/>
          <p:nvPr/>
        </p:nvSpPr>
        <p:spPr>
          <a:xfrm>
            <a:off x="2250935" y="2055933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4" name="직사각형 273"/>
          <p:cNvSpPr/>
          <p:nvPr/>
        </p:nvSpPr>
        <p:spPr>
          <a:xfrm>
            <a:off x="3311029" y="2149477"/>
            <a:ext cx="155472" cy="6119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75" name="TextBox 274"/>
          <p:cNvSpPr txBox="1"/>
          <p:nvPr/>
        </p:nvSpPr>
        <p:spPr>
          <a:xfrm>
            <a:off x="3000129" y="2100254"/>
            <a:ext cx="35690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Box 275"/>
          <p:cNvSpPr txBox="1"/>
          <p:nvPr/>
        </p:nvSpPr>
        <p:spPr>
          <a:xfrm>
            <a:off x="2911511" y="2046891"/>
            <a:ext cx="45298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276"/>
          <p:cNvSpPr txBox="1"/>
          <p:nvPr/>
        </p:nvSpPr>
        <p:spPr>
          <a:xfrm>
            <a:off x="3319173" y="2046986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/>
          <p:cNvSpPr txBox="1"/>
          <p:nvPr/>
        </p:nvSpPr>
        <p:spPr>
          <a:xfrm>
            <a:off x="3392113" y="2051329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직사각형 278"/>
          <p:cNvSpPr/>
          <p:nvPr/>
        </p:nvSpPr>
        <p:spPr>
          <a:xfrm>
            <a:off x="3586418" y="2151785"/>
            <a:ext cx="155472" cy="6119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80" name="TextBox 279"/>
          <p:cNvSpPr txBox="1"/>
          <p:nvPr/>
        </p:nvSpPr>
        <p:spPr>
          <a:xfrm>
            <a:off x="3592182" y="2049294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/>
          <p:cNvSpPr txBox="1"/>
          <p:nvPr/>
        </p:nvSpPr>
        <p:spPr>
          <a:xfrm>
            <a:off x="3660360" y="205363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직사각형 281"/>
          <p:cNvSpPr/>
          <p:nvPr/>
        </p:nvSpPr>
        <p:spPr>
          <a:xfrm>
            <a:off x="4701333" y="2150539"/>
            <a:ext cx="155472" cy="6119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83" name="TextBox 282"/>
          <p:cNvSpPr txBox="1"/>
          <p:nvPr/>
        </p:nvSpPr>
        <p:spPr>
          <a:xfrm>
            <a:off x="4363613" y="2101315"/>
            <a:ext cx="38372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4" name="TextBox 283"/>
          <p:cNvSpPr txBox="1"/>
          <p:nvPr/>
        </p:nvSpPr>
        <p:spPr>
          <a:xfrm>
            <a:off x="4311620" y="2047953"/>
            <a:ext cx="44318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TextBox 284"/>
          <p:cNvSpPr txBox="1"/>
          <p:nvPr/>
        </p:nvSpPr>
        <p:spPr>
          <a:xfrm>
            <a:off x="4707096" y="204804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6" name="TextBox 285"/>
          <p:cNvSpPr txBox="1"/>
          <p:nvPr/>
        </p:nvSpPr>
        <p:spPr>
          <a:xfrm>
            <a:off x="4782417" y="2052391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직사각형 286"/>
          <p:cNvSpPr/>
          <p:nvPr/>
        </p:nvSpPr>
        <p:spPr>
          <a:xfrm>
            <a:off x="4976722" y="2152847"/>
            <a:ext cx="155472" cy="61192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88" name="TextBox 287"/>
          <p:cNvSpPr txBox="1"/>
          <p:nvPr/>
        </p:nvSpPr>
        <p:spPr>
          <a:xfrm>
            <a:off x="4977724" y="2050355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/>
          <p:cNvSpPr txBox="1"/>
          <p:nvPr/>
        </p:nvSpPr>
        <p:spPr>
          <a:xfrm>
            <a:off x="5048283" y="2054699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직사각형 289"/>
          <p:cNvSpPr/>
          <p:nvPr/>
        </p:nvSpPr>
        <p:spPr>
          <a:xfrm>
            <a:off x="2101528" y="5443960"/>
            <a:ext cx="161882" cy="890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91" name="TextBox 290"/>
          <p:cNvSpPr txBox="1"/>
          <p:nvPr/>
        </p:nvSpPr>
        <p:spPr>
          <a:xfrm>
            <a:off x="2104757" y="5328846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2" name="TextBox 291"/>
          <p:cNvSpPr txBox="1"/>
          <p:nvPr/>
        </p:nvSpPr>
        <p:spPr>
          <a:xfrm>
            <a:off x="2185011" y="5331821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3" name="직사각형 292"/>
          <p:cNvSpPr/>
          <p:nvPr/>
        </p:nvSpPr>
        <p:spPr>
          <a:xfrm>
            <a:off x="3503384" y="5443486"/>
            <a:ext cx="161882" cy="890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94" name="TextBox 293"/>
          <p:cNvSpPr txBox="1"/>
          <p:nvPr/>
        </p:nvSpPr>
        <p:spPr>
          <a:xfrm>
            <a:off x="3502441" y="5328372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5" name="TextBox 294"/>
          <p:cNvSpPr txBox="1"/>
          <p:nvPr/>
        </p:nvSpPr>
        <p:spPr>
          <a:xfrm>
            <a:off x="3582695" y="5331347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6" name="직사각형 295"/>
          <p:cNvSpPr/>
          <p:nvPr/>
        </p:nvSpPr>
        <p:spPr>
          <a:xfrm>
            <a:off x="4899739" y="5442962"/>
            <a:ext cx="161882" cy="89063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297" name="TextBox 296"/>
          <p:cNvSpPr txBox="1"/>
          <p:nvPr/>
        </p:nvSpPr>
        <p:spPr>
          <a:xfrm>
            <a:off x="4902969" y="5327848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8" name="TextBox 297"/>
          <p:cNvSpPr txBox="1"/>
          <p:nvPr/>
        </p:nvSpPr>
        <p:spPr>
          <a:xfrm>
            <a:off x="4983223" y="5330824"/>
            <a:ext cx="7659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0" name="TextBox 299"/>
          <p:cNvSpPr txBox="1"/>
          <p:nvPr/>
        </p:nvSpPr>
        <p:spPr>
          <a:xfrm>
            <a:off x="4370703" y="3272732"/>
            <a:ext cx="34178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1" name="TextBox 300"/>
          <p:cNvSpPr txBox="1"/>
          <p:nvPr/>
        </p:nvSpPr>
        <p:spPr>
          <a:xfrm>
            <a:off x="2968689" y="3275717"/>
            <a:ext cx="37502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TextBox 301"/>
          <p:cNvSpPr txBox="1"/>
          <p:nvPr/>
        </p:nvSpPr>
        <p:spPr>
          <a:xfrm>
            <a:off x="1602191" y="3186014"/>
            <a:ext cx="338640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2463564" y="211250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2464748" y="318884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2390113" y="4332168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2424828" y="5419287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2420465" y="937205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2414823" y="1130800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2465274" y="327242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36080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1184970" y="6098137"/>
            <a:ext cx="4470183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Additional file 2: 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4.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The original figure of western blots of Figure 3a. The red box indicated the representative bands of protein levels in Fig. 3a. Protein expression of HIF-1α, Par3, TJP1 and Par6b in SCC-25 cell line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reated with siRNA-HIF-1</a:t>
            </a:r>
            <a:r>
              <a:rPr lang="el-GR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 or control siRNA by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blotting. GAPDH was used as the internal control. 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8" name="그룹 157"/>
          <p:cNvGrpSpPr>
            <a:grpSpLocks noChangeAspect="1"/>
          </p:cNvGrpSpPr>
          <p:nvPr/>
        </p:nvGrpSpPr>
        <p:grpSpPr>
          <a:xfrm>
            <a:off x="1184971" y="305081"/>
            <a:ext cx="4470182" cy="5767539"/>
            <a:chOff x="1184971" y="305081"/>
            <a:chExt cx="4470182" cy="5767539"/>
          </a:xfrm>
        </p:grpSpPr>
        <p:pic>
          <p:nvPicPr>
            <p:cNvPr id="4" name="그림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3644" y="4972163"/>
              <a:ext cx="1338229" cy="1095281"/>
            </a:xfrm>
            <a:prstGeom prst="rect">
              <a:avLst/>
            </a:prstGeom>
          </p:spPr>
        </p:pic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4256" y="3855459"/>
              <a:ext cx="1338229" cy="1095281"/>
            </a:xfrm>
            <a:prstGeom prst="rect">
              <a:avLst/>
            </a:prstGeom>
          </p:spPr>
        </p:pic>
        <p:pic>
          <p:nvPicPr>
            <p:cNvPr id="6" name="그림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4256" y="2742862"/>
              <a:ext cx="1338229" cy="1095281"/>
            </a:xfrm>
            <a:prstGeom prst="rect">
              <a:avLst/>
            </a:prstGeom>
          </p:spPr>
        </p:pic>
        <p:pic>
          <p:nvPicPr>
            <p:cNvPr id="7" name="그림 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4256" y="1627325"/>
              <a:ext cx="1338229" cy="1095281"/>
            </a:xfrm>
            <a:prstGeom prst="rect">
              <a:avLst/>
            </a:prstGeom>
          </p:spPr>
        </p:pic>
        <p:pic>
          <p:nvPicPr>
            <p:cNvPr id="8" name="그림 7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44256" y="513996"/>
              <a:ext cx="1338229" cy="1095281"/>
            </a:xfrm>
            <a:prstGeom prst="rect">
              <a:avLst/>
            </a:prstGeom>
          </p:spPr>
        </p:pic>
        <p:sp>
          <p:nvSpPr>
            <p:cNvPr id="9" name="TextBox 8"/>
            <p:cNvSpPr txBox="1"/>
            <p:nvPr/>
          </p:nvSpPr>
          <p:spPr>
            <a:xfrm rot="16200000">
              <a:off x="923834" y="942131"/>
              <a:ext cx="1095281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900" b="1" dirty="0"/>
            </a:p>
          </p:txBody>
        </p:sp>
        <p:sp>
          <p:nvSpPr>
            <p:cNvPr id="10" name="TextBox 9"/>
            <p:cNvSpPr txBox="1"/>
            <p:nvPr/>
          </p:nvSpPr>
          <p:spPr>
            <a:xfrm rot="16200000">
              <a:off x="921653" y="2060528"/>
              <a:ext cx="10952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900" b="1" dirty="0"/>
            </a:p>
          </p:txBody>
        </p:sp>
        <p:sp>
          <p:nvSpPr>
            <p:cNvPr id="11" name="TextBox 10"/>
            <p:cNvSpPr txBox="1"/>
            <p:nvPr/>
          </p:nvSpPr>
          <p:spPr>
            <a:xfrm rot="16200000">
              <a:off x="-1477960" y="3172834"/>
              <a:ext cx="555669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CC25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직선 연결선 11"/>
            <p:cNvCxnSpPr/>
            <p:nvPr/>
          </p:nvCxnSpPr>
          <p:spPr>
            <a:xfrm flipH="1">
              <a:off x="1373298" y="521734"/>
              <a:ext cx="3984" cy="555088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/>
            <p:cNvSpPr txBox="1"/>
            <p:nvPr/>
          </p:nvSpPr>
          <p:spPr>
            <a:xfrm>
              <a:off x="1553465" y="305081"/>
              <a:ext cx="1352547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rge</a:t>
              </a:r>
              <a:endParaRPr lang="ko-KR" altLang="en-US" sz="9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927536" y="305505"/>
              <a:ext cx="1352547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w exposure</a:t>
              </a:r>
              <a:endParaRPr lang="ko-KR" altLang="en-US" sz="9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302606" y="306637"/>
              <a:ext cx="1352547" cy="230832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gh </a:t>
              </a:r>
              <a:r>
                <a:rPr lang="en-US" altLang="ko-K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exposure</a:t>
              </a:r>
              <a:endParaRPr lang="ko-KR" altLang="en-US" sz="900" b="1" dirty="0"/>
            </a:p>
          </p:txBody>
        </p:sp>
        <p:sp>
          <p:nvSpPr>
            <p:cNvPr id="16" name="직사각형 15"/>
            <p:cNvSpPr/>
            <p:nvPr/>
          </p:nvSpPr>
          <p:spPr>
            <a:xfrm>
              <a:off x="1958217" y="2124831"/>
              <a:ext cx="152989" cy="6021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622807" y="2070609"/>
              <a:ext cx="349131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460430" y="871634"/>
              <a:ext cx="48011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595309" y="1055657"/>
              <a:ext cx="33225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138530" y="867520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218117" y="87090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2142479" y="1099920"/>
              <a:ext cx="155844" cy="6963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501594" y="1938816"/>
              <a:ext cx="48112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961203" y="193798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030832" y="194137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6200000">
              <a:off x="913490" y="3175149"/>
              <a:ext cx="10952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9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1541570" y="3141606"/>
              <a:ext cx="43289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483879" y="3048734"/>
              <a:ext cx="49047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241760" y="3044354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314115" y="304803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직사각형 30"/>
            <p:cNvSpPr/>
            <p:nvPr/>
          </p:nvSpPr>
          <p:spPr>
            <a:xfrm>
              <a:off x="2235720" y="3179634"/>
              <a:ext cx="152989" cy="762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1608494" y="4302816"/>
              <a:ext cx="35228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직사각형 32"/>
            <p:cNvSpPr/>
            <p:nvPr/>
          </p:nvSpPr>
          <p:spPr>
            <a:xfrm>
              <a:off x="2154245" y="4346204"/>
              <a:ext cx="156758" cy="6796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486991" y="4207084"/>
              <a:ext cx="4785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2163397" y="420599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229434" y="4209033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912593" y="4289769"/>
              <a:ext cx="10952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900" b="1" dirty="0"/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911793" y="5403542"/>
              <a:ext cx="109528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900" b="1" dirty="0"/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513488" y="5410408"/>
              <a:ext cx="40627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직사각형 39"/>
            <p:cNvSpPr/>
            <p:nvPr/>
          </p:nvSpPr>
          <p:spPr>
            <a:xfrm>
              <a:off x="2131841" y="5443538"/>
              <a:ext cx="159296" cy="8764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444494" y="5328819"/>
              <a:ext cx="479280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135019" y="5329034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213990" y="533196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그림 4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7536" y="509903"/>
              <a:ext cx="1338229" cy="109528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45" name="그림 44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03723" y="509386"/>
              <a:ext cx="1338229" cy="1095281"/>
            </a:xfrm>
            <a:prstGeom prst="rect">
              <a:avLst/>
            </a:prstGeom>
            <a:ln>
              <a:noFill/>
            </a:ln>
          </p:spPr>
        </p:pic>
        <p:sp>
          <p:nvSpPr>
            <p:cNvPr id="46" name="TextBox 45"/>
            <p:cNvSpPr txBox="1"/>
            <p:nvPr/>
          </p:nvSpPr>
          <p:spPr>
            <a:xfrm>
              <a:off x="2838623" y="867509"/>
              <a:ext cx="47754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>
              <a:off x="2971871" y="1051532"/>
              <a:ext cx="33131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3514157" y="863394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3593744" y="866777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직사각형 49"/>
            <p:cNvSpPr/>
            <p:nvPr/>
          </p:nvSpPr>
          <p:spPr>
            <a:xfrm>
              <a:off x="3518105" y="1095795"/>
              <a:ext cx="155844" cy="6963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4267950" y="867509"/>
              <a:ext cx="43490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4314930" y="1051532"/>
              <a:ext cx="37494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900842" y="863394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980429" y="866777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직사각형 54"/>
            <p:cNvSpPr/>
            <p:nvPr/>
          </p:nvSpPr>
          <p:spPr>
            <a:xfrm>
              <a:off x="4904790" y="1095795"/>
              <a:ext cx="155844" cy="6963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pic>
          <p:nvPicPr>
            <p:cNvPr id="56" name="그림 55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8158" y="1627325"/>
              <a:ext cx="1338229" cy="109528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7" name="그림 56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9243" y="1627325"/>
              <a:ext cx="1338229" cy="1095281"/>
            </a:xfrm>
            <a:prstGeom prst="rect">
              <a:avLst/>
            </a:prstGeom>
            <a:ln>
              <a:noFill/>
            </a:ln>
          </p:spPr>
        </p:pic>
        <p:sp>
          <p:nvSpPr>
            <p:cNvPr id="58" name="직사각형 57"/>
            <p:cNvSpPr/>
            <p:nvPr/>
          </p:nvSpPr>
          <p:spPr>
            <a:xfrm>
              <a:off x="3343159" y="2124831"/>
              <a:ext cx="152989" cy="6021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017573" y="2070609"/>
              <a:ext cx="33930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2880040" y="1938816"/>
              <a:ext cx="48761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3346145" y="193798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3415774" y="194137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직사각형 62"/>
            <p:cNvSpPr/>
            <p:nvPr/>
          </p:nvSpPr>
          <p:spPr>
            <a:xfrm>
              <a:off x="4709754" y="2124831"/>
              <a:ext cx="152989" cy="6021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328860" y="2070609"/>
              <a:ext cx="39461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3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207662" y="1938816"/>
              <a:ext cx="52658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712740" y="193798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4782369" y="194137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8" name="그림 67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8697" y="2737373"/>
              <a:ext cx="1338229" cy="109528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69" name="그림 68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9243" y="2737373"/>
              <a:ext cx="1338229" cy="1095281"/>
            </a:xfrm>
            <a:prstGeom prst="rect">
              <a:avLst/>
            </a:prstGeom>
            <a:ln>
              <a:noFill/>
            </a:ln>
          </p:spPr>
        </p:pic>
        <p:sp>
          <p:nvSpPr>
            <p:cNvPr id="70" name="TextBox 69"/>
            <p:cNvSpPr txBox="1"/>
            <p:nvPr/>
          </p:nvSpPr>
          <p:spPr>
            <a:xfrm>
              <a:off x="2969799" y="3140928"/>
              <a:ext cx="38939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2894456" y="3048056"/>
              <a:ext cx="46462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3626491" y="3043677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3698846" y="304736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직사각형 73"/>
            <p:cNvSpPr/>
            <p:nvPr/>
          </p:nvSpPr>
          <p:spPr>
            <a:xfrm>
              <a:off x="3620451" y="3178956"/>
              <a:ext cx="152989" cy="762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267863" y="3138347"/>
              <a:ext cx="46308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JP1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234335" y="3045475"/>
              <a:ext cx="496501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4998247" y="3041095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070603" y="3044780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" name="직사각형 78"/>
            <p:cNvSpPr/>
            <p:nvPr/>
          </p:nvSpPr>
          <p:spPr>
            <a:xfrm>
              <a:off x="4992208" y="3176375"/>
              <a:ext cx="152989" cy="762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pic>
          <p:nvPicPr>
            <p:cNvPr id="80" name="그림 79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7034" y="3853484"/>
              <a:ext cx="1338229" cy="1095281"/>
            </a:xfrm>
            <a:prstGeom prst="rect">
              <a:avLst/>
            </a:prstGeom>
            <a:ln>
              <a:noFill/>
            </a:ln>
          </p:spPr>
        </p:pic>
        <p:pic>
          <p:nvPicPr>
            <p:cNvPr id="81" name="그림 80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9243" y="3852223"/>
              <a:ext cx="1338229" cy="1095281"/>
            </a:xfrm>
            <a:prstGeom prst="rect">
              <a:avLst/>
            </a:prstGeom>
            <a:ln>
              <a:noFill/>
            </a:ln>
          </p:spPr>
        </p:pic>
        <p:sp>
          <p:nvSpPr>
            <p:cNvPr id="82" name="TextBox 81"/>
            <p:cNvSpPr txBox="1"/>
            <p:nvPr/>
          </p:nvSpPr>
          <p:spPr>
            <a:xfrm>
              <a:off x="2996707" y="4302816"/>
              <a:ext cx="35043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직사각형 82"/>
            <p:cNvSpPr/>
            <p:nvPr/>
          </p:nvSpPr>
          <p:spPr>
            <a:xfrm>
              <a:off x="3540610" y="4346204"/>
              <a:ext cx="156758" cy="6796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2893652" y="4207084"/>
              <a:ext cx="458296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3549762" y="420599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3615799" y="4209033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4288898" y="4302816"/>
              <a:ext cx="428263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직사각형 87"/>
            <p:cNvSpPr/>
            <p:nvPr/>
          </p:nvSpPr>
          <p:spPr>
            <a:xfrm>
              <a:off x="4910631" y="4346204"/>
              <a:ext cx="156758" cy="6796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4223364" y="4207084"/>
              <a:ext cx="49860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4919782" y="420599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4985819" y="4209033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직사각형 91"/>
            <p:cNvSpPr/>
            <p:nvPr/>
          </p:nvSpPr>
          <p:spPr>
            <a:xfrm>
              <a:off x="2138635" y="995919"/>
              <a:ext cx="155844" cy="6963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1568035" y="952160"/>
              <a:ext cx="360079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2964907" y="952160"/>
              <a:ext cx="33828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직사각형 94"/>
            <p:cNvSpPr/>
            <p:nvPr/>
          </p:nvSpPr>
          <p:spPr>
            <a:xfrm>
              <a:off x="3519922" y="993303"/>
              <a:ext cx="155844" cy="6963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325386" y="952043"/>
              <a:ext cx="36521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IF1A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직사각형 96"/>
            <p:cNvSpPr/>
            <p:nvPr/>
          </p:nvSpPr>
          <p:spPr>
            <a:xfrm>
              <a:off x="4895588" y="987701"/>
              <a:ext cx="155844" cy="69633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98" name="직사각형 97"/>
            <p:cNvSpPr/>
            <p:nvPr/>
          </p:nvSpPr>
          <p:spPr>
            <a:xfrm>
              <a:off x="2221828" y="2127713"/>
              <a:ext cx="152989" cy="6021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2230020" y="1937973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2299650" y="1941355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직사각형 100"/>
            <p:cNvSpPr/>
            <p:nvPr/>
          </p:nvSpPr>
          <p:spPr>
            <a:xfrm>
              <a:off x="3608067" y="2125512"/>
              <a:ext cx="152989" cy="6021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611063" y="1937973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680693" y="1941355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직사각형 103"/>
            <p:cNvSpPr/>
            <p:nvPr/>
          </p:nvSpPr>
          <p:spPr>
            <a:xfrm>
              <a:off x="4978880" y="2124831"/>
              <a:ext cx="152989" cy="60214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4981805" y="1937973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5051434" y="1941355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직사각형 106"/>
            <p:cNvSpPr/>
            <p:nvPr/>
          </p:nvSpPr>
          <p:spPr>
            <a:xfrm>
              <a:off x="1973219" y="3181974"/>
              <a:ext cx="152989" cy="762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1977828" y="3043677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2050184" y="304736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직사각형 109"/>
            <p:cNvSpPr/>
            <p:nvPr/>
          </p:nvSpPr>
          <p:spPr>
            <a:xfrm>
              <a:off x="3353814" y="3176375"/>
              <a:ext cx="152989" cy="762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361298" y="3042045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3433654" y="304572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직사각형 112"/>
            <p:cNvSpPr/>
            <p:nvPr/>
          </p:nvSpPr>
          <p:spPr>
            <a:xfrm>
              <a:off x="4726458" y="3176209"/>
              <a:ext cx="152989" cy="76276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730507" y="304041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802862" y="3044097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직사각형 115"/>
            <p:cNvSpPr/>
            <p:nvPr/>
          </p:nvSpPr>
          <p:spPr>
            <a:xfrm>
              <a:off x="2155456" y="4508007"/>
              <a:ext cx="156758" cy="6796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1526012" y="4464090"/>
              <a:ext cx="43363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2996881" y="4461477"/>
              <a:ext cx="34714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직사각형 121"/>
            <p:cNvSpPr/>
            <p:nvPr/>
          </p:nvSpPr>
          <p:spPr>
            <a:xfrm>
              <a:off x="3537499" y="4504865"/>
              <a:ext cx="156758" cy="6796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3546651" y="436465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3612687" y="4367694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4288682" y="4464270"/>
              <a:ext cx="428718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r6b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직사각형 126"/>
            <p:cNvSpPr/>
            <p:nvPr/>
          </p:nvSpPr>
          <p:spPr>
            <a:xfrm>
              <a:off x="4910870" y="4507659"/>
              <a:ext cx="156758" cy="67967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4920022" y="4367453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4986059" y="4370488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6" name="그림 135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24629" y="4971315"/>
              <a:ext cx="1338229" cy="1095281"/>
            </a:xfrm>
            <a:prstGeom prst="rect">
              <a:avLst/>
            </a:prstGeom>
          </p:spPr>
        </p:pic>
        <p:pic>
          <p:nvPicPr>
            <p:cNvPr id="137" name="그림 136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03723" y="4971315"/>
              <a:ext cx="1338229" cy="1095281"/>
            </a:xfrm>
            <a:prstGeom prst="rect">
              <a:avLst/>
            </a:prstGeom>
          </p:spPr>
        </p:pic>
        <p:sp>
          <p:nvSpPr>
            <p:cNvPr id="138" name="직사각형 137"/>
            <p:cNvSpPr/>
            <p:nvPr/>
          </p:nvSpPr>
          <p:spPr>
            <a:xfrm>
              <a:off x="1863627" y="5443041"/>
              <a:ext cx="159296" cy="8764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1866805" y="5328537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1945777" y="5331465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935643" y="5410754"/>
              <a:ext cx="36884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직사각형 141"/>
            <p:cNvSpPr/>
            <p:nvPr/>
          </p:nvSpPr>
          <p:spPr>
            <a:xfrm>
              <a:off x="3516567" y="5443884"/>
              <a:ext cx="159296" cy="8764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2840393" y="5329164"/>
              <a:ext cx="468107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3519745" y="5329379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3598717" y="5332308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직사각형 145"/>
            <p:cNvSpPr/>
            <p:nvPr/>
          </p:nvSpPr>
          <p:spPr>
            <a:xfrm>
              <a:off x="3248354" y="5443386"/>
              <a:ext cx="159296" cy="8764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251532" y="532888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330503" y="5331810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4261283" y="5410408"/>
              <a:ext cx="415042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직사각형 149"/>
            <p:cNvSpPr/>
            <p:nvPr/>
          </p:nvSpPr>
          <p:spPr>
            <a:xfrm>
              <a:off x="4888404" y="5443538"/>
              <a:ext cx="159296" cy="8764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4237293" y="5328819"/>
              <a:ext cx="443044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siR-HIF1A: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4891582" y="5329034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4970554" y="5331962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직사각형 153"/>
            <p:cNvSpPr/>
            <p:nvPr/>
          </p:nvSpPr>
          <p:spPr>
            <a:xfrm>
              <a:off x="4620191" y="5443041"/>
              <a:ext cx="159296" cy="87641"/>
            </a:xfrm>
            <a:prstGeom prst="rect">
              <a:avLst/>
            </a:prstGeom>
            <a:noFill/>
            <a:ln>
              <a:solidFill>
                <a:srgbClr val="FF00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>
                <a:solidFill>
                  <a:schemeClr val="tx1"/>
                </a:solidFill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4623369" y="5328537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4702340" y="5331465"/>
              <a:ext cx="75375" cy="153888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7" name="TextBox 156"/>
          <p:cNvSpPr txBox="1"/>
          <p:nvPr/>
        </p:nvSpPr>
        <p:spPr>
          <a:xfrm>
            <a:off x="2468321" y="2070474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2484062" y="3138347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/>
          <p:cNvSpPr txBox="1"/>
          <p:nvPr/>
        </p:nvSpPr>
        <p:spPr>
          <a:xfrm>
            <a:off x="2473458" y="4461477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TextBox 160"/>
          <p:cNvSpPr txBox="1"/>
          <p:nvPr/>
        </p:nvSpPr>
        <p:spPr>
          <a:xfrm>
            <a:off x="2446587" y="5414485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2438417" y="951264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2470412" y="4303229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2437600" y="1058057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93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973345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1163212" y="6128281"/>
            <a:ext cx="4505529" cy="91563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1">
              <a:lnSpc>
                <a:spcPct val="107000"/>
              </a:lnSpc>
              <a:spcAft>
                <a:spcPts val="800"/>
              </a:spcAft>
            </a:pPr>
            <a:r>
              <a:rPr lang="en-US" altLang="ko-KR" sz="1000" b="1" kern="100" dirty="0">
                <a:latin typeface="Arial" panose="020B0604020202020204" pitchFamily="34" charset="0"/>
                <a:cs typeface="Arial" panose="020B0604020202020204" pitchFamily="34" charset="0"/>
              </a:rPr>
              <a:t>Additional file 2: </a:t>
            </a:r>
            <a:r>
              <a:rPr lang="en-US" altLang="ko-KR" sz="1000" b="1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Figure S15.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The original figure of western blots of Figure 4a. The red box indicated the representative bands of protein levels in Fig. 4a. Protein expression of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, TJP1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Par6b and </a:t>
            </a:r>
            <a:r>
              <a:rPr lang="en-US" altLang="ko-KR" sz="1000" kern="1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 in HSC-2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cell </a:t>
            </a:r>
            <a:r>
              <a:rPr lang="en-US" altLang="ko-KR" sz="1000" kern="100" dirty="0" smtClean="0">
                <a:latin typeface="Arial" panose="020B0604020202020204" pitchFamily="34" charset="0"/>
                <a:cs typeface="Arial" panose="020B0604020202020204" pitchFamily="34" charset="0"/>
              </a:rPr>
              <a:t>line treated with siRNA-Par3 or control siRNA </a:t>
            </a:r>
            <a:r>
              <a:rPr lang="en-US" altLang="ko-KR" sz="1000" kern="100" dirty="0">
                <a:latin typeface="Arial" panose="020B0604020202020204" pitchFamily="34" charset="0"/>
                <a:cs typeface="Arial" panose="020B0604020202020204" pitchFamily="34" charset="0"/>
              </a:rPr>
              <a:t>by western blotting. GAPDH was used as the internal control. </a:t>
            </a:r>
            <a:endParaRPr lang="ko-KR" altLang="ko-KR" sz="1000" b="1" kern="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319" y="2766722"/>
            <a:ext cx="1349092" cy="1104167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319" y="3889116"/>
            <a:ext cx="1349092" cy="1104167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202" y="5012295"/>
            <a:ext cx="1349092" cy="1104167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202" y="1642338"/>
            <a:ext cx="1349092" cy="1104167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6290" y="520362"/>
            <a:ext cx="1349092" cy="110416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 rot="16200000">
            <a:off x="891148" y="952253"/>
            <a:ext cx="1104167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900" b="1" dirty="0"/>
          </a:p>
        </p:txBody>
      </p:sp>
      <p:sp>
        <p:nvSpPr>
          <p:cNvPr id="11" name="TextBox 10"/>
          <p:cNvSpPr txBox="1"/>
          <p:nvPr/>
        </p:nvSpPr>
        <p:spPr>
          <a:xfrm rot="16200000">
            <a:off x="888950" y="2079725"/>
            <a:ext cx="11041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  <a:endParaRPr lang="ko-KR" altLang="en-US" sz="900" b="1" dirty="0"/>
          </a:p>
        </p:txBody>
      </p:sp>
      <p:sp>
        <p:nvSpPr>
          <p:cNvPr id="12" name="TextBox 11"/>
          <p:cNvSpPr txBox="1"/>
          <p:nvPr/>
        </p:nvSpPr>
        <p:spPr>
          <a:xfrm rot="16200000">
            <a:off x="-1522260" y="3201055"/>
            <a:ext cx="5601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SC2</a:t>
            </a:r>
            <a:endParaRPr lang="ko-KR" altLang="en-US" sz="900" b="1" dirty="0"/>
          </a:p>
        </p:txBody>
      </p:sp>
      <p:cxnSp>
        <p:nvCxnSpPr>
          <p:cNvPr id="13" name="직선 연결선 12"/>
          <p:cNvCxnSpPr/>
          <p:nvPr/>
        </p:nvCxnSpPr>
        <p:spPr>
          <a:xfrm flipH="1">
            <a:off x="1352131" y="527510"/>
            <a:ext cx="4016" cy="559592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533760" y="310035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ko-KR" altLang="en-US" sz="9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2918984" y="310462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ow exposure</a:t>
            </a:r>
            <a:endParaRPr lang="ko-KR" altLang="en-US" sz="9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4305216" y="311603"/>
            <a:ext cx="1363525" cy="230832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igh 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exposure</a:t>
            </a:r>
            <a:endParaRPr lang="ko-KR" altLang="en-US" sz="900" b="1" dirty="0"/>
          </a:p>
        </p:txBody>
      </p:sp>
      <p:sp>
        <p:nvSpPr>
          <p:cNvPr id="17" name="직사각형 16"/>
          <p:cNvSpPr/>
          <p:nvPr/>
        </p:nvSpPr>
        <p:spPr>
          <a:xfrm>
            <a:off x="2138407" y="2156406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573357" y="2117478"/>
            <a:ext cx="33920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548315" y="872142"/>
            <a:ext cx="41405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592408" y="988851"/>
            <a:ext cx="36381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947101" y="86799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014636" y="87140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직사각형 22"/>
          <p:cNvSpPr/>
          <p:nvPr/>
        </p:nvSpPr>
        <p:spPr>
          <a:xfrm>
            <a:off x="1940969" y="1040418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1474056" y="2008832"/>
            <a:ext cx="44072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147440" y="200517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217635" y="200858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888592" y="3203389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9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1626502" y="3246100"/>
            <a:ext cx="33785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45067" y="3148023"/>
            <a:ext cx="42640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958633" y="314802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029400" y="315376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직사각형 31"/>
          <p:cNvSpPr/>
          <p:nvPr/>
        </p:nvSpPr>
        <p:spPr>
          <a:xfrm>
            <a:off x="1958445" y="3283457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1557841" y="4456127"/>
            <a:ext cx="36310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직사각형 33"/>
          <p:cNvSpPr/>
          <p:nvPr/>
        </p:nvSpPr>
        <p:spPr>
          <a:xfrm>
            <a:off x="1858524" y="4510065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498607" y="4222280"/>
            <a:ext cx="41643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864766" y="421971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936767" y="422355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 rot="16200000">
            <a:off x="887688" y="4327053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900" b="1" dirty="0"/>
          </a:p>
        </p:txBody>
      </p:sp>
      <p:sp>
        <p:nvSpPr>
          <p:cNvPr id="39" name="TextBox 38"/>
          <p:cNvSpPr txBox="1"/>
          <p:nvPr/>
        </p:nvSpPr>
        <p:spPr>
          <a:xfrm rot="16200000">
            <a:off x="886882" y="5449862"/>
            <a:ext cx="110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9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1517252" y="5394905"/>
            <a:ext cx="44912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직사각형 40"/>
          <p:cNvSpPr/>
          <p:nvPr/>
        </p:nvSpPr>
        <p:spPr>
          <a:xfrm>
            <a:off x="2210892" y="5441830"/>
            <a:ext cx="172965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494320" y="5314573"/>
            <a:ext cx="47651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2225419" y="531242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2294276" y="531537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5" name="그림 44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8984" y="521390"/>
            <a:ext cx="1349092" cy="1104167"/>
          </a:xfrm>
          <a:prstGeom prst="rect">
            <a:avLst/>
          </a:prstGeom>
        </p:spPr>
      </p:pic>
      <p:pic>
        <p:nvPicPr>
          <p:cNvPr id="46" name="그림 4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6346" y="520362"/>
            <a:ext cx="1349092" cy="1104167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2918814" y="872142"/>
            <a:ext cx="43773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035383" y="988851"/>
            <a:ext cx="31501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341278" y="86799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3408813" y="87140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직사각형 50"/>
          <p:cNvSpPr/>
          <p:nvPr/>
        </p:nvSpPr>
        <p:spPr>
          <a:xfrm>
            <a:off x="3335146" y="1040418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335153" y="872044"/>
            <a:ext cx="40885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384475" y="988754"/>
            <a:ext cx="35339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3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728742" y="86789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796277" y="87130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직사각형 55"/>
          <p:cNvSpPr/>
          <p:nvPr/>
        </p:nvSpPr>
        <p:spPr>
          <a:xfrm>
            <a:off x="4722610" y="1040320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pic>
        <p:nvPicPr>
          <p:cNvPr id="57" name="그림 5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8984" y="1642965"/>
            <a:ext cx="1349092" cy="1104167"/>
          </a:xfrm>
          <a:prstGeom prst="rect">
            <a:avLst/>
          </a:prstGeom>
        </p:spPr>
      </p:pic>
      <p:pic>
        <p:nvPicPr>
          <p:cNvPr id="58" name="그림 57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1185" y="1643047"/>
            <a:ext cx="1349092" cy="1104167"/>
          </a:xfrm>
          <a:prstGeom prst="rect">
            <a:avLst/>
          </a:prstGeom>
        </p:spPr>
      </p:pic>
      <p:sp>
        <p:nvSpPr>
          <p:cNvPr id="59" name="직사각형 58"/>
          <p:cNvSpPr/>
          <p:nvPr/>
        </p:nvSpPr>
        <p:spPr>
          <a:xfrm>
            <a:off x="3532740" y="2156406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2970351" y="2117478"/>
            <a:ext cx="33654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2887695" y="2008832"/>
            <a:ext cx="4214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541773" y="200517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611967" y="2008581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직사각형 63"/>
          <p:cNvSpPr/>
          <p:nvPr/>
        </p:nvSpPr>
        <p:spPr>
          <a:xfrm>
            <a:off x="4914610" y="2158085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4283012" y="2119157"/>
            <a:ext cx="405754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TJP1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4301557" y="2010511"/>
            <a:ext cx="38942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923643" y="200685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4993838" y="201026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그림 6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8984" y="5009439"/>
            <a:ext cx="1349092" cy="1104167"/>
          </a:xfrm>
          <a:prstGeom prst="rect">
            <a:avLst/>
          </a:prstGeom>
        </p:spPr>
      </p:pic>
      <p:pic>
        <p:nvPicPr>
          <p:cNvPr id="70" name="그림 69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1185" y="5009439"/>
            <a:ext cx="1349092" cy="1104167"/>
          </a:xfrm>
          <a:prstGeom prst="rect">
            <a:avLst/>
          </a:prstGeom>
        </p:spPr>
      </p:pic>
      <p:sp>
        <p:nvSpPr>
          <p:cNvPr id="71" name="TextBox 70"/>
          <p:cNvSpPr txBox="1"/>
          <p:nvPr/>
        </p:nvSpPr>
        <p:spPr>
          <a:xfrm>
            <a:off x="2934915" y="5394905"/>
            <a:ext cx="42313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직사각형 71"/>
          <p:cNvSpPr/>
          <p:nvPr/>
        </p:nvSpPr>
        <p:spPr>
          <a:xfrm>
            <a:off x="3602560" y="5441830"/>
            <a:ext cx="172965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2904581" y="5314573"/>
            <a:ext cx="457926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3617087" y="531242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3685944" y="531537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258702" y="5394905"/>
            <a:ext cx="48422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직사각형 76"/>
          <p:cNvSpPr/>
          <p:nvPr/>
        </p:nvSpPr>
        <p:spPr>
          <a:xfrm>
            <a:off x="4987443" y="5441830"/>
            <a:ext cx="172965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204372" y="5314573"/>
            <a:ext cx="54301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>
                <a:latin typeface="Arial" panose="020B0604020202020204" pitchFamily="34" charset="0"/>
                <a:cs typeface="Arial" panose="020B0604020202020204" pitchFamily="34" charset="0"/>
              </a:rPr>
              <a:t>siR-HIF1A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5001970" y="531242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070827" y="531537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그림 80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8984" y="3887294"/>
            <a:ext cx="1349092" cy="1104167"/>
          </a:xfrm>
          <a:prstGeom prst="rect">
            <a:avLst/>
          </a:prstGeom>
        </p:spPr>
      </p:pic>
      <p:pic>
        <p:nvPicPr>
          <p:cNvPr id="82" name="그림 81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1185" y="3886913"/>
            <a:ext cx="1349092" cy="1104167"/>
          </a:xfrm>
          <a:prstGeom prst="rect">
            <a:avLst/>
          </a:prstGeom>
        </p:spPr>
      </p:pic>
      <p:sp>
        <p:nvSpPr>
          <p:cNvPr id="83" name="TextBox 82"/>
          <p:cNvSpPr txBox="1"/>
          <p:nvPr/>
        </p:nvSpPr>
        <p:spPr>
          <a:xfrm>
            <a:off x="2996029" y="4456127"/>
            <a:ext cx="32113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직사각형 83"/>
          <p:cNvSpPr/>
          <p:nvPr/>
        </p:nvSpPr>
        <p:spPr>
          <a:xfrm>
            <a:off x="3254738" y="4510065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2845874" y="4222280"/>
            <a:ext cx="465382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3260981" y="421971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3332981" y="422355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4310911" y="4456127"/>
            <a:ext cx="388219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KC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직사각형 88"/>
          <p:cNvSpPr/>
          <p:nvPr/>
        </p:nvSpPr>
        <p:spPr>
          <a:xfrm>
            <a:off x="4636708" y="4510065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4284831" y="4222280"/>
            <a:ext cx="408393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642950" y="421971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714951" y="422355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직사각형 92"/>
          <p:cNvSpPr/>
          <p:nvPr/>
        </p:nvSpPr>
        <p:spPr>
          <a:xfrm>
            <a:off x="2213155" y="1040320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2224855" y="86845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2292390" y="87186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직사각형 95"/>
          <p:cNvSpPr/>
          <p:nvPr/>
        </p:nvSpPr>
        <p:spPr>
          <a:xfrm>
            <a:off x="3607390" y="1040320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3615425" y="86788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3682960" y="87129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직사각형 98"/>
          <p:cNvSpPr/>
          <p:nvPr/>
        </p:nvSpPr>
        <p:spPr>
          <a:xfrm>
            <a:off x="4997747" y="1040320"/>
            <a:ext cx="157109" cy="53460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5003436" y="86873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5070971" y="87214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직사각형 101"/>
          <p:cNvSpPr/>
          <p:nvPr/>
        </p:nvSpPr>
        <p:spPr>
          <a:xfrm>
            <a:off x="1861089" y="2152914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870122" y="200167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940316" y="200508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직사각형 104"/>
          <p:cNvSpPr/>
          <p:nvPr/>
        </p:nvSpPr>
        <p:spPr>
          <a:xfrm>
            <a:off x="3255313" y="2155187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06" name="TextBox 105"/>
          <p:cNvSpPr txBox="1"/>
          <p:nvPr/>
        </p:nvSpPr>
        <p:spPr>
          <a:xfrm>
            <a:off x="3264346" y="200395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3334540" y="200736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직사각형 107"/>
          <p:cNvSpPr/>
          <p:nvPr/>
        </p:nvSpPr>
        <p:spPr>
          <a:xfrm>
            <a:off x="4637244" y="2157975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4646276" y="200674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716471" y="201014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직사각형 110"/>
          <p:cNvSpPr/>
          <p:nvPr/>
        </p:nvSpPr>
        <p:spPr>
          <a:xfrm>
            <a:off x="2133777" y="4509773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2131956" y="422023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2203957" y="422407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직사각형 113"/>
          <p:cNvSpPr/>
          <p:nvPr/>
        </p:nvSpPr>
        <p:spPr>
          <a:xfrm>
            <a:off x="3528730" y="4509773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537673" y="4220270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3609673" y="422410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직사각형 116"/>
          <p:cNvSpPr/>
          <p:nvPr/>
        </p:nvSpPr>
        <p:spPr>
          <a:xfrm>
            <a:off x="4912160" y="4509773"/>
            <a:ext cx="154230" cy="46594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4911674" y="4220236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4983675" y="422407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0" name="그림 119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16096" y="2765783"/>
            <a:ext cx="1349092" cy="1104167"/>
          </a:xfrm>
          <a:prstGeom prst="rect">
            <a:avLst/>
          </a:prstGeom>
        </p:spPr>
      </p:pic>
      <p:pic>
        <p:nvPicPr>
          <p:cNvPr id="121" name="그림 120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01494" y="2766099"/>
            <a:ext cx="1349092" cy="1104167"/>
          </a:xfrm>
          <a:prstGeom prst="rect">
            <a:avLst/>
          </a:prstGeom>
        </p:spPr>
      </p:pic>
      <p:sp>
        <p:nvSpPr>
          <p:cNvPr id="122" name="TextBox 121"/>
          <p:cNvSpPr txBox="1"/>
          <p:nvPr/>
        </p:nvSpPr>
        <p:spPr>
          <a:xfrm>
            <a:off x="2227926" y="315109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2298693" y="315684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직사각형 123"/>
          <p:cNvSpPr/>
          <p:nvPr/>
        </p:nvSpPr>
        <p:spPr>
          <a:xfrm>
            <a:off x="2227739" y="3286533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2972539" y="3241989"/>
            <a:ext cx="383638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2943820" y="3143913"/>
            <a:ext cx="41946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350452" y="314391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3421219" y="314965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직사각형 128"/>
          <p:cNvSpPr/>
          <p:nvPr/>
        </p:nvSpPr>
        <p:spPr>
          <a:xfrm>
            <a:off x="3350264" y="3279346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3619745" y="314698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3690512" y="3152735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직사각형 131"/>
          <p:cNvSpPr/>
          <p:nvPr/>
        </p:nvSpPr>
        <p:spPr>
          <a:xfrm>
            <a:off x="3619558" y="3282422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4365836" y="3243383"/>
            <a:ext cx="37613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ar6b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4295069" y="3145307"/>
            <a:ext cx="454015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R-Par3: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4736249" y="3145307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4807016" y="315105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직사각형 136"/>
          <p:cNvSpPr/>
          <p:nvPr/>
        </p:nvSpPr>
        <p:spPr>
          <a:xfrm>
            <a:off x="4736062" y="3280740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38" name="TextBox 137"/>
          <p:cNvSpPr txBox="1"/>
          <p:nvPr/>
        </p:nvSpPr>
        <p:spPr>
          <a:xfrm>
            <a:off x="5005542" y="3148383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>
            <a:off x="5076310" y="315412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직사각형 139"/>
          <p:cNvSpPr/>
          <p:nvPr/>
        </p:nvSpPr>
        <p:spPr>
          <a:xfrm>
            <a:off x="5005355" y="3283816"/>
            <a:ext cx="154230" cy="7689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1" name="직사각형 140"/>
          <p:cNvSpPr/>
          <p:nvPr/>
        </p:nvSpPr>
        <p:spPr>
          <a:xfrm>
            <a:off x="1933060" y="5441830"/>
            <a:ext cx="172965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bg1"/>
              </a:solidFill>
            </a:endParaRPr>
          </a:p>
        </p:txBody>
      </p:sp>
      <p:sp>
        <p:nvSpPr>
          <p:cNvPr id="142" name="TextBox 141"/>
          <p:cNvSpPr txBox="1"/>
          <p:nvPr/>
        </p:nvSpPr>
        <p:spPr>
          <a:xfrm>
            <a:off x="1947587" y="531242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2016444" y="531537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직사각형 143"/>
          <p:cNvSpPr/>
          <p:nvPr/>
        </p:nvSpPr>
        <p:spPr>
          <a:xfrm>
            <a:off x="3323071" y="5441830"/>
            <a:ext cx="172965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3337599" y="5312422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3406456" y="5315374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직사각형 146"/>
          <p:cNvSpPr/>
          <p:nvPr/>
        </p:nvSpPr>
        <p:spPr>
          <a:xfrm>
            <a:off x="4702632" y="5441695"/>
            <a:ext cx="172965" cy="55735"/>
          </a:xfrm>
          <a:prstGeom prst="rect">
            <a:avLst/>
          </a:prstGeom>
          <a:noFill/>
          <a:ln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solidFill>
                <a:schemeClr val="tx1"/>
              </a:solidFill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4717159" y="5312287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4786016" y="5315239"/>
            <a:ext cx="75987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altLang="ko-KR" sz="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2442901" y="2115793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20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2496379" y="3250791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1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2464618" y="5392183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2462346" y="997290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0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2448148" y="4461485"/>
            <a:ext cx="390821" cy="153888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r>
              <a:rPr lang="en-US" altLang="ko-KR" sz="4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400" b="1" dirty="0" err="1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ko-KR" altLang="en-US" sz="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16163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53</TotalTime>
  <Words>2123</Words>
  <Application>Microsoft Office PowerPoint</Application>
  <PresentationFormat>Letter 용지(8.5x11in)</PresentationFormat>
  <Paragraphs>1199</Paragraphs>
  <Slides>1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1</vt:i4>
      </vt:variant>
    </vt:vector>
  </HeadingPairs>
  <TitlesOfParts>
    <vt:vector size="16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H Choi</dc:creator>
  <cp:lastModifiedBy>JH Choi</cp:lastModifiedBy>
  <cp:revision>33</cp:revision>
  <dcterms:created xsi:type="dcterms:W3CDTF">2023-01-02T06:14:53Z</dcterms:created>
  <dcterms:modified xsi:type="dcterms:W3CDTF">2023-03-02T12:50:16Z</dcterms:modified>
</cp:coreProperties>
</file>